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sldIdLst>
    <p:sldId id="267" r:id="rId2"/>
    <p:sldId id="259" r:id="rId3"/>
    <p:sldId id="263" r:id="rId4"/>
    <p:sldId id="261" r:id="rId5"/>
    <p:sldId id="266" r:id="rId6"/>
  </p:sldIdLst>
  <p:sldSz cx="12192000" cy="15544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1" autoAdjust="0"/>
    <p:restoredTop sz="94660"/>
  </p:normalViewPr>
  <p:slideViewPr>
    <p:cSldViewPr snapToGrid="0">
      <p:cViewPr>
        <p:scale>
          <a:sx n="80" d="100"/>
          <a:sy n="80" d="100"/>
        </p:scale>
        <p:origin x="1424" y="-14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56.emf"/><Relationship Id="rId2" Type="http://schemas.openxmlformats.org/officeDocument/2006/relationships/image" Target="../media/image55.emf"/><Relationship Id="rId1" Type="http://schemas.openxmlformats.org/officeDocument/2006/relationships/image" Target="../media/image54.emf"/><Relationship Id="rId4" Type="http://schemas.openxmlformats.org/officeDocument/2006/relationships/image" Target="../media/image57.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544023"/>
            <a:ext cx="10363200" cy="5411893"/>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164619"/>
            <a:ext cx="9144000" cy="375306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9/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19639883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9/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4284567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27617"/>
            <a:ext cx="2628900" cy="1317349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27617"/>
            <a:ext cx="7734300" cy="1317349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9/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1173352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9/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527605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3875409"/>
            <a:ext cx="10515600" cy="6466204"/>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402786"/>
            <a:ext cx="10515600" cy="3400424"/>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445A22D-DBF3-48EC-9B1A-1E6A50109BEB}" type="datetimeFigureOut">
              <a:rPr lang="en-US" smtClean="0"/>
              <a:t>9/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10346016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138083"/>
            <a:ext cx="5181600" cy="98630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138083"/>
            <a:ext cx="5181600" cy="98630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445A22D-DBF3-48EC-9B1A-1E6A50109BEB}" type="datetimeFigureOut">
              <a:rPr lang="en-US" smtClean="0"/>
              <a:t>9/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3085928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27620"/>
            <a:ext cx="10515600" cy="3004609"/>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810636"/>
            <a:ext cx="5157787"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4" name="Content Placeholder 3"/>
          <p:cNvSpPr>
            <a:spLocks noGrp="1"/>
          </p:cNvSpPr>
          <p:nvPr>
            <p:ph sz="half" idx="2"/>
          </p:nvPr>
        </p:nvSpPr>
        <p:spPr>
          <a:xfrm>
            <a:off x="839789" y="5678170"/>
            <a:ext cx="5157787" cy="83517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810636"/>
            <a:ext cx="5183188"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6" name="Content Placeholder 5"/>
          <p:cNvSpPr>
            <a:spLocks noGrp="1"/>
          </p:cNvSpPr>
          <p:nvPr>
            <p:ph sz="quarter" idx="4"/>
          </p:nvPr>
        </p:nvSpPr>
        <p:spPr>
          <a:xfrm>
            <a:off x="6172201" y="5678170"/>
            <a:ext cx="5183188" cy="83517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445A22D-DBF3-48EC-9B1A-1E6A50109BEB}" type="datetimeFigureOut">
              <a:rPr lang="en-US" smtClean="0"/>
              <a:t>9/23/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6529465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445A22D-DBF3-48EC-9B1A-1E6A50109BEB}" type="datetimeFigureOut">
              <a:rPr lang="en-US" smtClean="0"/>
              <a:t>9/23/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41645967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445A22D-DBF3-48EC-9B1A-1E6A50109BEB}" type="datetimeFigureOut">
              <a:rPr lang="en-US" smtClean="0"/>
              <a:t>9/23/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8327466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238167"/>
            <a:ext cx="6172200" cy="11046883"/>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445A22D-DBF3-48EC-9B1A-1E6A50109BEB}" type="datetimeFigureOut">
              <a:rPr lang="en-US" smtClean="0"/>
              <a:t>9/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3407544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238167"/>
            <a:ext cx="6172200" cy="11046883"/>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445A22D-DBF3-48EC-9B1A-1E6A50109BEB}" type="datetimeFigureOut">
              <a:rPr lang="en-US" smtClean="0"/>
              <a:t>9/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83942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27620"/>
            <a:ext cx="10515600" cy="300460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138083"/>
            <a:ext cx="10515600" cy="986303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4407730"/>
            <a:ext cx="2743200" cy="827617"/>
          </a:xfrm>
          <a:prstGeom prst="rect">
            <a:avLst/>
          </a:prstGeom>
        </p:spPr>
        <p:txBody>
          <a:bodyPr vert="horz" lIns="91440" tIns="45720" rIns="91440" bIns="45720" rtlCol="0" anchor="ctr"/>
          <a:lstStyle>
            <a:lvl1pPr algn="l">
              <a:defRPr sz="1600">
                <a:solidFill>
                  <a:schemeClr val="tx1">
                    <a:tint val="75000"/>
                  </a:schemeClr>
                </a:solidFill>
              </a:defRPr>
            </a:lvl1pPr>
          </a:lstStyle>
          <a:p>
            <a:fld id="{4445A22D-DBF3-48EC-9B1A-1E6A50109BEB}" type="datetimeFigureOut">
              <a:rPr lang="en-US" smtClean="0"/>
              <a:t>9/23/20</a:t>
            </a:fld>
            <a:endParaRPr lang="en-US"/>
          </a:p>
        </p:txBody>
      </p:sp>
      <p:sp>
        <p:nvSpPr>
          <p:cNvPr id="5" name="Footer Placeholder 4"/>
          <p:cNvSpPr>
            <a:spLocks noGrp="1"/>
          </p:cNvSpPr>
          <p:nvPr>
            <p:ph type="ftr" sz="quarter" idx="3"/>
          </p:nvPr>
        </p:nvSpPr>
        <p:spPr>
          <a:xfrm>
            <a:off x="4038600" y="14407730"/>
            <a:ext cx="4114800" cy="827617"/>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4407730"/>
            <a:ext cx="2743200" cy="827617"/>
          </a:xfrm>
          <a:prstGeom prst="rect">
            <a:avLst/>
          </a:prstGeom>
        </p:spPr>
        <p:txBody>
          <a:bodyPr vert="horz" lIns="91440" tIns="45720" rIns="91440" bIns="45720" rtlCol="0" anchor="ctr"/>
          <a:lstStyle>
            <a:lvl1pPr algn="r">
              <a:defRPr sz="1600">
                <a:solidFill>
                  <a:schemeClr val="tx1">
                    <a:tint val="75000"/>
                  </a:schemeClr>
                </a:solidFill>
              </a:defRPr>
            </a:lvl1pPr>
          </a:lstStyle>
          <a:p>
            <a:fld id="{1FFA4151-A00B-4121-823D-3DCB10405D51}" type="slidenum">
              <a:rPr lang="en-US" smtClean="0"/>
              <a:t>‹#›</a:t>
            </a:fld>
            <a:endParaRPr lang="en-US"/>
          </a:p>
        </p:txBody>
      </p:sp>
    </p:spTree>
    <p:extLst>
      <p:ext uri="{BB962C8B-B14F-4D97-AF65-F5344CB8AC3E}">
        <p14:creationId xmlns:p14="http://schemas.microsoft.com/office/powerpoint/2010/main" val="4179301405"/>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2.emf"/><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6.png"/><Relationship Id="rId11" Type="http://schemas.openxmlformats.org/officeDocument/2006/relationships/image" Target="../media/image1.emf"/><Relationship Id="rId5" Type="http://schemas.openxmlformats.org/officeDocument/2006/relationships/image" Target="../media/image5.png"/><Relationship Id="rId10" Type="http://schemas.openxmlformats.org/officeDocument/2006/relationships/oleObject" Target="../embeddings/oleObject1.bin"/><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0.jpg"/></Relationships>
</file>

<file path=ppt/slides/_rels/slide3.xml.rels><?xml version="1.0" encoding="UTF-8" standalone="yes"?>
<Relationships xmlns="http://schemas.openxmlformats.org/package/2006/relationships"><Relationship Id="rId8" Type="http://schemas.openxmlformats.org/officeDocument/2006/relationships/image" Target="../media/image17.png"/><Relationship Id="rId13" Type="http://schemas.openxmlformats.org/officeDocument/2006/relationships/image" Target="../media/image22.png"/><Relationship Id="rId18" Type="http://schemas.openxmlformats.org/officeDocument/2006/relationships/image" Target="../media/image27.png"/><Relationship Id="rId26" Type="http://schemas.openxmlformats.org/officeDocument/2006/relationships/image" Target="../media/image35.png"/><Relationship Id="rId3" Type="http://schemas.openxmlformats.org/officeDocument/2006/relationships/image" Target="../media/image12.jpg"/><Relationship Id="rId21" Type="http://schemas.openxmlformats.org/officeDocument/2006/relationships/image" Target="../media/image30.png"/><Relationship Id="rId7" Type="http://schemas.openxmlformats.org/officeDocument/2006/relationships/image" Target="../media/image16.png"/><Relationship Id="rId12" Type="http://schemas.openxmlformats.org/officeDocument/2006/relationships/image" Target="../media/image21.png"/><Relationship Id="rId17" Type="http://schemas.openxmlformats.org/officeDocument/2006/relationships/image" Target="../media/image26.png"/><Relationship Id="rId25" Type="http://schemas.openxmlformats.org/officeDocument/2006/relationships/image" Target="../media/image34.png"/><Relationship Id="rId2" Type="http://schemas.openxmlformats.org/officeDocument/2006/relationships/image" Target="../media/image11.jpg"/><Relationship Id="rId16" Type="http://schemas.openxmlformats.org/officeDocument/2006/relationships/image" Target="../media/image25.png"/><Relationship Id="rId20" Type="http://schemas.openxmlformats.org/officeDocument/2006/relationships/image" Target="../media/image29.png"/><Relationship Id="rId29" Type="http://schemas.openxmlformats.org/officeDocument/2006/relationships/image" Target="../media/image38.jpg"/><Relationship Id="rId1" Type="http://schemas.openxmlformats.org/officeDocument/2006/relationships/slideLayout" Target="../slideLayouts/slideLayout7.xml"/><Relationship Id="rId6" Type="http://schemas.openxmlformats.org/officeDocument/2006/relationships/image" Target="../media/image15.png"/><Relationship Id="rId11" Type="http://schemas.openxmlformats.org/officeDocument/2006/relationships/image" Target="../media/image20.png"/><Relationship Id="rId24" Type="http://schemas.openxmlformats.org/officeDocument/2006/relationships/image" Target="../media/image33.png"/><Relationship Id="rId32" Type="http://schemas.openxmlformats.org/officeDocument/2006/relationships/image" Target="../media/image41.jpg"/><Relationship Id="rId5" Type="http://schemas.openxmlformats.org/officeDocument/2006/relationships/image" Target="../media/image14.png"/><Relationship Id="rId15" Type="http://schemas.openxmlformats.org/officeDocument/2006/relationships/image" Target="../media/image24.png"/><Relationship Id="rId23" Type="http://schemas.openxmlformats.org/officeDocument/2006/relationships/image" Target="../media/image32.png"/><Relationship Id="rId28" Type="http://schemas.openxmlformats.org/officeDocument/2006/relationships/image" Target="../media/image37.png"/><Relationship Id="rId10" Type="http://schemas.openxmlformats.org/officeDocument/2006/relationships/image" Target="../media/image19.png"/><Relationship Id="rId19" Type="http://schemas.openxmlformats.org/officeDocument/2006/relationships/image" Target="../media/image28.png"/><Relationship Id="rId31" Type="http://schemas.openxmlformats.org/officeDocument/2006/relationships/image" Target="../media/image40.jpg"/><Relationship Id="rId4" Type="http://schemas.openxmlformats.org/officeDocument/2006/relationships/image" Target="../media/image13.jpg"/><Relationship Id="rId9" Type="http://schemas.openxmlformats.org/officeDocument/2006/relationships/image" Target="../media/image18.png"/><Relationship Id="rId14" Type="http://schemas.openxmlformats.org/officeDocument/2006/relationships/image" Target="../media/image23.png"/><Relationship Id="rId22" Type="http://schemas.openxmlformats.org/officeDocument/2006/relationships/image" Target="../media/image31.png"/><Relationship Id="rId27" Type="http://schemas.openxmlformats.org/officeDocument/2006/relationships/image" Target="../media/image36.png"/><Relationship Id="rId30" Type="http://schemas.openxmlformats.org/officeDocument/2006/relationships/image" Target="../media/image39.jpg"/></Relationships>
</file>

<file path=ppt/slides/_rels/slide4.xml.rels><?xml version="1.0" encoding="UTF-8" standalone="yes"?>
<Relationships xmlns="http://schemas.openxmlformats.org/package/2006/relationships"><Relationship Id="rId8" Type="http://schemas.openxmlformats.org/officeDocument/2006/relationships/image" Target="../media/image48.jpeg"/><Relationship Id="rId13" Type="http://schemas.openxmlformats.org/officeDocument/2006/relationships/image" Target="../media/image53.jpeg"/><Relationship Id="rId3" Type="http://schemas.openxmlformats.org/officeDocument/2006/relationships/image" Target="../media/image43.jpeg"/><Relationship Id="rId7" Type="http://schemas.openxmlformats.org/officeDocument/2006/relationships/image" Target="../media/image47.jpeg"/><Relationship Id="rId12" Type="http://schemas.openxmlformats.org/officeDocument/2006/relationships/image" Target="../media/image52.jpeg"/><Relationship Id="rId2" Type="http://schemas.openxmlformats.org/officeDocument/2006/relationships/image" Target="../media/image42.jpeg"/><Relationship Id="rId1" Type="http://schemas.openxmlformats.org/officeDocument/2006/relationships/slideLayout" Target="../slideLayouts/slideLayout7.xml"/><Relationship Id="rId6" Type="http://schemas.openxmlformats.org/officeDocument/2006/relationships/image" Target="../media/image46.jpeg"/><Relationship Id="rId11" Type="http://schemas.openxmlformats.org/officeDocument/2006/relationships/image" Target="../media/image51.jpeg"/><Relationship Id="rId5" Type="http://schemas.openxmlformats.org/officeDocument/2006/relationships/image" Target="../media/image45.jpeg"/><Relationship Id="rId10" Type="http://schemas.openxmlformats.org/officeDocument/2006/relationships/image" Target="../media/image50.jpeg"/><Relationship Id="rId4" Type="http://schemas.openxmlformats.org/officeDocument/2006/relationships/image" Target="../media/image44.jpeg"/><Relationship Id="rId9" Type="http://schemas.openxmlformats.org/officeDocument/2006/relationships/image" Target="../media/image49.jpeg"/></Relationships>
</file>

<file path=ppt/slides/_rels/slide5.xml.rels><?xml version="1.0" encoding="UTF-8" standalone="yes"?>
<Relationships xmlns="http://schemas.openxmlformats.org/package/2006/relationships"><Relationship Id="rId8" Type="http://schemas.openxmlformats.org/officeDocument/2006/relationships/image" Target="../media/image61.jpg"/><Relationship Id="rId13" Type="http://schemas.openxmlformats.org/officeDocument/2006/relationships/oleObject" Target="../embeddings/oleObject6.bin"/><Relationship Id="rId18" Type="http://schemas.openxmlformats.org/officeDocument/2006/relationships/image" Target="../media/image65.jpeg"/><Relationship Id="rId26" Type="http://schemas.openxmlformats.org/officeDocument/2006/relationships/image" Target="../media/image73.jpeg"/><Relationship Id="rId3" Type="http://schemas.openxmlformats.org/officeDocument/2006/relationships/oleObject" Target="../embeddings/oleObject3.bin"/><Relationship Id="rId21" Type="http://schemas.openxmlformats.org/officeDocument/2006/relationships/image" Target="../media/image68.jpeg"/><Relationship Id="rId7" Type="http://schemas.openxmlformats.org/officeDocument/2006/relationships/image" Target="../media/image60.jpeg"/><Relationship Id="rId12" Type="http://schemas.openxmlformats.org/officeDocument/2006/relationships/image" Target="../media/image56.emf"/><Relationship Id="rId17" Type="http://schemas.openxmlformats.org/officeDocument/2006/relationships/image" Target="../media/image64.jpeg"/><Relationship Id="rId25" Type="http://schemas.openxmlformats.org/officeDocument/2006/relationships/image" Target="../media/image72.jpeg"/><Relationship Id="rId2" Type="http://schemas.openxmlformats.org/officeDocument/2006/relationships/slideLayout" Target="../slideLayouts/slideLayout7.xml"/><Relationship Id="rId16" Type="http://schemas.openxmlformats.org/officeDocument/2006/relationships/image" Target="../media/image63.jpeg"/><Relationship Id="rId20" Type="http://schemas.openxmlformats.org/officeDocument/2006/relationships/image" Target="../media/image67.jpeg"/><Relationship Id="rId1" Type="http://schemas.openxmlformats.org/officeDocument/2006/relationships/vmlDrawing" Target="../drawings/vmlDrawing2.vml"/><Relationship Id="rId6" Type="http://schemas.openxmlformats.org/officeDocument/2006/relationships/image" Target="../media/image59.jpeg"/><Relationship Id="rId11" Type="http://schemas.openxmlformats.org/officeDocument/2006/relationships/oleObject" Target="../embeddings/oleObject5.bin"/><Relationship Id="rId24" Type="http://schemas.openxmlformats.org/officeDocument/2006/relationships/image" Target="../media/image71.jpeg"/><Relationship Id="rId5" Type="http://schemas.openxmlformats.org/officeDocument/2006/relationships/image" Target="../media/image58.jpg"/><Relationship Id="rId15" Type="http://schemas.openxmlformats.org/officeDocument/2006/relationships/image" Target="../media/image62.jpeg"/><Relationship Id="rId23" Type="http://schemas.openxmlformats.org/officeDocument/2006/relationships/image" Target="../media/image70.jpeg"/><Relationship Id="rId10" Type="http://schemas.openxmlformats.org/officeDocument/2006/relationships/image" Target="../media/image55.emf"/><Relationship Id="rId19" Type="http://schemas.openxmlformats.org/officeDocument/2006/relationships/image" Target="../media/image66.jpeg"/><Relationship Id="rId4" Type="http://schemas.openxmlformats.org/officeDocument/2006/relationships/image" Target="../media/image54.emf"/><Relationship Id="rId9" Type="http://schemas.openxmlformats.org/officeDocument/2006/relationships/oleObject" Target="../embeddings/oleObject4.bin"/><Relationship Id="rId14" Type="http://schemas.openxmlformats.org/officeDocument/2006/relationships/image" Target="../media/image57.emf"/><Relationship Id="rId22" Type="http://schemas.openxmlformats.org/officeDocument/2006/relationships/image" Target="../media/image69.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Supplemental Figures</a:t>
            </a:r>
            <a:endParaRPr lang="en-US" b="1" dirty="0"/>
          </a:p>
        </p:txBody>
      </p:sp>
    </p:spTree>
    <p:extLst>
      <p:ext uri="{BB962C8B-B14F-4D97-AF65-F5344CB8AC3E}">
        <p14:creationId xmlns:p14="http://schemas.microsoft.com/office/powerpoint/2010/main" val="1837932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653220" y="10169619"/>
            <a:ext cx="6559062" cy="2462213"/>
          </a:xfrm>
          <a:prstGeom prst="rect">
            <a:avLst/>
          </a:prstGeom>
        </p:spPr>
        <p:txBody>
          <a:bodyPr wrap="square">
            <a:spAutoFit/>
          </a:bodyPr>
          <a:lstStyle/>
          <a:p>
            <a:pPr algn="just"/>
            <a:r>
              <a:rPr lang="en-US" sz="1400" b="1" dirty="0">
                <a:latin typeface="Arial" panose="020B0604020202020204" pitchFamily="34" charset="0"/>
                <a:cs typeface="Arial" panose="020B0604020202020204" pitchFamily="34" charset="0"/>
              </a:rPr>
              <a:t>Supplemental Fig. 1: </a:t>
            </a:r>
            <a:r>
              <a:rPr lang="en-US" sz="1400" dirty="0">
                <a:latin typeface="Arial" panose="020B0604020202020204" pitchFamily="34" charset="0"/>
                <a:cs typeface="Arial" panose="020B0604020202020204" pitchFamily="34" charset="0"/>
              </a:rPr>
              <a:t>Evaluation of synergy between midostaurin and venetoclax in FLT3-WT cell lines. </a:t>
            </a:r>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Proliferation assay of a range of doses of midostaurin and venetoclax on </a:t>
            </a:r>
            <a:r>
              <a:rPr lang="en-US" sz="1400" i="1" dirty="0">
                <a:latin typeface="Arial" panose="020B0604020202020204" pitchFamily="34" charset="0"/>
                <a:cs typeface="Arial" panose="020B0604020202020204" pitchFamily="34" charset="0"/>
              </a:rPr>
              <a:t>FLT3</a:t>
            </a:r>
            <a:r>
              <a:rPr lang="en-US" sz="1400" dirty="0">
                <a:latin typeface="Arial" panose="020B0604020202020204" pitchFamily="34" charset="0"/>
                <a:cs typeface="Arial" panose="020B0604020202020204" pitchFamily="34" charset="0"/>
              </a:rPr>
              <a:t>-WT cell lines K-562, HL-60, OCI-AML3, KASUMI-1, U-937, and THP-1. b Changes in </a:t>
            </a:r>
            <a:r>
              <a:rPr lang="en-US" sz="1400" dirty="0" err="1">
                <a:latin typeface="Arial" panose="020B0604020202020204" pitchFamily="34" charset="0"/>
                <a:cs typeface="Arial" panose="020B0604020202020204" pitchFamily="34" charset="0"/>
              </a:rPr>
              <a:t>sgRNA</a:t>
            </a:r>
            <a:r>
              <a:rPr lang="en-US" sz="1400" dirty="0">
                <a:latin typeface="Arial" panose="020B0604020202020204" pitchFamily="34" charset="0"/>
                <a:cs typeface="Arial" panose="020B0604020202020204" pitchFamily="34" charset="0"/>
              </a:rPr>
              <a:t> levels for members of the BCL2 family across 4 replicate screens.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Colony-forming assays performed with </a:t>
            </a:r>
            <a:r>
              <a:rPr lang="en-US" sz="1400" i="1" dirty="0">
                <a:latin typeface="Arial" panose="020B0604020202020204" pitchFamily="34" charset="0"/>
                <a:cs typeface="Arial" panose="020B0604020202020204" pitchFamily="34" charset="0"/>
              </a:rPr>
              <a:t>FLT3</a:t>
            </a:r>
            <a:r>
              <a:rPr lang="en-US" sz="1400" dirty="0">
                <a:latin typeface="Arial" panose="020B0604020202020204" pitchFamily="34" charset="0"/>
                <a:cs typeface="Arial" panose="020B0604020202020204" pitchFamily="34" charset="0"/>
              </a:rPr>
              <a:t>-ITD or </a:t>
            </a:r>
            <a:r>
              <a:rPr lang="en-US" sz="1400" i="1" dirty="0">
                <a:latin typeface="Arial" panose="020B0604020202020204" pitchFamily="34" charset="0"/>
                <a:cs typeface="Arial" panose="020B0604020202020204" pitchFamily="34" charset="0"/>
              </a:rPr>
              <a:t>FLT3</a:t>
            </a:r>
            <a:r>
              <a:rPr lang="en-US" sz="1400" dirty="0">
                <a:latin typeface="Arial" panose="020B0604020202020204" pitchFamily="34" charset="0"/>
                <a:cs typeface="Arial" panose="020B0604020202020204" pitchFamily="34" charset="0"/>
              </a:rPr>
              <a:t>-WT primary patient samples cultivated in duplicate in </a:t>
            </a:r>
            <a:r>
              <a:rPr lang="en-US" sz="1400" dirty="0" err="1">
                <a:latin typeface="Arial" panose="020B0604020202020204" pitchFamily="34" charset="0"/>
                <a:cs typeface="Arial" panose="020B0604020202020204" pitchFamily="34" charset="0"/>
              </a:rPr>
              <a:t>Methocult</a:t>
            </a:r>
            <a:r>
              <a:rPr lang="en-US" sz="1400" dirty="0">
                <a:latin typeface="Arial" panose="020B0604020202020204" pitchFamily="34" charset="0"/>
                <a:cs typeface="Arial" panose="020B0604020202020204" pitchFamily="34" charset="0"/>
              </a:rPr>
              <a:t> media with 100nM venetoclax with or without 100nM midostaurin for 7-10 days were compared to determine in how many patient samples the CFU were further reduced by the addition of midostaurin (outlined in red).</a:t>
            </a:r>
            <a:r>
              <a:rPr lang="en-US" sz="1400" b="1" dirty="0">
                <a:latin typeface="Arial" panose="020B0604020202020204" pitchFamily="34" charset="0"/>
                <a:cs typeface="Arial" panose="020B0604020202020204" pitchFamily="34" charset="0"/>
              </a:rPr>
              <a:t> d </a:t>
            </a:r>
            <a:r>
              <a:rPr lang="en-US" sz="1400" dirty="0">
                <a:latin typeface="Arial" panose="020B0604020202020204" pitchFamily="34" charset="0"/>
                <a:cs typeface="Arial" panose="020B0604020202020204" pitchFamily="34" charset="0"/>
              </a:rPr>
              <a:t>Cells from the primary plating of CFU assays were dissolved in warm media, re-plated at 15,000 cells/plate, incubated for 7-10 days, and colonies counted. </a:t>
            </a:r>
            <a:endParaRPr lang="en-US" sz="1400" dirty="0"/>
          </a:p>
        </p:txBody>
      </p:sp>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88787" r="-579" b="6920"/>
          <a:stretch/>
        </p:blipFill>
        <p:spPr>
          <a:xfrm rot="5400000">
            <a:off x="2853286" y="5951644"/>
            <a:ext cx="355953" cy="2279670"/>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0233" y="4747577"/>
            <a:ext cx="2536154" cy="1978390"/>
          </a:xfrm>
          <a:prstGeom prst="rect">
            <a:avLst/>
          </a:prstGeom>
        </p:spPr>
      </p:pic>
      <p:pic>
        <p:nvPicPr>
          <p:cNvPr id="5" name="Pictur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667103" y="384749"/>
            <a:ext cx="2545016" cy="1978390"/>
          </a:xfrm>
          <a:prstGeom prst="rect">
            <a:avLst/>
          </a:prstGeom>
        </p:spPr>
      </p:pic>
      <p:pic>
        <p:nvPicPr>
          <p:cNvPr id="6" name="Picture 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0233" y="384749"/>
            <a:ext cx="2545016" cy="1978390"/>
          </a:xfrm>
          <a:prstGeom prst="rect">
            <a:avLst/>
          </a:prstGeom>
        </p:spPr>
      </p:pic>
      <p:pic>
        <p:nvPicPr>
          <p:cNvPr id="7" name="Picture 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686310" y="4747577"/>
            <a:ext cx="2525809" cy="1978390"/>
          </a:xfrm>
          <a:prstGeom prst="rect">
            <a:avLst/>
          </a:prstGeom>
        </p:spPr>
      </p:pic>
      <p:pic>
        <p:nvPicPr>
          <p:cNvPr id="8" name="Picture 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667103" y="2535697"/>
            <a:ext cx="2545016" cy="1978390"/>
          </a:xfrm>
          <a:prstGeom prst="rect">
            <a:avLst/>
          </a:prstGeom>
        </p:spPr>
      </p:pic>
      <p:pic>
        <p:nvPicPr>
          <p:cNvPr id="9" name="Picture 8"/>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0233" y="2535697"/>
            <a:ext cx="2545016" cy="1978390"/>
          </a:xfrm>
          <a:prstGeom prst="rect">
            <a:avLst/>
          </a:prstGeom>
        </p:spPr>
      </p:pic>
      <p:sp>
        <p:nvSpPr>
          <p:cNvPr id="11" name="TextBox 10"/>
          <p:cNvSpPr txBox="1"/>
          <p:nvPr/>
        </p:nvSpPr>
        <p:spPr>
          <a:xfrm>
            <a:off x="-48518" y="7313707"/>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graphicFrame>
        <p:nvGraphicFramePr>
          <p:cNvPr id="12" name="Object 11"/>
          <p:cNvGraphicFramePr>
            <a:graphicFrameLocks noChangeAspect="1"/>
          </p:cNvGraphicFramePr>
          <p:nvPr>
            <p:extLst>
              <p:ext uri="{D42A27DB-BD31-4B8C-83A1-F6EECF244321}">
                <p14:modId xmlns:p14="http://schemas.microsoft.com/office/powerpoint/2010/main" val="3318418947"/>
              </p:ext>
            </p:extLst>
          </p:nvPr>
        </p:nvGraphicFramePr>
        <p:xfrm>
          <a:off x="-28167" y="10157285"/>
          <a:ext cx="5543659" cy="2476322"/>
        </p:xfrm>
        <a:graphic>
          <a:graphicData uri="http://schemas.openxmlformats.org/presentationml/2006/ole">
            <mc:AlternateContent xmlns:mc="http://schemas.openxmlformats.org/markup-compatibility/2006">
              <mc:Choice xmlns:v="urn:schemas-microsoft-com:vml" Requires="v">
                <p:oleObj spid="_x0000_s6242" name="Prism 7" r:id="rId10" imgW="6750744" imgH="3014129" progId="Prism7.Document">
                  <p:embed/>
                </p:oleObj>
              </mc:Choice>
              <mc:Fallback>
                <p:oleObj name="Prism 7" r:id="rId10" imgW="6750744" imgH="3014129" progId="Prism7.Document">
                  <p:embed/>
                  <p:pic>
                    <p:nvPicPr>
                      <p:cNvPr id="45" name="Object 44"/>
                      <p:cNvPicPr/>
                      <p:nvPr/>
                    </p:nvPicPr>
                    <p:blipFill>
                      <a:blip r:embed="rId11"/>
                      <a:stretch>
                        <a:fillRect/>
                      </a:stretch>
                    </p:blipFill>
                    <p:spPr>
                      <a:xfrm>
                        <a:off x="-28167" y="10157285"/>
                        <a:ext cx="5543659" cy="2476322"/>
                      </a:xfrm>
                      <a:prstGeom prst="rect">
                        <a:avLst/>
                      </a:prstGeom>
                    </p:spPr>
                  </p:pic>
                </p:oleObj>
              </mc:Fallback>
            </mc:AlternateContent>
          </a:graphicData>
        </a:graphic>
      </p:graphicFrame>
      <p:graphicFrame>
        <p:nvGraphicFramePr>
          <p:cNvPr id="13" name="Object 12"/>
          <p:cNvGraphicFramePr>
            <a:graphicFrameLocks noChangeAspect="1"/>
          </p:cNvGraphicFramePr>
          <p:nvPr>
            <p:extLst>
              <p:ext uri="{D42A27DB-BD31-4B8C-83A1-F6EECF244321}">
                <p14:modId xmlns:p14="http://schemas.microsoft.com/office/powerpoint/2010/main" val="2100056137"/>
              </p:ext>
            </p:extLst>
          </p:nvPr>
        </p:nvGraphicFramePr>
        <p:xfrm>
          <a:off x="49456" y="7346488"/>
          <a:ext cx="5440900" cy="2898375"/>
        </p:xfrm>
        <a:graphic>
          <a:graphicData uri="http://schemas.openxmlformats.org/presentationml/2006/ole">
            <mc:AlternateContent xmlns:mc="http://schemas.openxmlformats.org/markup-compatibility/2006">
              <mc:Choice xmlns:v="urn:schemas-microsoft-com:vml" Requires="v">
                <p:oleObj spid="_x0000_s6243" name="Prism 8" r:id="rId12" imgW="5644047" imgH="3005125" progId="Prism8.Document">
                  <p:embed/>
                </p:oleObj>
              </mc:Choice>
              <mc:Fallback>
                <p:oleObj name="Prism 8" r:id="rId12" imgW="5644047" imgH="3005125" progId="Prism8.Document">
                  <p:embed/>
                  <p:pic>
                    <p:nvPicPr>
                      <p:cNvPr id="46" name="Object 45"/>
                      <p:cNvPicPr/>
                      <p:nvPr/>
                    </p:nvPicPr>
                    <p:blipFill>
                      <a:blip r:embed="rId13"/>
                      <a:stretch>
                        <a:fillRect/>
                      </a:stretch>
                    </p:blipFill>
                    <p:spPr>
                      <a:xfrm>
                        <a:off x="49456" y="7346488"/>
                        <a:ext cx="5440900" cy="2898375"/>
                      </a:xfrm>
                      <a:prstGeom prst="rect">
                        <a:avLst/>
                      </a:prstGeom>
                    </p:spPr>
                  </p:pic>
                </p:oleObj>
              </mc:Fallback>
            </mc:AlternateContent>
          </a:graphicData>
        </a:graphic>
      </p:graphicFrame>
      <p:sp>
        <p:nvSpPr>
          <p:cNvPr id="15" name="TextBox 14"/>
          <p:cNvSpPr txBox="1"/>
          <p:nvPr/>
        </p:nvSpPr>
        <p:spPr>
          <a:xfrm>
            <a:off x="-48518" y="12092"/>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16" name="TextBox 15"/>
          <p:cNvSpPr txBox="1"/>
          <p:nvPr/>
        </p:nvSpPr>
        <p:spPr>
          <a:xfrm>
            <a:off x="29835" y="10124030"/>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pic>
        <p:nvPicPr>
          <p:cNvPr id="10" name="Picture 9"/>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5425166" y="235906"/>
            <a:ext cx="6679493" cy="8548865"/>
          </a:xfrm>
          <a:prstGeom prst="rect">
            <a:avLst/>
          </a:prstGeom>
        </p:spPr>
      </p:pic>
      <p:sp>
        <p:nvSpPr>
          <p:cNvPr id="17" name="TextBox 16"/>
          <p:cNvSpPr txBox="1"/>
          <p:nvPr/>
        </p:nvSpPr>
        <p:spPr>
          <a:xfrm>
            <a:off x="5262042" y="12092"/>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688954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31889" y="1418556"/>
            <a:ext cx="2561418" cy="535531"/>
          </a:xfrm>
          <a:prstGeom prst="rect">
            <a:avLst/>
          </a:prstGeom>
          <a:noFill/>
        </p:spPr>
        <p:txBody>
          <a:bodyPr wrap="square" rtlCol="0">
            <a:spAutoFit/>
          </a:bodyPr>
          <a:lstStyle/>
          <a:p>
            <a:r>
              <a:rPr lang="en-US" sz="1440" dirty="0"/>
              <a:t>Midostaurin vs Venetoclax </a:t>
            </a:r>
          </a:p>
          <a:p>
            <a:r>
              <a:rPr lang="en-US" sz="1440" dirty="0"/>
              <a:t>FLT3-ITD AML samples</a:t>
            </a:r>
          </a:p>
        </p:txBody>
      </p:sp>
      <p:sp>
        <p:nvSpPr>
          <p:cNvPr id="3" name="TextBox 2"/>
          <p:cNvSpPr txBox="1"/>
          <p:nvPr/>
        </p:nvSpPr>
        <p:spPr>
          <a:xfrm>
            <a:off x="126282" y="1063562"/>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A</a:t>
            </a:r>
          </a:p>
        </p:txBody>
      </p:sp>
      <p:sp>
        <p:nvSpPr>
          <p:cNvPr id="4" name="TextBox 3"/>
          <p:cNvSpPr txBox="1"/>
          <p:nvPr/>
        </p:nvSpPr>
        <p:spPr>
          <a:xfrm>
            <a:off x="5246991" y="1418557"/>
            <a:ext cx="2230281" cy="535531"/>
          </a:xfrm>
          <a:prstGeom prst="rect">
            <a:avLst/>
          </a:prstGeom>
          <a:noFill/>
        </p:spPr>
        <p:txBody>
          <a:bodyPr wrap="square" rtlCol="0">
            <a:spAutoFit/>
          </a:bodyPr>
          <a:lstStyle/>
          <a:p>
            <a:r>
              <a:rPr lang="en-US" sz="1440" dirty="0"/>
              <a:t>Midostaurin vs Venetoclax</a:t>
            </a:r>
          </a:p>
          <a:p>
            <a:r>
              <a:rPr lang="en-US" sz="1440" dirty="0"/>
              <a:t> FLT3-WT AML samples</a:t>
            </a:r>
          </a:p>
        </p:txBody>
      </p:sp>
      <p:sp>
        <p:nvSpPr>
          <p:cNvPr id="5" name="TextBox 4"/>
          <p:cNvSpPr txBox="1"/>
          <p:nvPr/>
        </p:nvSpPr>
        <p:spPr>
          <a:xfrm>
            <a:off x="2916598" y="1418557"/>
            <a:ext cx="2153534" cy="535531"/>
          </a:xfrm>
          <a:prstGeom prst="rect">
            <a:avLst/>
          </a:prstGeom>
          <a:noFill/>
        </p:spPr>
        <p:txBody>
          <a:bodyPr wrap="square" rtlCol="0">
            <a:spAutoFit/>
          </a:bodyPr>
          <a:lstStyle/>
          <a:p>
            <a:r>
              <a:rPr lang="en-US" sz="1440" dirty="0"/>
              <a:t>Gilteritinib vs Venetoclax</a:t>
            </a:r>
          </a:p>
          <a:p>
            <a:r>
              <a:rPr lang="en-US" sz="1440" dirty="0"/>
              <a:t>FLT3-ITD AML samples</a:t>
            </a:r>
          </a:p>
        </p:txBody>
      </p:sp>
      <p:sp>
        <p:nvSpPr>
          <p:cNvPr id="6" name="TextBox 5"/>
          <p:cNvSpPr txBox="1"/>
          <p:nvPr/>
        </p:nvSpPr>
        <p:spPr>
          <a:xfrm>
            <a:off x="7477269" y="1418557"/>
            <a:ext cx="2107306" cy="535531"/>
          </a:xfrm>
          <a:prstGeom prst="rect">
            <a:avLst/>
          </a:prstGeom>
          <a:noFill/>
        </p:spPr>
        <p:txBody>
          <a:bodyPr wrap="square" rtlCol="0">
            <a:spAutoFit/>
          </a:bodyPr>
          <a:lstStyle/>
          <a:p>
            <a:r>
              <a:rPr lang="en-US" sz="1440" dirty="0"/>
              <a:t>Gilteritinib vs Venetoclax</a:t>
            </a:r>
          </a:p>
          <a:p>
            <a:r>
              <a:rPr lang="en-US" sz="1440" dirty="0"/>
              <a:t>FLT3-WT AML samples</a:t>
            </a:r>
          </a:p>
        </p:txBody>
      </p:sp>
      <p:pic>
        <p:nvPicPr>
          <p:cNvPr id="7" name="Picture 6"/>
          <p:cNvPicPr>
            <a:picLocks noChangeAspect="1"/>
          </p:cNvPicPr>
          <p:nvPr/>
        </p:nvPicPr>
        <p:blipFill rotWithShape="1">
          <a:blip r:embed="rId2" cstate="print">
            <a:extLst>
              <a:ext uri="{28A0092B-C50C-407E-A947-70E740481C1C}">
                <a14:useLocalDpi xmlns:a14="http://schemas.microsoft.com/office/drawing/2010/main" val="0"/>
              </a:ext>
            </a:extLst>
          </a:blip>
          <a:srcRect r="66716" b="7375"/>
          <a:stretch/>
        </p:blipFill>
        <p:spPr>
          <a:xfrm>
            <a:off x="5578098" y="1964155"/>
            <a:ext cx="1863807" cy="3746984"/>
          </a:xfrm>
          <a:prstGeom prst="rect">
            <a:avLst/>
          </a:prstGeom>
        </p:spPr>
      </p:pic>
      <p:pic>
        <p:nvPicPr>
          <p:cNvPr id="8" name="Picture 7"/>
          <p:cNvPicPr>
            <a:picLocks noChangeAspect="1"/>
          </p:cNvPicPr>
          <p:nvPr/>
        </p:nvPicPr>
        <p:blipFill rotWithShape="1">
          <a:blip r:embed="rId2" cstate="print">
            <a:extLst>
              <a:ext uri="{28A0092B-C50C-407E-A947-70E740481C1C}">
                <a14:useLocalDpi xmlns:a14="http://schemas.microsoft.com/office/drawing/2010/main" val="0"/>
              </a:ext>
            </a:extLst>
          </a:blip>
          <a:srcRect r="66716" b="7375"/>
          <a:stretch/>
        </p:blipFill>
        <p:spPr>
          <a:xfrm>
            <a:off x="7654713" y="1964155"/>
            <a:ext cx="1863807" cy="3746984"/>
          </a:xfrm>
          <a:prstGeom prst="rect">
            <a:avLst/>
          </a:prstGeom>
        </p:spPr>
      </p:pic>
      <p:pic>
        <p:nvPicPr>
          <p:cNvPr id="9" name="Picture 8"/>
          <p:cNvPicPr>
            <a:picLocks noChangeAspect="1"/>
          </p:cNvPicPr>
          <p:nvPr/>
        </p:nvPicPr>
        <p:blipFill rotWithShape="1">
          <a:blip r:embed="rId3" cstate="print">
            <a:extLst>
              <a:ext uri="{28A0092B-C50C-407E-A947-70E740481C1C}">
                <a14:useLocalDpi xmlns:a14="http://schemas.microsoft.com/office/drawing/2010/main" val="0"/>
              </a:ext>
            </a:extLst>
          </a:blip>
          <a:srcRect r="58709" b="6553"/>
          <a:stretch/>
        </p:blipFill>
        <p:spPr>
          <a:xfrm>
            <a:off x="448543" y="1964159"/>
            <a:ext cx="2312213" cy="4720133"/>
          </a:xfrm>
          <a:prstGeom prst="rect">
            <a:avLst/>
          </a:prstGeom>
        </p:spPr>
      </p:pic>
      <p:pic>
        <p:nvPicPr>
          <p:cNvPr id="10" name="Picture 9"/>
          <p:cNvPicPr>
            <a:picLocks noChangeAspect="1"/>
          </p:cNvPicPr>
          <p:nvPr/>
        </p:nvPicPr>
        <p:blipFill rotWithShape="1">
          <a:blip r:embed="rId4" cstate="print">
            <a:extLst>
              <a:ext uri="{28A0092B-C50C-407E-A947-70E740481C1C}">
                <a14:useLocalDpi xmlns:a14="http://schemas.microsoft.com/office/drawing/2010/main" val="0"/>
              </a:ext>
            </a:extLst>
          </a:blip>
          <a:srcRect r="57289" b="5924"/>
          <a:stretch/>
        </p:blipFill>
        <p:spPr>
          <a:xfrm>
            <a:off x="2973561" y="1964159"/>
            <a:ext cx="2391726" cy="4751938"/>
          </a:xfrm>
          <a:prstGeom prst="rect">
            <a:avLst/>
          </a:prstGeom>
        </p:spPr>
      </p:pic>
      <p:sp>
        <p:nvSpPr>
          <p:cNvPr id="11" name="TextBox 10"/>
          <p:cNvSpPr txBox="1"/>
          <p:nvPr/>
        </p:nvSpPr>
        <p:spPr>
          <a:xfrm>
            <a:off x="1858972" y="1063562"/>
            <a:ext cx="6122510" cy="313932"/>
          </a:xfrm>
          <a:prstGeom prst="rect">
            <a:avLst/>
          </a:prstGeom>
          <a:noFill/>
        </p:spPr>
        <p:txBody>
          <a:bodyPr wrap="square" rtlCol="0">
            <a:spAutoFit/>
          </a:bodyPr>
          <a:lstStyle/>
          <a:p>
            <a:pPr algn="ctr"/>
            <a:r>
              <a:rPr lang="en-US" sz="1440" b="1" dirty="0"/>
              <a:t>Mutational status of primary samples used in CFU </a:t>
            </a:r>
            <a:r>
              <a:rPr lang="en-US" sz="1440" b="1" dirty="0" err="1"/>
              <a:t>asssays</a:t>
            </a:r>
            <a:endParaRPr lang="en-US" sz="1440" b="1" dirty="0"/>
          </a:p>
        </p:txBody>
      </p:sp>
      <p:sp>
        <p:nvSpPr>
          <p:cNvPr id="12" name="TextBox 11"/>
          <p:cNvSpPr txBox="1"/>
          <p:nvPr/>
        </p:nvSpPr>
        <p:spPr>
          <a:xfrm>
            <a:off x="21357" y="14038638"/>
            <a:ext cx="9389510" cy="954107"/>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l Fig. 2:</a:t>
            </a:r>
            <a:r>
              <a:rPr lang="en-US" sz="1400" dirty="0">
                <a:latin typeface="Arial" panose="020B0604020202020204" pitchFamily="34" charset="0"/>
                <a:cs typeface="Arial" panose="020B0604020202020204" pitchFamily="34" charset="0"/>
              </a:rPr>
              <a:t> Primary samples used in CFU and MTS assays.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Mutations present in each sample are shown for samples used in CFU assays. </a:t>
            </a:r>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Dose-response curves of individual patient samples as well as mutations present in each sample are shown for samples used in MTS assays.</a:t>
            </a:r>
          </a:p>
          <a:p>
            <a:endParaRPr lang="en-US" sz="1400" dirty="0">
              <a:latin typeface="Arial" panose="020B0604020202020204" pitchFamily="34" charset="0"/>
              <a:cs typeface="Arial" panose="020B0604020202020204" pitchFamily="34" charset="0"/>
            </a:endParaRPr>
          </a:p>
        </p:txBody>
      </p:sp>
      <p:pic>
        <p:nvPicPr>
          <p:cNvPr id="13" name="Picture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0166" y="11223501"/>
            <a:ext cx="892702" cy="731520"/>
          </a:xfrm>
          <a:prstGeom prst="rect">
            <a:avLst/>
          </a:prstGeom>
        </p:spPr>
      </p:pic>
      <p:pic>
        <p:nvPicPr>
          <p:cNvPr id="14" name="Picture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445801" y="11223501"/>
            <a:ext cx="894474" cy="731520"/>
          </a:xfrm>
          <a:prstGeom prst="rect">
            <a:avLst/>
          </a:prstGeom>
        </p:spPr>
      </p:pic>
      <p:pic>
        <p:nvPicPr>
          <p:cNvPr id="15" name="Picture 1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38395" y="12057426"/>
            <a:ext cx="894474" cy="731520"/>
          </a:xfrm>
          <a:prstGeom prst="rect">
            <a:avLst/>
          </a:prstGeom>
        </p:spPr>
      </p:pic>
      <p:pic>
        <p:nvPicPr>
          <p:cNvPr id="16" name="Picture 15"/>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444034" y="12057426"/>
            <a:ext cx="896245" cy="731520"/>
          </a:xfrm>
          <a:prstGeom prst="rect">
            <a:avLst/>
          </a:prstGeom>
        </p:spPr>
      </p:pic>
      <p:pic>
        <p:nvPicPr>
          <p:cNvPr id="17" name="Picture 16"/>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36628" y="12891352"/>
            <a:ext cx="896245" cy="731520"/>
          </a:xfrm>
          <a:prstGeom prst="rect">
            <a:avLst/>
          </a:prstGeom>
        </p:spPr>
      </p:pic>
      <p:pic>
        <p:nvPicPr>
          <p:cNvPr id="18" name="Picture 17"/>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445801" y="12891352"/>
            <a:ext cx="894474" cy="731520"/>
          </a:xfrm>
          <a:prstGeom prst="rect">
            <a:avLst/>
          </a:prstGeom>
        </p:spPr>
      </p:pic>
      <p:pic>
        <p:nvPicPr>
          <p:cNvPr id="19" name="Picture 18"/>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74401" y="7454734"/>
            <a:ext cx="892702" cy="731520"/>
          </a:xfrm>
          <a:prstGeom prst="rect">
            <a:avLst/>
          </a:prstGeom>
        </p:spPr>
      </p:pic>
      <p:pic>
        <p:nvPicPr>
          <p:cNvPr id="20" name="Picture 19"/>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473422" y="7454734"/>
            <a:ext cx="894474" cy="731520"/>
          </a:xfrm>
          <a:prstGeom prst="rect">
            <a:avLst/>
          </a:prstGeom>
        </p:spPr>
      </p:pic>
      <p:pic>
        <p:nvPicPr>
          <p:cNvPr id="21" name="Picture 20"/>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74404" y="8288660"/>
            <a:ext cx="896245" cy="731520"/>
          </a:xfrm>
          <a:prstGeom prst="rect">
            <a:avLst/>
          </a:prstGeom>
        </p:spPr>
      </p:pic>
      <p:pic>
        <p:nvPicPr>
          <p:cNvPr id="22" name="Picture 21"/>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1473422" y="8288660"/>
            <a:ext cx="894474" cy="731520"/>
          </a:xfrm>
          <a:prstGeom prst="rect">
            <a:avLst/>
          </a:prstGeom>
        </p:spPr>
      </p:pic>
      <p:pic>
        <p:nvPicPr>
          <p:cNvPr id="23" name="Picture 22"/>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374401" y="9122586"/>
            <a:ext cx="892702" cy="731520"/>
          </a:xfrm>
          <a:prstGeom prst="rect">
            <a:avLst/>
          </a:prstGeom>
        </p:spPr>
      </p:pic>
      <p:pic>
        <p:nvPicPr>
          <p:cNvPr id="24" name="Picture 23"/>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1473422" y="9122586"/>
            <a:ext cx="894474" cy="731520"/>
          </a:xfrm>
          <a:prstGeom prst="rect">
            <a:avLst/>
          </a:prstGeom>
        </p:spPr>
      </p:pic>
      <p:pic>
        <p:nvPicPr>
          <p:cNvPr id="25" name="Picture 24"/>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374404" y="9956512"/>
            <a:ext cx="896245" cy="731520"/>
          </a:xfrm>
          <a:prstGeom prst="rect">
            <a:avLst/>
          </a:prstGeom>
        </p:spPr>
      </p:pic>
      <p:pic>
        <p:nvPicPr>
          <p:cNvPr id="26" name="Picture 25"/>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1472540" y="9956512"/>
            <a:ext cx="896245" cy="731520"/>
          </a:xfrm>
          <a:prstGeom prst="rect">
            <a:avLst/>
          </a:prstGeom>
        </p:spPr>
      </p:pic>
      <p:sp>
        <p:nvSpPr>
          <p:cNvPr id="27" name="TextBox 26"/>
          <p:cNvSpPr txBox="1"/>
          <p:nvPr/>
        </p:nvSpPr>
        <p:spPr>
          <a:xfrm>
            <a:off x="448983" y="7064856"/>
            <a:ext cx="3919758" cy="313932"/>
          </a:xfrm>
          <a:prstGeom prst="rect">
            <a:avLst/>
          </a:prstGeom>
          <a:noFill/>
        </p:spPr>
        <p:txBody>
          <a:bodyPr wrap="square" rtlCol="0">
            <a:spAutoFit/>
          </a:bodyPr>
          <a:lstStyle/>
          <a:p>
            <a:r>
              <a:rPr lang="en-US" sz="1440" dirty="0"/>
              <a:t>Midostaurin vs Venetoclax FLT3-ITD, n=4</a:t>
            </a:r>
          </a:p>
        </p:txBody>
      </p:sp>
      <p:pic>
        <p:nvPicPr>
          <p:cNvPr id="28" name="Picture 27"/>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4900940" y="7613457"/>
            <a:ext cx="896245" cy="731520"/>
          </a:xfrm>
          <a:prstGeom prst="rect">
            <a:avLst/>
          </a:prstGeom>
        </p:spPr>
      </p:pic>
      <p:pic>
        <p:nvPicPr>
          <p:cNvPr id="29" name="Picture 28"/>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6002613" y="7613457"/>
            <a:ext cx="894474" cy="731520"/>
          </a:xfrm>
          <a:prstGeom prst="rect">
            <a:avLst/>
          </a:prstGeom>
        </p:spPr>
      </p:pic>
      <p:pic>
        <p:nvPicPr>
          <p:cNvPr id="30" name="Picture 29"/>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4900940" y="8489446"/>
            <a:ext cx="896245" cy="731520"/>
          </a:xfrm>
          <a:prstGeom prst="rect">
            <a:avLst/>
          </a:prstGeom>
        </p:spPr>
      </p:pic>
      <p:pic>
        <p:nvPicPr>
          <p:cNvPr id="31" name="Picture 30"/>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6002613" y="8489446"/>
            <a:ext cx="894474" cy="731520"/>
          </a:xfrm>
          <a:prstGeom prst="rect">
            <a:avLst/>
          </a:prstGeom>
        </p:spPr>
      </p:pic>
      <p:pic>
        <p:nvPicPr>
          <p:cNvPr id="32" name="Picture 31"/>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4900940" y="9365436"/>
            <a:ext cx="896245" cy="731520"/>
          </a:xfrm>
          <a:prstGeom prst="rect">
            <a:avLst/>
          </a:prstGeom>
        </p:spPr>
      </p:pic>
      <p:pic>
        <p:nvPicPr>
          <p:cNvPr id="33" name="Picture 32"/>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6002618" y="9365436"/>
            <a:ext cx="896245" cy="731520"/>
          </a:xfrm>
          <a:prstGeom prst="rect">
            <a:avLst/>
          </a:prstGeom>
        </p:spPr>
      </p:pic>
      <p:pic>
        <p:nvPicPr>
          <p:cNvPr id="34" name="Picture 33"/>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4980973" y="11314846"/>
            <a:ext cx="894474" cy="731520"/>
          </a:xfrm>
          <a:prstGeom prst="rect">
            <a:avLst/>
          </a:prstGeom>
        </p:spPr>
      </p:pic>
      <p:pic>
        <p:nvPicPr>
          <p:cNvPr id="35" name="Picture 34"/>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6088379" y="11314846"/>
            <a:ext cx="894474" cy="731520"/>
          </a:xfrm>
          <a:prstGeom prst="rect">
            <a:avLst/>
          </a:prstGeom>
        </p:spPr>
      </p:pic>
      <p:pic>
        <p:nvPicPr>
          <p:cNvPr id="36" name="Picture 35"/>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4982745" y="12190835"/>
            <a:ext cx="892702" cy="731520"/>
          </a:xfrm>
          <a:prstGeom prst="rect">
            <a:avLst/>
          </a:prstGeom>
        </p:spPr>
      </p:pic>
      <p:pic>
        <p:nvPicPr>
          <p:cNvPr id="37" name="Picture 36"/>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6088379" y="12190835"/>
            <a:ext cx="894474" cy="731520"/>
          </a:xfrm>
          <a:prstGeom prst="rect">
            <a:avLst/>
          </a:prstGeom>
        </p:spPr>
      </p:pic>
      <p:sp>
        <p:nvSpPr>
          <p:cNvPr id="38" name="TextBox 37"/>
          <p:cNvSpPr txBox="1"/>
          <p:nvPr/>
        </p:nvSpPr>
        <p:spPr>
          <a:xfrm>
            <a:off x="114459" y="6783244"/>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B</a:t>
            </a:r>
          </a:p>
        </p:txBody>
      </p:sp>
      <p:pic>
        <p:nvPicPr>
          <p:cNvPr id="39" name="Picture 38"/>
          <p:cNvPicPr>
            <a:picLocks noChangeAspect="1"/>
          </p:cNvPicPr>
          <p:nvPr/>
        </p:nvPicPr>
        <p:blipFill rotWithShape="1">
          <a:blip r:embed="rId29" cstate="print">
            <a:extLst>
              <a:ext uri="{28A0092B-C50C-407E-A947-70E740481C1C}">
                <a14:useLocalDpi xmlns:a14="http://schemas.microsoft.com/office/drawing/2010/main" val="0"/>
              </a:ext>
            </a:extLst>
          </a:blip>
          <a:srcRect r="67886" b="13244"/>
          <a:stretch/>
        </p:blipFill>
        <p:spPr>
          <a:xfrm>
            <a:off x="2601862" y="7382648"/>
            <a:ext cx="1798308" cy="1764276"/>
          </a:xfrm>
          <a:prstGeom prst="rect">
            <a:avLst/>
          </a:prstGeom>
        </p:spPr>
      </p:pic>
      <p:sp>
        <p:nvSpPr>
          <p:cNvPr id="40" name="TextBox 39"/>
          <p:cNvSpPr txBox="1"/>
          <p:nvPr/>
        </p:nvSpPr>
        <p:spPr>
          <a:xfrm>
            <a:off x="336482" y="10833622"/>
            <a:ext cx="3800172" cy="313932"/>
          </a:xfrm>
          <a:prstGeom prst="rect">
            <a:avLst/>
          </a:prstGeom>
          <a:noFill/>
        </p:spPr>
        <p:txBody>
          <a:bodyPr wrap="square" rtlCol="0">
            <a:spAutoFit/>
          </a:bodyPr>
          <a:lstStyle/>
          <a:p>
            <a:r>
              <a:rPr lang="en-US" sz="1440" dirty="0"/>
              <a:t>Midostaurin vs Venetoclax FLT3-WT, n=3</a:t>
            </a:r>
          </a:p>
        </p:txBody>
      </p:sp>
      <p:pic>
        <p:nvPicPr>
          <p:cNvPr id="41" name="Picture 40"/>
          <p:cNvPicPr>
            <a:picLocks noChangeAspect="1"/>
          </p:cNvPicPr>
          <p:nvPr/>
        </p:nvPicPr>
        <p:blipFill rotWithShape="1">
          <a:blip r:embed="rId30" cstate="print">
            <a:extLst>
              <a:ext uri="{28A0092B-C50C-407E-A947-70E740481C1C}">
                <a14:useLocalDpi xmlns:a14="http://schemas.microsoft.com/office/drawing/2010/main" val="0"/>
              </a:ext>
            </a:extLst>
          </a:blip>
          <a:srcRect r="73315" b="9879"/>
          <a:stretch/>
        </p:blipFill>
        <p:spPr>
          <a:xfrm>
            <a:off x="2659722" y="11186930"/>
            <a:ext cx="1494292" cy="2435947"/>
          </a:xfrm>
          <a:prstGeom prst="rect">
            <a:avLst/>
          </a:prstGeom>
        </p:spPr>
      </p:pic>
      <p:sp>
        <p:nvSpPr>
          <p:cNvPr id="42" name="TextBox 41"/>
          <p:cNvSpPr txBox="1"/>
          <p:nvPr/>
        </p:nvSpPr>
        <p:spPr>
          <a:xfrm>
            <a:off x="4979058" y="7098024"/>
            <a:ext cx="3656338" cy="313932"/>
          </a:xfrm>
          <a:prstGeom prst="rect">
            <a:avLst/>
          </a:prstGeom>
          <a:noFill/>
        </p:spPr>
        <p:txBody>
          <a:bodyPr wrap="square" rtlCol="0">
            <a:spAutoFit/>
          </a:bodyPr>
          <a:lstStyle/>
          <a:p>
            <a:r>
              <a:rPr lang="en-US" sz="1440" dirty="0"/>
              <a:t>Gilteritinib vs Venetoclax FLT3-ITD, n=3</a:t>
            </a:r>
          </a:p>
        </p:txBody>
      </p:sp>
      <p:pic>
        <p:nvPicPr>
          <p:cNvPr id="43" name="Picture 42"/>
          <p:cNvPicPr>
            <a:picLocks noChangeAspect="1"/>
          </p:cNvPicPr>
          <p:nvPr/>
        </p:nvPicPr>
        <p:blipFill rotWithShape="1">
          <a:blip r:embed="rId31" cstate="print">
            <a:extLst>
              <a:ext uri="{28A0092B-C50C-407E-A947-70E740481C1C}">
                <a14:useLocalDpi xmlns:a14="http://schemas.microsoft.com/office/drawing/2010/main" val="0"/>
              </a:ext>
            </a:extLst>
          </a:blip>
          <a:srcRect r="69009" b="8542"/>
          <a:stretch/>
        </p:blipFill>
        <p:spPr>
          <a:xfrm>
            <a:off x="7163366" y="7440760"/>
            <a:ext cx="1735452" cy="3087594"/>
          </a:xfrm>
          <a:prstGeom prst="rect">
            <a:avLst/>
          </a:prstGeom>
        </p:spPr>
      </p:pic>
      <p:sp>
        <p:nvSpPr>
          <p:cNvPr id="44" name="TextBox 43"/>
          <p:cNvSpPr txBox="1"/>
          <p:nvPr/>
        </p:nvSpPr>
        <p:spPr>
          <a:xfrm>
            <a:off x="4979061" y="10799413"/>
            <a:ext cx="3504788" cy="313932"/>
          </a:xfrm>
          <a:prstGeom prst="rect">
            <a:avLst/>
          </a:prstGeom>
          <a:noFill/>
        </p:spPr>
        <p:txBody>
          <a:bodyPr wrap="square" rtlCol="0">
            <a:spAutoFit/>
          </a:bodyPr>
          <a:lstStyle/>
          <a:p>
            <a:r>
              <a:rPr lang="en-US" sz="1440" dirty="0"/>
              <a:t>Gilteritinib vs Venetoclax FLT3-WT, n=2</a:t>
            </a:r>
          </a:p>
        </p:txBody>
      </p:sp>
      <p:pic>
        <p:nvPicPr>
          <p:cNvPr id="45" name="Picture 44"/>
          <p:cNvPicPr>
            <a:picLocks noChangeAspect="1"/>
          </p:cNvPicPr>
          <p:nvPr/>
        </p:nvPicPr>
        <p:blipFill rotWithShape="1">
          <a:blip r:embed="rId32" cstate="print">
            <a:extLst>
              <a:ext uri="{28A0092B-C50C-407E-A947-70E740481C1C}">
                <a14:useLocalDpi xmlns:a14="http://schemas.microsoft.com/office/drawing/2010/main" val="0"/>
              </a:ext>
            </a:extLst>
          </a:blip>
          <a:srcRect r="72371" b="9109"/>
          <a:stretch/>
        </p:blipFill>
        <p:spPr>
          <a:xfrm>
            <a:off x="7246747" y="11175301"/>
            <a:ext cx="1547150" cy="2762594"/>
          </a:xfrm>
          <a:prstGeom prst="rect">
            <a:avLst/>
          </a:prstGeom>
        </p:spPr>
      </p:pic>
      <p:sp>
        <p:nvSpPr>
          <p:cNvPr id="46" name="TextBox 45"/>
          <p:cNvSpPr txBox="1"/>
          <p:nvPr/>
        </p:nvSpPr>
        <p:spPr>
          <a:xfrm>
            <a:off x="1920661" y="6778925"/>
            <a:ext cx="6122510" cy="313932"/>
          </a:xfrm>
          <a:prstGeom prst="rect">
            <a:avLst/>
          </a:prstGeom>
          <a:noFill/>
        </p:spPr>
        <p:txBody>
          <a:bodyPr wrap="square" rtlCol="0">
            <a:spAutoFit/>
          </a:bodyPr>
          <a:lstStyle/>
          <a:p>
            <a:pPr algn="ctr"/>
            <a:r>
              <a:rPr lang="en-US" sz="1440" b="1" dirty="0"/>
              <a:t>Mutational status and dose-response of primary samples used in MTS assays</a:t>
            </a:r>
          </a:p>
        </p:txBody>
      </p:sp>
    </p:spTree>
    <p:extLst>
      <p:ext uri="{BB962C8B-B14F-4D97-AF65-F5344CB8AC3E}">
        <p14:creationId xmlns:p14="http://schemas.microsoft.com/office/powerpoint/2010/main" val="11006311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58535" y="8204817"/>
            <a:ext cx="7919357" cy="2246769"/>
          </a:xfrm>
          <a:prstGeom prst="rect">
            <a:avLst/>
          </a:prstGeom>
        </p:spPr>
        <p:txBody>
          <a:bodyPr wrap="square">
            <a:spAutoFit/>
          </a:bodyPr>
          <a:lstStyle/>
          <a:p>
            <a:pPr algn="just"/>
            <a:r>
              <a:rPr lang="en-US" sz="1400" b="1" dirty="0">
                <a:latin typeface="Arial" panose="020B0604020202020204" pitchFamily="34" charset="0"/>
                <a:cs typeface="Arial" panose="020B0604020202020204" pitchFamily="34" charset="0"/>
              </a:rPr>
              <a:t>Supplemental Fig. 3: </a:t>
            </a:r>
            <a:r>
              <a:rPr lang="en-US" sz="1400" dirty="0">
                <a:latin typeface="Arial" panose="020B0604020202020204" pitchFamily="34" charset="0"/>
                <a:cs typeface="Arial" panose="020B0604020202020204" pitchFamily="34" charset="0"/>
              </a:rPr>
              <a:t>Histopathology of MOLM-13 xenograft. Histopathology was performed at the end of the study. Abundant neoplastic blast cells are found within the tissues of mice from all treatment groups. Cells are characterized by ample basophilic cytoplasm, central round nuclei, stippled chromatin, and 1-3 nucleoli. These cells fill the bone marrow cavity (outlined), expand the alveolar septa giving the lung an overall basophilic hue, and percolate throughout the hepatic sinusoids (arrows). Subjectively, the numbers of neoplastic cells in the tissues of mice treated with combination therapy are reduced. This is evidenced by increased quantity of typical hematopoietic bone marrow, an overall eosinophilic hue in the alveolar septa, and absence of blast cells percolating through the hepatic sinusoids. 10x Objective, Total Magnification= 600xBone Marrow, 100XLung</a:t>
            </a:r>
            <a:r>
              <a:rPr lang="en-US" sz="1400">
                <a:latin typeface="Arial" panose="020B0604020202020204" pitchFamily="34" charset="0"/>
                <a:cs typeface="Arial" panose="020B0604020202020204" pitchFamily="34" charset="0"/>
              </a:rPr>
              <a:t>, 400XLiver. </a:t>
            </a:r>
            <a:endParaRPr lang="en-US" sz="1400" dirty="0"/>
          </a:p>
        </p:txBody>
      </p:sp>
      <p:pic>
        <p:nvPicPr>
          <p:cNvPr id="5" name="Picture 4" descr="A close up&#10;&#10;Description automatically generated">
            <a:extLst>
              <a:ext uri="{FF2B5EF4-FFF2-40B4-BE49-F238E27FC236}">
                <a16:creationId xmlns:a16="http://schemas.microsoft.com/office/drawing/2014/main" id="{44DBE32D-16A3-4ABD-9180-B5BC1889A01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62708" y="4536295"/>
            <a:ext cx="2468880" cy="1755648"/>
          </a:xfrm>
          <a:prstGeom prst="rect">
            <a:avLst/>
          </a:prstGeom>
        </p:spPr>
      </p:pic>
      <p:pic>
        <p:nvPicPr>
          <p:cNvPr id="7" name="Picture 6" descr="A picture containing star, group, people, person&#10;&#10;Description automatically generated">
            <a:extLst>
              <a:ext uri="{FF2B5EF4-FFF2-40B4-BE49-F238E27FC236}">
                <a16:creationId xmlns:a16="http://schemas.microsoft.com/office/drawing/2014/main" id="{D38E4DED-B3C1-41C8-8F6C-F3B4F9D441B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62708" y="2734858"/>
            <a:ext cx="2468880" cy="1755648"/>
          </a:xfrm>
          <a:prstGeom prst="rect">
            <a:avLst/>
          </a:prstGeom>
        </p:spPr>
      </p:pic>
      <p:pic>
        <p:nvPicPr>
          <p:cNvPr id="9" name="Picture 8" descr="A picture containing purple, pink, laying, bed&#10;&#10;Description automatically generated">
            <a:extLst>
              <a:ext uri="{FF2B5EF4-FFF2-40B4-BE49-F238E27FC236}">
                <a16:creationId xmlns:a16="http://schemas.microsoft.com/office/drawing/2014/main" id="{A9AB8D16-8C7F-4A19-94B4-BD15DFC1944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76356" y="919773"/>
            <a:ext cx="2468880" cy="1755648"/>
          </a:xfrm>
          <a:prstGeom prst="rect">
            <a:avLst/>
          </a:prstGeom>
        </p:spPr>
      </p:pic>
      <p:pic>
        <p:nvPicPr>
          <p:cNvPr id="11" name="Picture 10" descr="A close up of a coral&#10;&#10;Description automatically generated">
            <a:extLst>
              <a:ext uri="{FF2B5EF4-FFF2-40B4-BE49-F238E27FC236}">
                <a16:creationId xmlns:a16="http://schemas.microsoft.com/office/drawing/2014/main" id="{D077A000-EFAD-4DFD-A096-3FD726ABBABB}"/>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62708" y="6326795"/>
            <a:ext cx="2468880" cy="1755648"/>
          </a:xfrm>
          <a:prstGeom prst="rect">
            <a:avLst/>
          </a:prstGeom>
        </p:spPr>
      </p:pic>
      <p:sp>
        <p:nvSpPr>
          <p:cNvPr id="12" name="TextBox 11">
            <a:extLst>
              <a:ext uri="{FF2B5EF4-FFF2-40B4-BE49-F238E27FC236}">
                <a16:creationId xmlns:a16="http://schemas.microsoft.com/office/drawing/2014/main" id="{AA882709-2195-4F7F-944E-E29D71739B87}"/>
              </a:ext>
            </a:extLst>
          </p:cNvPr>
          <p:cNvSpPr txBox="1"/>
          <p:nvPr/>
        </p:nvSpPr>
        <p:spPr>
          <a:xfrm rot="16200000">
            <a:off x="-553830" y="1660109"/>
            <a:ext cx="1981200" cy="369332"/>
          </a:xfrm>
          <a:prstGeom prst="rect">
            <a:avLst/>
          </a:prstGeom>
          <a:noFill/>
        </p:spPr>
        <p:txBody>
          <a:bodyPr wrap="square" rtlCol="0">
            <a:spAutoFit/>
          </a:bodyPr>
          <a:lstStyle/>
          <a:p>
            <a:pPr algn="ctr"/>
            <a:r>
              <a:rPr lang="en-US" dirty="0"/>
              <a:t>Vehicle</a:t>
            </a:r>
          </a:p>
        </p:txBody>
      </p:sp>
      <p:sp>
        <p:nvSpPr>
          <p:cNvPr id="13" name="TextBox 12">
            <a:extLst>
              <a:ext uri="{FF2B5EF4-FFF2-40B4-BE49-F238E27FC236}">
                <a16:creationId xmlns:a16="http://schemas.microsoft.com/office/drawing/2014/main" id="{3BC952E0-67B3-4AB6-B5BA-19B6F21B4013}"/>
              </a:ext>
            </a:extLst>
          </p:cNvPr>
          <p:cNvSpPr txBox="1"/>
          <p:nvPr/>
        </p:nvSpPr>
        <p:spPr>
          <a:xfrm>
            <a:off x="1025598" y="514215"/>
            <a:ext cx="1981200" cy="369332"/>
          </a:xfrm>
          <a:prstGeom prst="rect">
            <a:avLst/>
          </a:prstGeom>
          <a:noFill/>
        </p:spPr>
        <p:txBody>
          <a:bodyPr wrap="square" rtlCol="0">
            <a:spAutoFit/>
          </a:bodyPr>
          <a:lstStyle/>
          <a:p>
            <a:pPr algn="ctr"/>
            <a:r>
              <a:rPr lang="en-US" dirty="0"/>
              <a:t>Bone Marrow 600x</a:t>
            </a:r>
          </a:p>
        </p:txBody>
      </p:sp>
      <p:sp>
        <p:nvSpPr>
          <p:cNvPr id="14" name="TextBox 13">
            <a:extLst>
              <a:ext uri="{FF2B5EF4-FFF2-40B4-BE49-F238E27FC236}">
                <a16:creationId xmlns:a16="http://schemas.microsoft.com/office/drawing/2014/main" id="{0A8330CC-37E3-4461-8A52-78FA32582757}"/>
              </a:ext>
            </a:extLst>
          </p:cNvPr>
          <p:cNvSpPr txBox="1"/>
          <p:nvPr/>
        </p:nvSpPr>
        <p:spPr>
          <a:xfrm rot="16200000">
            <a:off x="-553831" y="5149055"/>
            <a:ext cx="1981200" cy="369332"/>
          </a:xfrm>
          <a:prstGeom prst="rect">
            <a:avLst/>
          </a:prstGeom>
          <a:noFill/>
        </p:spPr>
        <p:txBody>
          <a:bodyPr wrap="square" rtlCol="0">
            <a:spAutoFit/>
          </a:bodyPr>
          <a:lstStyle/>
          <a:p>
            <a:pPr algn="ctr"/>
            <a:r>
              <a:rPr lang="en-US" dirty="0" err="1"/>
              <a:t>Midostaurin</a:t>
            </a:r>
            <a:endParaRPr lang="en-US" dirty="0"/>
          </a:p>
        </p:txBody>
      </p:sp>
      <p:sp>
        <p:nvSpPr>
          <p:cNvPr id="15" name="TextBox 14">
            <a:extLst>
              <a:ext uri="{FF2B5EF4-FFF2-40B4-BE49-F238E27FC236}">
                <a16:creationId xmlns:a16="http://schemas.microsoft.com/office/drawing/2014/main" id="{2B571047-3850-4473-9788-D4FA5E711B98}"/>
              </a:ext>
            </a:extLst>
          </p:cNvPr>
          <p:cNvSpPr txBox="1"/>
          <p:nvPr/>
        </p:nvSpPr>
        <p:spPr>
          <a:xfrm rot="16200000">
            <a:off x="-553830" y="3404582"/>
            <a:ext cx="1981200" cy="369332"/>
          </a:xfrm>
          <a:prstGeom prst="rect">
            <a:avLst/>
          </a:prstGeom>
          <a:noFill/>
        </p:spPr>
        <p:txBody>
          <a:bodyPr wrap="square" rtlCol="0">
            <a:spAutoFit/>
          </a:bodyPr>
          <a:lstStyle/>
          <a:p>
            <a:pPr algn="ctr"/>
            <a:r>
              <a:rPr lang="en-US" dirty="0" err="1"/>
              <a:t>Venetoclax</a:t>
            </a:r>
            <a:endParaRPr lang="en-US" dirty="0"/>
          </a:p>
        </p:txBody>
      </p:sp>
      <p:sp>
        <p:nvSpPr>
          <p:cNvPr id="16" name="TextBox 15">
            <a:extLst>
              <a:ext uri="{FF2B5EF4-FFF2-40B4-BE49-F238E27FC236}">
                <a16:creationId xmlns:a16="http://schemas.microsoft.com/office/drawing/2014/main" id="{F6E73C32-4F07-4FDF-AE95-0E107D022FA9}"/>
              </a:ext>
            </a:extLst>
          </p:cNvPr>
          <p:cNvSpPr txBox="1"/>
          <p:nvPr/>
        </p:nvSpPr>
        <p:spPr>
          <a:xfrm rot="16200000">
            <a:off x="-553831" y="6893529"/>
            <a:ext cx="1981200" cy="369332"/>
          </a:xfrm>
          <a:prstGeom prst="rect">
            <a:avLst/>
          </a:prstGeom>
          <a:noFill/>
        </p:spPr>
        <p:txBody>
          <a:bodyPr wrap="square" rtlCol="0">
            <a:spAutoFit/>
          </a:bodyPr>
          <a:lstStyle/>
          <a:p>
            <a:pPr algn="ctr"/>
            <a:r>
              <a:rPr lang="en-US" dirty="0"/>
              <a:t>Combination</a:t>
            </a:r>
          </a:p>
        </p:txBody>
      </p:sp>
      <p:pic>
        <p:nvPicPr>
          <p:cNvPr id="18" name="Picture 17" descr="A close up of a flower&#10;&#10;Description automatically generated">
            <a:extLst>
              <a:ext uri="{FF2B5EF4-FFF2-40B4-BE49-F238E27FC236}">
                <a16:creationId xmlns:a16="http://schemas.microsoft.com/office/drawing/2014/main" id="{E106BE95-36B0-487A-B153-AFA37B493F69}"/>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297422" y="925242"/>
            <a:ext cx="2468880" cy="1755648"/>
          </a:xfrm>
          <a:prstGeom prst="rect">
            <a:avLst/>
          </a:prstGeom>
        </p:spPr>
      </p:pic>
      <p:pic>
        <p:nvPicPr>
          <p:cNvPr id="20" name="Picture 19" descr="A close up of a flower&#10;&#10;Description automatically generated">
            <a:extLst>
              <a:ext uri="{FF2B5EF4-FFF2-40B4-BE49-F238E27FC236}">
                <a16:creationId xmlns:a16="http://schemas.microsoft.com/office/drawing/2014/main" id="{15F713DF-5A2D-4833-B4BA-0C1E4F07A729}"/>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283774" y="6326795"/>
            <a:ext cx="2468880" cy="1755648"/>
          </a:xfrm>
          <a:prstGeom prst="rect">
            <a:avLst/>
          </a:prstGeom>
        </p:spPr>
      </p:pic>
      <p:pic>
        <p:nvPicPr>
          <p:cNvPr id="22" name="Picture 21" descr="A close up of a flower&#10;&#10;Description automatically generated">
            <a:extLst>
              <a:ext uri="{FF2B5EF4-FFF2-40B4-BE49-F238E27FC236}">
                <a16:creationId xmlns:a16="http://schemas.microsoft.com/office/drawing/2014/main" id="{E83EC332-12A3-44CA-B178-1037EA6B390E}"/>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288738" y="4536295"/>
            <a:ext cx="2468880" cy="1755648"/>
          </a:xfrm>
          <a:prstGeom prst="rect">
            <a:avLst/>
          </a:prstGeom>
        </p:spPr>
      </p:pic>
      <p:pic>
        <p:nvPicPr>
          <p:cNvPr id="24" name="Picture 23" descr="A picture containing fabric&#10;&#10;Description automatically generated">
            <a:extLst>
              <a:ext uri="{FF2B5EF4-FFF2-40B4-BE49-F238E27FC236}">
                <a16:creationId xmlns:a16="http://schemas.microsoft.com/office/drawing/2014/main" id="{B9A36E4D-1EE6-4D12-A2DE-2E62F02D72FD}"/>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288738" y="2734858"/>
            <a:ext cx="2468880" cy="1755648"/>
          </a:xfrm>
          <a:prstGeom prst="rect">
            <a:avLst/>
          </a:prstGeom>
        </p:spPr>
      </p:pic>
      <p:sp>
        <p:nvSpPr>
          <p:cNvPr id="25" name="TextBox 24">
            <a:extLst>
              <a:ext uri="{FF2B5EF4-FFF2-40B4-BE49-F238E27FC236}">
                <a16:creationId xmlns:a16="http://schemas.microsoft.com/office/drawing/2014/main" id="{B37F35E9-3E65-4AFE-8CA6-0BA6E9544A6E}"/>
              </a:ext>
            </a:extLst>
          </p:cNvPr>
          <p:cNvSpPr txBox="1"/>
          <p:nvPr/>
        </p:nvSpPr>
        <p:spPr>
          <a:xfrm>
            <a:off x="3546445" y="514215"/>
            <a:ext cx="1981200" cy="369332"/>
          </a:xfrm>
          <a:prstGeom prst="rect">
            <a:avLst/>
          </a:prstGeom>
          <a:noFill/>
        </p:spPr>
        <p:txBody>
          <a:bodyPr wrap="square" rtlCol="0">
            <a:spAutoFit/>
          </a:bodyPr>
          <a:lstStyle/>
          <a:p>
            <a:pPr algn="ctr"/>
            <a:r>
              <a:rPr lang="en-US" dirty="0"/>
              <a:t>Lung 100x</a:t>
            </a:r>
          </a:p>
        </p:txBody>
      </p:sp>
      <p:sp>
        <p:nvSpPr>
          <p:cNvPr id="26" name="TextBox 25">
            <a:extLst>
              <a:ext uri="{FF2B5EF4-FFF2-40B4-BE49-F238E27FC236}">
                <a16:creationId xmlns:a16="http://schemas.microsoft.com/office/drawing/2014/main" id="{22C1944B-8154-44DF-8AB1-B81DBEFE40F4}"/>
              </a:ext>
            </a:extLst>
          </p:cNvPr>
          <p:cNvSpPr txBox="1"/>
          <p:nvPr/>
        </p:nvSpPr>
        <p:spPr>
          <a:xfrm>
            <a:off x="6067292" y="514215"/>
            <a:ext cx="1981200" cy="369332"/>
          </a:xfrm>
          <a:prstGeom prst="rect">
            <a:avLst/>
          </a:prstGeom>
          <a:noFill/>
        </p:spPr>
        <p:txBody>
          <a:bodyPr wrap="square" rtlCol="0">
            <a:spAutoFit/>
          </a:bodyPr>
          <a:lstStyle/>
          <a:p>
            <a:pPr algn="ctr"/>
            <a:r>
              <a:rPr lang="en-US" dirty="0"/>
              <a:t>Liver 400x </a:t>
            </a:r>
          </a:p>
        </p:txBody>
      </p:sp>
      <p:pic>
        <p:nvPicPr>
          <p:cNvPr id="28" name="Picture 27" descr="A close up of a coral&#10;&#10;Description automatically generated">
            <a:extLst>
              <a:ext uri="{FF2B5EF4-FFF2-40B4-BE49-F238E27FC236}">
                <a16:creationId xmlns:a16="http://schemas.microsoft.com/office/drawing/2014/main" id="{87BAC3F4-13B3-4693-B3EB-87E546E635F0}"/>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5819110" y="4527355"/>
            <a:ext cx="2468880" cy="1755648"/>
          </a:xfrm>
          <a:prstGeom prst="rect">
            <a:avLst/>
          </a:prstGeom>
        </p:spPr>
      </p:pic>
      <p:pic>
        <p:nvPicPr>
          <p:cNvPr id="30" name="Picture 29" descr="A picture containing umbrella, holding, large, group&#10;&#10;Description automatically generated">
            <a:extLst>
              <a:ext uri="{FF2B5EF4-FFF2-40B4-BE49-F238E27FC236}">
                <a16:creationId xmlns:a16="http://schemas.microsoft.com/office/drawing/2014/main" id="{CE2C43A6-7703-430B-B0CB-08FA384CCE2F}"/>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819110" y="933421"/>
            <a:ext cx="2468880" cy="1755648"/>
          </a:xfrm>
          <a:prstGeom prst="rect">
            <a:avLst/>
          </a:prstGeom>
        </p:spPr>
      </p:pic>
      <p:pic>
        <p:nvPicPr>
          <p:cNvPr id="32" name="Picture 31" descr="A star filled sky&#10;&#10;Description automatically generated">
            <a:extLst>
              <a:ext uri="{FF2B5EF4-FFF2-40B4-BE49-F238E27FC236}">
                <a16:creationId xmlns:a16="http://schemas.microsoft.com/office/drawing/2014/main" id="{D115F7A2-A1C1-4E31-A48E-0A758E53CB8B}"/>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819110" y="2730388"/>
            <a:ext cx="2468880" cy="1755648"/>
          </a:xfrm>
          <a:prstGeom prst="rect">
            <a:avLst/>
          </a:prstGeom>
        </p:spPr>
      </p:pic>
      <p:pic>
        <p:nvPicPr>
          <p:cNvPr id="34" name="Picture 33" descr="A picture containing shower, person, umbrella, beach&#10;&#10;Description automatically generated">
            <a:extLst>
              <a:ext uri="{FF2B5EF4-FFF2-40B4-BE49-F238E27FC236}">
                <a16:creationId xmlns:a16="http://schemas.microsoft.com/office/drawing/2014/main" id="{EAC95780-D3AD-4EFC-A0BC-6C30E8738780}"/>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819110" y="6324321"/>
            <a:ext cx="2468880" cy="1755648"/>
          </a:xfrm>
          <a:prstGeom prst="rect">
            <a:avLst/>
          </a:prstGeom>
        </p:spPr>
      </p:pic>
      <p:cxnSp>
        <p:nvCxnSpPr>
          <p:cNvPr id="39" name="Straight Arrow Connector 38">
            <a:extLst>
              <a:ext uri="{FF2B5EF4-FFF2-40B4-BE49-F238E27FC236}">
                <a16:creationId xmlns:a16="http://schemas.microsoft.com/office/drawing/2014/main" id="{714CFD91-C9E5-45D8-840D-CF3BFFB5AC7A}"/>
              </a:ext>
            </a:extLst>
          </p:cNvPr>
          <p:cNvCxnSpPr>
            <a:cxnSpLocks/>
          </p:cNvCxnSpPr>
          <p:nvPr/>
        </p:nvCxnSpPr>
        <p:spPr>
          <a:xfrm flipH="1">
            <a:off x="7588155" y="1653655"/>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90B0F2D0-7415-4167-8CFC-7DA7FC71D032}"/>
              </a:ext>
            </a:extLst>
          </p:cNvPr>
          <p:cNvCxnSpPr>
            <a:cxnSpLocks/>
          </p:cNvCxnSpPr>
          <p:nvPr/>
        </p:nvCxnSpPr>
        <p:spPr>
          <a:xfrm flipH="1">
            <a:off x="7600390" y="2213212"/>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42" name="Straight Arrow Connector 41">
            <a:extLst>
              <a:ext uri="{FF2B5EF4-FFF2-40B4-BE49-F238E27FC236}">
                <a16:creationId xmlns:a16="http://schemas.microsoft.com/office/drawing/2014/main" id="{226A645E-13A6-41C1-911B-1F8DE8444551}"/>
              </a:ext>
            </a:extLst>
          </p:cNvPr>
          <p:cNvCxnSpPr>
            <a:cxnSpLocks/>
          </p:cNvCxnSpPr>
          <p:nvPr/>
        </p:nvCxnSpPr>
        <p:spPr>
          <a:xfrm flipH="1">
            <a:off x="6568260" y="5684293"/>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43" name="Straight Arrow Connector 42">
            <a:extLst>
              <a:ext uri="{FF2B5EF4-FFF2-40B4-BE49-F238E27FC236}">
                <a16:creationId xmlns:a16="http://schemas.microsoft.com/office/drawing/2014/main" id="{97DD1708-BCCC-4712-BDAC-3B0BDBCD0391}"/>
              </a:ext>
            </a:extLst>
          </p:cNvPr>
          <p:cNvCxnSpPr>
            <a:cxnSpLocks/>
          </p:cNvCxnSpPr>
          <p:nvPr/>
        </p:nvCxnSpPr>
        <p:spPr>
          <a:xfrm flipH="1">
            <a:off x="7677728" y="5017827"/>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44" name="Straight Arrow Connector 43">
            <a:extLst>
              <a:ext uri="{FF2B5EF4-FFF2-40B4-BE49-F238E27FC236}">
                <a16:creationId xmlns:a16="http://schemas.microsoft.com/office/drawing/2014/main" id="{F3EDD0F4-1EE3-489D-9768-2CD2FD4D77BF}"/>
              </a:ext>
            </a:extLst>
          </p:cNvPr>
          <p:cNvCxnSpPr>
            <a:cxnSpLocks/>
          </p:cNvCxnSpPr>
          <p:nvPr/>
        </p:nvCxnSpPr>
        <p:spPr>
          <a:xfrm flipH="1">
            <a:off x="7435755" y="3668974"/>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cxnSp>
        <p:nvCxnSpPr>
          <p:cNvPr id="45" name="Straight Arrow Connector 44">
            <a:extLst>
              <a:ext uri="{FF2B5EF4-FFF2-40B4-BE49-F238E27FC236}">
                <a16:creationId xmlns:a16="http://schemas.microsoft.com/office/drawing/2014/main" id="{341DCE90-1162-49DC-BBB4-072CB12AC5E3}"/>
              </a:ext>
            </a:extLst>
          </p:cNvPr>
          <p:cNvCxnSpPr>
            <a:cxnSpLocks/>
          </p:cNvCxnSpPr>
          <p:nvPr/>
        </p:nvCxnSpPr>
        <p:spPr>
          <a:xfrm flipH="1">
            <a:off x="6810233" y="3152634"/>
            <a:ext cx="241973" cy="0"/>
          </a:xfrm>
          <a:prstGeom prst="straightConnector1">
            <a:avLst/>
          </a:prstGeom>
          <a:ln w="38100">
            <a:tailEnd type="triangle"/>
          </a:ln>
        </p:spPr>
        <p:style>
          <a:lnRef idx="1">
            <a:schemeClr val="dk1"/>
          </a:lnRef>
          <a:fillRef idx="0">
            <a:schemeClr val="dk1"/>
          </a:fillRef>
          <a:effectRef idx="0">
            <a:schemeClr val="dk1"/>
          </a:effectRef>
          <a:fontRef idx="minor">
            <a:schemeClr val="tx1"/>
          </a:fontRef>
        </p:style>
      </p:cxnSp>
      <p:sp>
        <p:nvSpPr>
          <p:cNvPr id="47" name="Freeform: Shape 46">
            <a:extLst>
              <a:ext uri="{FF2B5EF4-FFF2-40B4-BE49-F238E27FC236}">
                <a16:creationId xmlns:a16="http://schemas.microsoft.com/office/drawing/2014/main" id="{FED62A9F-7D84-4FEE-8F84-A4269FF02A9B}"/>
              </a:ext>
            </a:extLst>
          </p:cNvPr>
          <p:cNvSpPr/>
          <p:nvPr/>
        </p:nvSpPr>
        <p:spPr>
          <a:xfrm>
            <a:off x="770192" y="882800"/>
            <a:ext cx="2425117" cy="1715848"/>
          </a:xfrm>
          <a:custGeom>
            <a:avLst/>
            <a:gdLst>
              <a:gd name="connsiteX0" fmla="*/ 7729 w 2384808"/>
              <a:gd name="connsiteY0" fmla="*/ 72543 h 1560149"/>
              <a:gd name="connsiteX1" fmla="*/ 21377 w 2384808"/>
              <a:gd name="connsiteY1" fmla="*/ 195373 h 1560149"/>
              <a:gd name="connsiteX2" fmla="*/ 21377 w 2384808"/>
              <a:gd name="connsiteY2" fmla="*/ 782227 h 1560149"/>
              <a:gd name="connsiteX3" fmla="*/ 62320 w 2384808"/>
              <a:gd name="connsiteY3" fmla="*/ 823170 h 1560149"/>
              <a:gd name="connsiteX4" fmla="*/ 185150 w 2384808"/>
              <a:gd name="connsiteY4" fmla="*/ 877761 h 1560149"/>
              <a:gd name="connsiteX5" fmla="*/ 280685 w 2384808"/>
              <a:gd name="connsiteY5" fmla="*/ 918704 h 1560149"/>
              <a:gd name="connsiteX6" fmla="*/ 321628 w 2384808"/>
              <a:gd name="connsiteY6" fmla="*/ 946000 h 1560149"/>
              <a:gd name="connsiteX7" fmla="*/ 403514 w 2384808"/>
              <a:gd name="connsiteY7" fmla="*/ 973296 h 1560149"/>
              <a:gd name="connsiteX8" fmla="*/ 526344 w 2384808"/>
              <a:gd name="connsiteY8" fmla="*/ 1068830 h 1560149"/>
              <a:gd name="connsiteX9" fmla="*/ 567288 w 2384808"/>
              <a:gd name="connsiteY9" fmla="*/ 1123421 h 1560149"/>
              <a:gd name="connsiteX10" fmla="*/ 731061 w 2384808"/>
              <a:gd name="connsiteY10" fmla="*/ 1109773 h 1560149"/>
              <a:gd name="connsiteX11" fmla="*/ 758356 w 2384808"/>
              <a:gd name="connsiteY11" fmla="*/ 1027887 h 1560149"/>
              <a:gd name="connsiteX12" fmla="*/ 744708 w 2384808"/>
              <a:gd name="connsiteY12" fmla="*/ 918704 h 1560149"/>
              <a:gd name="connsiteX13" fmla="*/ 608231 w 2384808"/>
              <a:gd name="connsiteY13" fmla="*/ 823170 h 1560149"/>
              <a:gd name="connsiteX14" fmla="*/ 307980 w 2384808"/>
              <a:gd name="connsiteY14" fmla="*/ 809522 h 1560149"/>
              <a:gd name="connsiteX15" fmla="*/ 226094 w 2384808"/>
              <a:gd name="connsiteY15" fmla="*/ 768579 h 1560149"/>
              <a:gd name="connsiteX16" fmla="*/ 198798 w 2384808"/>
              <a:gd name="connsiteY16" fmla="*/ 686693 h 1560149"/>
              <a:gd name="connsiteX17" fmla="*/ 198798 w 2384808"/>
              <a:gd name="connsiteY17" fmla="*/ 454681 h 1560149"/>
              <a:gd name="connsiteX18" fmla="*/ 226094 w 2384808"/>
              <a:gd name="connsiteY18" fmla="*/ 413737 h 1560149"/>
              <a:gd name="connsiteX19" fmla="*/ 307980 w 2384808"/>
              <a:gd name="connsiteY19" fmla="*/ 372794 h 1560149"/>
              <a:gd name="connsiteX20" fmla="*/ 567288 w 2384808"/>
              <a:gd name="connsiteY20" fmla="*/ 386442 h 1560149"/>
              <a:gd name="connsiteX21" fmla="*/ 608231 w 2384808"/>
              <a:gd name="connsiteY21" fmla="*/ 413737 h 1560149"/>
              <a:gd name="connsiteX22" fmla="*/ 649174 w 2384808"/>
              <a:gd name="connsiteY22" fmla="*/ 427385 h 1560149"/>
              <a:gd name="connsiteX23" fmla="*/ 676470 w 2384808"/>
              <a:gd name="connsiteY23" fmla="*/ 468328 h 1560149"/>
              <a:gd name="connsiteX24" fmla="*/ 717413 w 2384808"/>
              <a:gd name="connsiteY24" fmla="*/ 481976 h 1560149"/>
              <a:gd name="connsiteX25" fmla="*/ 785652 w 2384808"/>
              <a:gd name="connsiteY25" fmla="*/ 563863 h 1560149"/>
              <a:gd name="connsiteX26" fmla="*/ 812947 w 2384808"/>
              <a:gd name="connsiteY26" fmla="*/ 645749 h 1560149"/>
              <a:gd name="connsiteX27" fmla="*/ 826595 w 2384808"/>
              <a:gd name="connsiteY27" fmla="*/ 686693 h 1560149"/>
              <a:gd name="connsiteX28" fmla="*/ 840243 w 2384808"/>
              <a:gd name="connsiteY28" fmla="*/ 727636 h 1560149"/>
              <a:gd name="connsiteX29" fmla="*/ 894834 w 2384808"/>
              <a:gd name="connsiteY29" fmla="*/ 809522 h 1560149"/>
              <a:gd name="connsiteX30" fmla="*/ 976720 w 2384808"/>
              <a:gd name="connsiteY30" fmla="*/ 850466 h 1560149"/>
              <a:gd name="connsiteX31" fmla="*/ 1017664 w 2384808"/>
              <a:gd name="connsiteY31" fmla="*/ 864113 h 1560149"/>
              <a:gd name="connsiteX32" fmla="*/ 1140494 w 2384808"/>
              <a:gd name="connsiteY32" fmla="*/ 932352 h 1560149"/>
              <a:gd name="connsiteX33" fmla="*/ 1181437 w 2384808"/>
              <a:gd name="connsiteY33" fmla="*/ 973296 h 1560149"/>
              <a:gd name="connsiteX34" fmla="*/ 1317914 w 2384808"/>
              <a:gd name="connsiteY34" fmla="*/ 1055182 h 1560149"/>
              <a:gd name="connsiteX35" fmla="*/ 1399801 w 2384808"/>
              <a:gd name="connsiteY35" fmla="*/ 1096125 h 1560149"/>
              <a:gd name="connsiteX36" fmla="*/ 1440744 w 2384808"/>
              <a:gd name="connsiteY36" fmla="*/ 1123421 h 1560149"/>
              <a:gd name="connsiteX37" fmla="*/ 1481688 w 2384808"/>
              <a:gd name="connsiteY37" fmla="*/ 1164364 h 1560149"/>
              <a:gd name="connsiteX38" fmla="*/ 1522631 w 2384808"/>
              <a:gd name="connsiteY38" fmla="*/ 1178012 h 1560149"/>
              <a:gd name="connsiteX39" fmla="*/ 1563574 w 2384808"/>
              <a:gd name="connsiteY39" fmla="*/ 1205307 h 1560149"/>
              <a:gd name="connsiteX40" fmla="*/ 1604517 w 2384808"/>
              <a:gd name="connsiteY40" fmla="*/ 1218955 h 1560149"/>
              <a:gd name="connsiteX41" fmla="*/ 1686404 w 2384808"/>
              <a:gd name="connsiteY41" fmla="*/ 1273546 h 1560149"/>
              <a:gd name="connsiteX42" fmla="*/ 1727347 w 2384808"/>
              <a:gd name="connsiteY42" fmla="*/ 1287194 h 1560149"/>
              <a:gd name="connsiteX43" fmla="*/ 1863825 w 2384808"/>
              <a:gd name="connsiteY43" fmla="*/ 1382728 h 1560149"/>
              <a:gd name="connsiteX44" fmla="*/ 1932064 w 2384808"/>
              <a:gd name="connsiteY44" fmla="*/ 1450967 h 1560149"/>
              <a:gd name="connsiteX45" fmla="*/ 2013950 w 2384808"/>
              <a:gd name="connsiteY45" fmla="*/ 1519206 h 1560149"/>
              <a:gd name="connsiteX46" fmla="*/ 2150428 w 2384808"/>
              <a:gd name="connsiteY46" fmla="*/ 1546501 h 1560149"/>
              <a:gd name="connsiteX47" fmla="*/ 2205019 w 2384808"/>
              <a:gd name="connsiteY47" fmla="*/ 1560149 h 1560149"/>
              <a:gd name="connsiteX48" fmla="*/ 2273258 w 2384808"/>
              <a:gd name="connsiteY48" fmla="*/ 1546501 h 1560149"/>
              <a:gd name="connsiteX49" fmla="*/ 2355144 w 2384808"/>
              <a:gd name="connsiteY49" fmla="*/ 1478263 h 1560149"/>
              <a:gd name="connsiteX50" fmla="*/ 2368792 w 2384808"/>
              <a:gd name="connsiteY50" fmla="*/ 1300842 h 1560149"/>
              <a:gd name="connsiteX51" fmla="*/ 2327849 w 2384808"/>
              <a:gd name="connsiteY51" fmla="*/ 1246251 h 1560149"/>
              <a:gd name="connsiteX52" fmla="*/ 2245962 w 2384808"/>
              <a:gd name="connsiteY52" fmla="*/ 1164364 h 1560149"/>
              <a:gd name="connsiteX53" fmla="*/ 2164076 w 2384808"/>
              <a:gd name="connsiteY53" fmla="*/ 1109773 h 1560149"/>
              <a:gd name="connsiteX54" fmla="*/ 2136780 w 2384808"/>
              <a:gd name="connsiteY54" fmla="*/ 1068830 h 1560149"/>
              <a:gd name="connsiteX55" fmla="*/ 2095837 w 2384808"/>
              <a:gd name="connsiteY55" fmla="*/ 1027887 h 1560149"/>
              <a:gd name="connsiteX56" fmla="*/ 2082189 w 2384808"/>
              <a:gd name="connsiteY56" fmla="*/ 986943 h 1560149"/>
              <a:gd name="connsiteX57" fmla="*/ 2027598 w 2384808"/>
              <a:gd name="connsiteY57" fmla="*/ 891409 h 1560149"/>
              <a:gd name="connsiteX58" fmla="*/ 2013950 w 2384808"/>
              <a:gd name="connsiteY58" fmla="*/ 850466 h 1560149"/>
              <a:gd name="connsiteX59" fmla="*/ 1959359 w 2384808"/>
              <a:gd name="connsiteY59" fmla="*/ 768579 h 1560149"/>
              <a:gd name="connsiteX60" fmla="*/ 1932064 w 2384808"/>
              <a:gd name="connsiteY60" fmla="*/ 713988 h 1560149"/>
              <a:gd name="connsiteX61" fmla="*/ 1918416 w 2384808"/>
              <a:gd name="connsiteY61" fmla="*/ 673045 h 1560149"/>
              <a:gd name="connsiteX62" fmla="*/ 1850177 w 2384808"/>
              <a:gd name="connsiteY62" fmla="*/ 591158 h 1560149"/>
              <a:gd name="connsiteX63" fmla="*/ 1822882 w 2384808"/>
              <a:gd name="connsiteY63" fmla="*/ 536567 h 1560149"/>
              <a:gd name="connsiteX64" fmla="*/ 1809234 w 2384808"/>
              <a:gd name="connsiteY64" fmla="*/ 495624 h 1560149"/>
              <a:gd name="connsiteX65" fmla="*/ 1740995 w 2384808"/>
              <a:gd name="connsiteY65" fmla="*/ 413737 h 1560149"/>
              <a:gd name="connsiteX66" fmla="*/ 1727347 w 2384808"/>
              <a:gd name="connsiteY66" fmla="*/ 372794 h 1560149"/>
              <a:gd name="connsiteX67" fmla="*/ 1700052 w 2384808"/>
              <a:gd name="connsiteY67" fmla="*/ 318203 h 1560149"/>
              <a:gd name="connsiteX68" fmla="*/ 1631813 w 2384808"/>
              <a:gd name="connsiteY68" fmla="*/ 236316 h 1560149"/>
              <a:gd name="connsiteX69" fmla="*/ 1590870 w 2384808"/>
              <a:gd name="connsiteY69" fmla="*/ 209021 h 1560149"/>
              <a:gd name="connsiteX70" fmla="*/ 1495335 w 2384808"/>
              <a:gd name="connsiteY70" fmla="*/ 113487 h 1560149"/>
              <a:gd name="connsiteX71" fmla="*/ 635526 w 2384808"/>
              <a:gd name="connsiteY71" fmla="*/ 58896 h 1560149"/>
              <a:gd name="connsiteX72" fmla="*/ 580935 w 2384808"/>
              <a:gd name="connsiteY72" fmla="*/ 45248 h 1560149"/>
              <a:gd name="connsiteX73" fmla="*/ 417162 w 2384808"/>
              <a:gd name="connsiteY73" fmla="*/ 31600 h 1560149"/>
              <a:gd name="connsiteX74" fmla="*/ 75968 w 2384808"/>
              <a:gd name="connsiteY74" fmla="*/ 45248 h 1560149"/>
              <a:gd name="connsiteX75" fmla="*/ 7729 w 2384808"/>
              <a:gd name="connsiteY75" fmla="*/ 72543 h 156014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2384808" h="1560149">
                <a:moveTo>
                  <a:pt x="7729" y="72543"/>
                </a:moveTo>
                <a:cubicBezTo>
                  <a:pt x="-1369" y="97564"/>
                  <a:pt x="21377" y="154178"/>
                  <a:pt x="21377" y="195373"/>
                </a:cubicBezTo>
                <a:cubicBezTo>
                  <a:pt x="21377" y="490872"/>
                  <a:pt x="-26722" y="433512"/>
                  <a:pt x="21377" y="782227"/>
                </a:cubicBezTo>
                <a:cubicBezTo>
                  <a:pt x="24014" y="801347"/>
                  <a:pt x="47493" y="810814"/>
                  <a:pt x="62320" y="823170"/>
                </a:cubicBezTo>
                <a:cubicBezTo>
                  <a:pt x="173432" y="915763"/>
                  <a:pt x="6614" y="758737"/>
                  <a:pt x="185150" y="877761"/>
                </a:cubicBezTo>
                <a:cubicBezTo>
                  <a:pt x="241701" y="915461"/>
                  <a:pt x="210181" y="901079"/>
                  <a:pt x="280685" y="918704"/>
                </a:cubicBezTo>
                <a:cubicBezTo>
                  <a:pt x="294333" y="927803"/>
                  <a:pt x="306639" y="939338"/>
                  <a:pt x="321628" y="946000"/>
                </a:cubicBezTo>
                <a:cubicBezTo>
                  <a:pt x="347920" y="957686"/>
                  <a:pt x="379574" y="957336"/>
                  <a:pt x="403514" y="973296"/>
                </a:cubicBezTo>
                <a:cubicBezTo>
                  <a:pt x="465123" y="1014368"/>
                  <a:pt x="483583" y="1018943"/>
                  <a:pt x="526344" y="1068830"/>
                </a:cubicBezTo>
                <a:cubicBezTo>
                  <a:pt x="541147" y="1086100"/>
                  <a:pt x="553640" y="1105224"/>
                  <a:pt x="567288" y="1123421"/>
                </a:cubicBezTo>
                <a:cubicBezTo>
                  <a:pt x="621879" y="1118872"/>
                  <a:pt x="682064" y="1134271"/>
                  <a:pt x="731061" y="1109773"/>
                </a:cubicBezTo>
                <a:cubicBezTo>
                  <a:pt x="756795" y="1096906"/>
                  <a:pt x="758356" y="1027887"/>
                  <a:pt x="758356" y="1027887"/>
                </a:cubicBezTo>
                <a:cubicBezTo>
                  <a:pt x="753807" y="991493"/>
                  <a:pt x="761111" y="951509"/>
                  <a:pt x="744708" y="918704"/>
                </a:cubicBezTo>
                <a:cubicBezTo>
                  <a:pt x="716084" y="861456"/>
                  <a:pt x="667945" y="827763"/>
                  <a:pt x="608231" y="823170"/>
                </a:cubicBezTo>
                <a:cubicBezTo>
                  <a:pt x="508339" y="815486"/>
                  <a:pt x="408064" y="814071"/>
                  <a:pt x="307980" y="809522"/>
                </a:cubicBezTo>
                <a:cubicBezTo>
                  <a:pt x="285670" y="802086"/>
                  <a:pt x="240020" y="790860"/>
                  <a:pt x="226094" y="768579"/>
                </a:cubicBezTo>
                <a:cubicBezTo>
                  <a:pt x="210845" y="744181"/>
                  <a:pt x="207897" y="713988"/>
                  <a:pt x="198798" y="686693"/>
                </a:cubicBezTo>
                <a:cubicBezTo>
                  <a:pt x="182171" y="586932"/>
                  <a:pt x="173054" y="574819"/>
                  <a:pt x="198798" y="454681"/>
                </a:cubicBezTo>
                <a:cubicBezTo>
                  <a:pt x="202235" y="438642"/>
                  <a:pt x="214495" y="425336"/>
                  <a:pt x="226094" y="413737"/>
                </a:cubicBezTo>
                <a:cubicBezTo>
                  <a:pt x="252549" y="387282"/>
                  <a:pt x="274681" y="383894"/>
                  <a:pt x="307980" y="372794"/>
                </a:cubicBezTo>
                <a:cubicBezTo>
                  <a:pt x="394416" y="377343"/>
                  <a:pt x="481526" y="374747"/>
                  <a:pt x="567288" y="386442"/>
                </a:cubicBezTo>
                <a:cubicBezTo>
                  <a:pt x="583540" y="388658"/>
                  <a:pt x="593560" y="406402"/>
                  <a:pt x="608231" y="413737"/>
                </a:cubicBezTo>
                <a:cubicBezTo>
                  <a:pt x="621098" y="420171"/>
                  <a:pt x="635526" y="422836"/>
                  <a:pt x="649174" y="427385"/>
                </a:cubicBezTo>
                <a:cubicBezTo>
                  <a:pt x="658273" y="441033"/>
                  <a:pt x="663662" y="458081"/>
                  <a:pt x="676470" y="468328"/>
                </a:cubicBezTo>
                <a:cubicBezTo>
                  <a:pt x="687704" y="477315"/>
                  <a:pt x="705443" y="473996"/>
                  <a:pt x="717413" y="481976"/>
                </a:cubicBezTo>
                <a:cubicBezTo>
                  <a:pt x="737712" y="495509"/>
                  <a:pt x="775051" y="540012"/>
                  <a:pt x="785652" y="563863"/>
                </a:cubicBezTo>
                <a:cubicBezTo>
                  <a:pt x="797337" y="590155"/>
                  <a:pt x="803849" y="618454"/>
                  <a:pt x="812947" y="645749"/>
                </a:cubicBezTo>
                <a:lnTo>
                  <a:pt x="826595" y="686693"/>
                </a:lnTo>
                <a:cubicBezTo>
                  <a:pt x="831144" y="700341"/>
                  <a:pt x="832263" y="715666"/>
                  <a:pt x="840243" y="727636"/>
                </a:cubicBezTo>
                <a:cubicBezTo>
                  <a:pt x="858440" y="754931"/>
                  <a:pt x="863713" y="799148"/>
                  <a:pt x="894834" y="809522"/>
                </a:cubicBezTo>
                <a:cubicBezTo>
                  <a:pt x="997755" y="843830"/>
                  <a:pt x="870883" y="797548"/>
                  <a:pt x="976720" y="850466"/>
                </a:cubicBezTo>
                <a:cubicBezTo>
                  <a:pt x="989587" y="856900"/>
                  <a:pt x="1004016" y="859564"/>
                  <a:pt x="1017664" y="864113"/>
                </a:cubicBezTo>
                <a:cubicBezTo>
                  <a:pt x="1111520" y="926684"/>
                  <a:pt x="1068428" y="908330"/>
                  <a:pt x="1140494" y="932352"/>
                </a:cubicBezTo>
                <a:cubicBezTo>
                  <a:pt x="1154142" y="946000"/>
                  <a:pt x="1166202" y="961446"/>
                  <a:pt x="1181437" y="973296"/>
                </a:cubicBezTo>
                <a:cubicBezTo>
                  <a:pt x="1273891" y="1045206"/>
                  <a:pt x="1237925" y="1009475"/>
                  <a:pt x="1317914" y="1055182"/>
                </a:cubicBezTo>
                <a:cubicBezTo>
                  <a:pt x="1391993" y="1097513"/>
                  <a:pt x="1324734" y="1071104"/>
                  <a:pt x="1399801" y="1096125"/>
                </a:cubicBezTo>
                <a:cubicBezTo>
                  <a:pt x="1413449" y="1105224"/>
                  <a:pt x="1428143" y="1112920"/>
                  <a:pt x="1440744" y="1123421"/>
                </a:cubicBezTo>
                <a:cubicBezTo>
                  <a:pt x="1455571" y="1135777"/>
                  <a:pt x="1465629" y="1153658"/>
                  <a:pt x="1481688" y="1164364"/>
                </a:cubicBezTo>
                <a:cubicBezTo>
                  <a:pt x="1493658" y="1172344"/>
                  <a:pt x="1509764" y="1171578"/>
                  <a:pt x="1522631" y="1178012"/>
                </a:cubicBezTo>
                <a:cubicBezTo>
                  <a:pt x="1537302" y="1185347"/>
                  <a:pt x="1548903" y="1197972"/>
                  <a:pt x="1563574" y="1205307"/>
                </a:cubicBezTo>
                <a:cubicBezTo>
                  <a:pt x="1576441" y="1211741"/>
                  <a:pt x="1591941" y="1211969"/>
                  <a:pt x="1604517" y="1218955"/>
                </a:cubicBezTo>
                <a:cubicBezTo>
                  <a:pt x="1633194" y="1234887"/>
                  <a:pt x="1655282" y="1263172"/>
                  <a:pt x="1686404" y="1273546"/>
                </a:cubicBezTo>
                <a:cubicBezTo>
                  <a:pt x="1700052" y="1278095"/>
                  <a:pt x="1714771" y="1280208"/>
                  <a:pt x="1727347" y="1287194"/>
                </a:cubicBezTo>
                <a:cubicBezTo>
                  <a:pt x="1770554" y="1311198"/>
                  <a:pt x="1822932" y="1352059"/>
                  <a:pt x="1863825" y="1382728"/>
                </a:cubicBezTo>
                <a:cubicBezTo>
                  <a:pt x="1913866" y="1457792"/>
                  <a:pt x="1863825" y="1394102"/>
                  <a:pt x="1932064" y="1450967"/>
                </a:cubicBezTo>
                <a:cubicBezTo>
                  <a:pt x="1977339" y="1488696"/>
                  <a:pt x="1963123" y="1493792"/>
                  <a:pt x="2013950" y="1519206"/>
                </a:cubicBezTo>
                <a:cubicBezTo>
                  <a:pt x="2053991" y="1539227"/>
                  <a:pt x="2110909" y="1539316"/>
                  <a:pt x="2150428" y="1546501"/>
                </a:cubicBezTo>
                <a:cubicBezTo>
                  <a:pt x="2168883" y="1549856"/>
                  <a:pt x="2186822" y="1555600"/>
                  <a:pt x="2205019" y="1560149"/>
                </a:cubicBezTo>
                <a:cubicBezTo>
                  <a:pt x="2227765" y="1555600"/>
                  <a:pt x="2251538" y="1554646"/>
                  <a:pt x="2273258" y="1546501"/>
                </a:cubicBezTo>
                <a:cubicBezTo>
                  <a:pt x="2303660" y="1535100"/>
                  <a:pt x="2333903" y="1499504"/>
                  <a:pt x="2355144" y="1478263"/>
                </a:cubicBezTo>
                <a:cubicBezTo>
                  <a:pt x="2380900" y="1400996"/>
                  <a:pt x="2399604" y="1385575"/>
                  <a:pt x="2368792" y="1300842"/>
                </a:cubicBezTo>
                <a:cubicBezTo>
                  <a:pt x="2361019" y="1279465"/>
                  <a:pt x="2343065" y="1263158"/>
                  <a:pt x="2327849" y="1246251"/>
                </a:cubicBezTo>
                <a:cubicBezTo>
                  <a:pt x="2302026" y="1217558"/>
                  <a:pt x="2278081" y="1185777"/>
                  <a:pt x="2245962" y="1164364"/>
                </a:cubicBezTo>
                <a:lnTo>
                  <a:pt x="2164076" y="1109773"/>
                </a:lnTo>
                <a:cubicBezTo>
                  <a:pt x="2154977" y="1096125"/>
                  <a:pt x="2147281" y="1081431"/>
                  <a:pt x="2136780" y="1068830"/>
                </a:cubicBezTo>
                <a:cubicBezTo>
                  <a:pt x="2124424" y="1054003"/>
                  <a:pt x="2106543" y="1043946"/>
                  <a:pt x="2095837" y="1027887"/>
                </a:cubicBezTo>
                <a:cubicBezTo>
                  <a:pt x="2087857" y="1015917"/>
                  <a:pt x="2087856" y="1000166"/>
                  <a:pt x="2082189" y="986943"/>
                </a:cubicBezTo>
                <a:cubicBezTo>
                  <a:pt x="2010418" y="819475"/>
                  <a:pt x="2096123" y="1028456"/>
                  <a:pt x="2027598" y="891409"/>
                </a:cubicBezTo>
                <a:cubicBezTo>
                  <a:pt x="2021164" y="878542"/>
                  <a:pt x="2020936" y="863042"/>
                  <a:pt x="2013950" y="850466"/>
                </a:cubicBezTo>
                <a:cubicBezTo>
                  <a:pt x="1998018" y="821789"/>
                  <a:pt x="1974030" y="797921"/>
                  <a:pt x="1959359" y="768579"/>
                </a:cubicBezTo>
                <a:cubicBezTo>
                  <a:pt x="1950261" y="750382"/>
                  <a:pt x="1940078" y="732688"/>
                  <a:pt x="1932064" y="713988"/>
                </a:cubicBezTo>
                <a:cubicBezTo>
                  <a:pt x="1926397" y="700765"/>
                  <a:pt x="1924850" y="685912"/>
                  <a:pt x="1918416" y="673045"/>
                </a:cubicBezTo>
                <a:cubicBezTo>
                  <a:pt x="1899414" y="635042"/>
                  <a:pt x="1880361" y="621342"/>
                  <a:pt x="1850177" y="591158"/>
                </a:cubicBezTo>
                <a:cubicBezTo>
                  <a:pt x="1841079" y="572961"/>
                  <a:pt x="1830896" y="555267"/>
                  <a:pt x="1822882" y="536567"/>
                </a:cubicBezTo>
                <a:cubicBezTo>
                  <a:pt x="1817215" y="523344"/>
                  <a:pt x="1817214" y="507594"/>
                  <a:pt x="1809234" y="495624"/>
                </a:cubicBezTo>
                <a:cubicBezTo>
                  <a:pt x="1748865" y="405071"/>
                  <a:pt x="1785649" y="503044"/>
                  <a:pt x="1740995" y="413737"/>
                </a:cubicBezTo>
                <a:cubicBezTo>
                  <a:pt x="1734561" y="400870"/>
                  <a:pt x="1733014" y="386017"/>
                  <a:pt x="1727347" y="372794"/>
                </a:cubicBezTo>
                <a:cubicBezTo>
                  <a:pt x="1719333" y="354094"/>
                  <a:pt x="1710146" y="335867"/>
                  <a:pt x="1700052" y="318203"/>
                </a:cubicBezTo>
                <a:cubicBezTo>
                  <a:pt x="1680535" y="284048"/>
                  <a:pt x="1662603" y="261974"/>
                  <a:pt x="1631813" y="236316"/>
                </a:cubicBezTo>
                <a:cubicBezTo>
                  <a:pt x="1619212" y="225815"/>
                  <a:pt x="1604518" y="218119"/>
                  <a:pt x="1590870" y="209021"/>
                </a:cubicBezTo>
                <a:cubicBezTo>
                  <a:pt x="1528299" y="115164"/>
                  <a:pt x="1567401" y="137507"/>
                  <a:pt x="1495335" y="113487"/>
                </a:cubicBezTo>
                <a:cubicBezTo>
                  <a:pt x="1260467" y="-121387"/>
                  <a:pt x="1486308" y="85482"/>
                  <a:pt x="635526" y="58896"/>
                </a:cubicBezTo>
                <a:cubicBezTo>
                  <a:pt x="616778" y="58310"/>
                  <a:pt x="599547" y="47575"/>
                  <a:pt x="580935" y="45248"/>
                </a:cubicBezTo>
                <a:cubicBezTo>
                  <a:pt x="526578" y="38453"/>
                  <a:pt x="471753" y="36149"/>
                  <a:pt x="417162" y="31600"/>
                </a:cubicBezTo>
                <a:cubicBezTo>
                  <a:pt x="303431" y="36149"/>
                  <a:pt x="189501" y="37138"/>
                  <a:pt x="75968" y="45248"/>
                </a:cubicBezTo>
                <a:cubicBezTo>
                  <a:pt x="61619" y="46273"/>
                  <a:pt x="16827" y="47522"/>
                  <a:pt x="7729" y="72543"/>
                </a:cubicBezTo>
                <a:close/>
              </a:path>
            </a:pathLst>
          </a:custGeom>
          <a:noFill/>
          <a:ln w="381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Freeform: Shape 48">
            <a:extLst>
              <a:ext uri="{FF2B5EF4-FFF2-40B4-BE49-F238E27FC236}">
                <a16:creationId xmlns:a16="http://schemas.microsoft.com/office/drawing/2014/main" id="{2187C0C5-C053-4F20-8055-8F817B36CEF2}"/>
              </a:ext>
            </a:extLst>
          </p:cNvPr>
          <p:cNvSpPr/>
          <p:nvPr/>
        </p:nvSpPr>
        <p:spPr>
          <a:xfrm>
            <a:off x="777922" y="2748111"/>
            <a:ext cx="2449324" cy="1737925"/>
          </a:xfrm>
          <a:custGeom>
            <a:avLst/>
            <a:gdLst>
              <a:gd name="connsiteX0" fmla="*/ 0 w 2442950"/>
              <a:gd name="connsiteY0" fmla="*/ 95535 h 1828800"/>
              <a:gd name="connsiteX1" fmla="*/ 13648 w 2442950"/>
              <a:gd name="connsiteY1" fmla="*/ 163773 h 1828800"/>
              <a:gd name="connsiteX2" fmla="*/ 27296 w 2442950"/>
              <a:gd name="connsiteY2" fmla="*/ 272955 h 1828800"/>
              <a:gd name="connsiteX3" fmla="*/ 54591 w 2442950"/>
              <a:gd name="connsiteY3" fmla="*/ 313899 h 1828800"/>
              <a:gd name="connsiteX4" fmla="*/ 68239 w 2442950"/>
              <a:gd name="connsiteY4" fmla="*/ 354842 h 1828800"/>
              <a:gd name="connsiteX5" fmla="*/ 150126 w 2442950"/>
              <a:gd name="connsiteY5" fmla="*/ 409433 h 1828800"/>
              <a:gd name="connsiteX6" fmla="*/ 191069 w 2442950"/>
              <a:gd name="connsiteY6" fmla="*/ 436729 h 1828800"/>
              <a:gd name="connsiteX7" fmla="*/ 272956 w 2442950"/>
              <a:gd name="connsiteY7" fmla="*/ 504967 h 1828800"/>
              <a:gd name="connsiteX8" fmla="*/ 327547 w 2442950"/>
              <a:gd name="connsiteY8" fmla="*/ 586854 h 1828800"/>
              <a:gd name="connsiteX9" fmla="*/ 354842 w 2442950"/>
              <a:gd name="connsiteY9" fmla="*/ 668740 h 1828800"/>
              <a:gd name="connsiteX10" fmla="*/ 382138 w 2442950"/>
              <a:gd name="connsiteY10" fmla="*/ 723332 h 1828800"/>
              <a:gd name="connsiteX11" fmla="*/ 409433 w 2442950"/>
              <a:gd name="connsiteY11" fmla="*/ 805218 h 1828800"/>
              <a:gd name="connsiteX12" fmla="*/ 436729 w 2442950"/>
              <a:gd name="connsiteY12" fmla="*/ 914400 h 1828800"/>
              <a:gd name="connsiteX13" fmla="*/ 464024 w 2442950"/>
              <a:gd name="connsiteY13" fmla="*/ 955343 h 1828800"/>
              <a:gd name="connsiteX14" fmla="*/ 559559 w 2442950"/>
              <a:gd name="connsiteY14" fmla="*/ 1078173 h 1828800"/>
              <a:gd name="connsiteX15" fmla="*/ 696036 w 2442950"/>
              <a:gd name="connsiteY15" fmla="*/ 1132764 h 1828800"/>
              <a:gd name="connsiteX16" fmla="*/ 736979 w 2442950"/>
              <a:gd name="connsiteY16" fmla="*/ 1146412 h 1828800"/>
              <a:gd name="connsiteX17" fmla="*/ 832514 w 2442950"/>
              <a:gd name="connsiteY17" fmla="*/ 1160060 h 1828800"/>
              <a:gd name="connsiteX18" fmla="*/ 873457 w 2442950"/>
              <a:gd name="connsiteY18" fmla="*/ 1173708 h 1828800"/>
              <a:gd name="connsiteX19" fmla="*/ 955344 w 2442950"/>
              <a:gd name="connsiteY19" fmla="*/ 1187355 h 1828800"/>
              <a:gd name="connsiteX20" fmla="*/ 1023582 w 2442950"/>
              <a:gd name="connsiteY20" fmla="*/ 1201003 h 1828800"/>
              <a:gd name="connsiteX21" fmla="*/ 1064526 w 2442950"/>
              <a:gd name="connsiteY21" fmla="*/ 1228299 h 1828800"/>
              <a:gd name="connsiteX22" fmla="*/ 1078174 w 2442950"/>
              <a:gd name="connsiteY22" fmla="*/ 1269242 h 1828800"/>
              <a:gd name="connsiteX23" fmla="*/ 1119117 w 2442950"/>
              <a:gd name="connsiteY23" fmla="*/ 1323833 h 1828800"/>
              <a:gd name="connsiteX24" fmla="*/ 1146412 w 2442950"/>
              <a:gd name="connsiteY24" fmla="*/ 1419367 h 1828800"/>
              <a:gd name="connsiteX25" fmla="*/ 1187356 w 2442950"/>
              <a:gd name="connsiteY25" fmla="*/ 1473958 h 1828800"/>
              <a:gd name="connsiteX26" fmla="*/ 1214651 w 2442950"/>
              <a:gd name="connsiteY26" fmla="*/ 1514902 h 1828800"/>
              <a:gd name="connsiteX27" fmla="*/ 1296538 w 2442950"/>
              <a:gd name="connsiteY27" fmla="*/ 1583140 h 1828800"/>
              <a:gd name="connsiteX28" fmla="*/ 1487606 w 2442950"/>
              <a:gd name="connsiteY28" fmla="*/ 1596788 h 1828800"/>
              <a:gd name="connsiteX29" fmla="*/ 1569493 w 2442950"/>
              <a:gd name="connsiteY29" fmla="*/ 1651379 h 1828800"/>
              <a:gd name="connsiteX30" fmla="*/ 1610436 w 2442950"/>
              <a:gd name="connsiteY30" fmla="*/ 1760561 h 1828800"/>
              <a:gd name="connsiteX31" fmla="*/ 1651379 w 2442950"/>
              <a:gd name="connsiteY31" fmla="*/ 1787857 h 1828800"/>
              <a:gd name="connsiteX32" fmla="*/ 1897039 w 2442950"/>
              <a:gd name="connsiteY32" fmla="*/ 1801505 h 1828800"/>
              <a:gd name="connsiteX33" fmla="*/ 1965278 w 2442950"/>
              <a:gd name="connsiteY33" fmla="*/ 1815152 h 1828800"/>
              <a:gd name="connsiteX34" fmla="*/ 2265529 w 2442950"/>
              <a:gd name="connsiteY34" fmla="*/ 1787857 h 1828800"/>
              <a:gd name="connsiteX35" fmla="*/ 2320120 w 2442950"/>
              <a:gd name="connsiteY35" fmla="*/ 1801505 h 1828800"/>
              <a:gd name="connsiteX36" fmla="*/ 2402006 w 2442950"/>
              <a:gd name="connsiteY36" fmla="*/ 1828800 h 1828800"/>
              <a:gd name="connsiteX37" fmla="*/ 2442950 w 2442950"/>
              <a:gd name="connsiteY37" fmla="*/ 1733266 h 1828800"/>
              <a:gd name="connsiteX38" fmla="*/ 2415654 w 2442950"/>
              <a:gd name="connsiteY38" fmla="*/ 1528549 h 1828800"/>
              <a:gd name="connsiteX39" fmla="*/ 2374711 w 2442950"/>
              <a:gd name="connsiteY39" fmla="*/ 1310185 h 1828800"/>
              <a:gd name="connsiteX40" fmla="*/ 2361063 w 2442950"/>
              <a:gd name="connsiteY40" fmla="*/ 1255594 h 1828800"/>
              <a:gd name="connsiteX41" fmla="*/ 2333768 w 2442950"/>
              <a:gd name="connsiteY41" fmla="*/ 1173708 h 1828800"/>
              <a:gd name="connsiteX42" fmla="*/ 2265529 w 2442950"/>
              <a:gd name="connsiteY42" fmla="*/ 1050878 h 1828800"/>
              <a:gd name="connsiteX43" fmla="*/ 2224585 w 2442950"/>
              <a:gd name="connsiteY43" fmla="*/ 1023582 h 1828800"/>
              <a:gd name="connsiteX44" fmla="*/ 2156347 w 2442950"/>
              <a:gd name="connsiteY44" fmla="*/ 955343 h 1828800"/>
              <a:gd name="connsiteX45" fmla="*/ 2129051 w 2442950"/>
              <a:gd name="connsiteY45" fmla="*/ 914400 h 1828800"/>
              <a:gd name="connsiteX46" fmla="*/ 2060812 w 2442950"/>
              <a:gd name="connsiteY46" fmla="*/ 832514 h 1828800"/>
              <a:gd name="connsiteX47" fmla="*/ 2019869 w 2442950"/>
              <a:gd name="connsiteY47" fmla="*/ 736979 h 1828800"/>
              <a:gd name="connsiteX48" fmla="*/ 1992574 w 2442950"/>
              <a:gd name="connsiteY48" fmla="*/ 655093 h 1828800"/>
              <a:gd name="connsiteX49" fmla="*/ 1978926 w 2442950"/>
              <a:gd name="connsiteY49" fmla="*/ 614149 h 1828800"/>
              <a:gd name="connsiteX50" fmla="*/ 1965278 w 2442950"/>
              <a:gd name="connsiteY50" fmla="*/ 573206 h 1828800"/>
              <a:gd name="connsiteX51" fmla="*/ 1978926 w 2442950"/>
              <a:gd name="connsiteY51" fmla="*/ 409433 h 1828800"/>
              <a:gd name="connsiteX52" fmla="*/ 2033517 w 2442950"/>
              <a:gd name="connsiteY52" fmla="*/ 395785 h 1828800"/>
              <a:gd name="connsiteX53" fmla="*/ 2101756 w 2442950"/>
              <a:gd name="connsiteY53" fmla="*/ 382138 h 1828800"/>
              <a:gd name="connsiteX54" fmla="*/ 2142699 w 2442950"/>
              <a:gd name="connsiteY54" fmla="*/ 368490 h 1828800"/>
              <a:gd name="connsiteX55" fmla="*/ 2197290 w 2442950"/>
              <a:gd name="connsiteY55" fmla="*/ 354842 h 1828800"/>
              <a:gd name="connsiteX56" fmla="*/ 2251881 w 2442950"/>
              <a:gd name="connsiteY56" fmla="*/ 259308 h 1828800"/>
              <a:gd name="connsiteX57" fmla="*/ 2197290 w 2442950"/>
              <a:gd name="connsiteY57" fmla="*/ 150126 h 1828800"/>
              <a:gd name="connsiteX58" fmla="*/ 2156347 w 2442950"/>
              <a:gd name="connsiteY58" fmla="*/ 136478 h 1828800"/>
              <a:gd name="connsiteX59" fmla="*/ 2115403 w 2442950"/>
              <a:gd name="connsiteY59" fmla="*/ 95535 h 1828800"/>
              <a:gd name="connsiteX60" fmla="*/ 2074460 w 2442950"/>
              <a:gd name="connsiteY60" fmla="*/ 81887 h 1828800"/>
              <a:gd name="connsiteX61" fmla="*/ 1351129 w 2442950"/>
              <a:gd name="connsiteY61" fmla="*/ 68239 h 1828800"/>
              <a:gd name="connsiteX62" fmla="*/ 1228299 w 2442950"/>
              <a:gd name="connsiteY62" fmla="*/ 40943 h 1828800"/>
              <a:gd name="connsiteX63" fmla="*/ 1187356 w 2442950"/>
              <a:gd name="connsiteY63" fmla="*/ 27296 h 1828800"/>
              <a:gd name="connsiteX64" fmla="*/ 1091821 w 2442950"/>
              <a:gd name="connsiteY64" fmla="*/ 0 h 1828800"/>
              <a:gd name="connsiteX65" fmla="*/ 423081 w 2442950"/>
              <a:gd name="connsiteY65" fmla="*/ 27296 h 1828800"/>
              <a:gd name="connsiteX66" fmla="*/ 382138 w 2442950"/>
              <a:gd name="connsiteY66" fmla="*/ 40943 h 1828800"/>
              <a:gd name="connsiteX67" fmla="*/ 245660 w 2442950"/>
              <a:gd name="connsiteY67" fmla="*/ 68239 h 1828800"/>
              <a:gd name="connsiteX68" fmla="*/ 163774 w 2442950"/>
              <a:gd name="connsiteY68" fmla="*/ 95535 h 1828800"/>
              <a:gd name="connsiteX69" fmla="*/ 122830 w 2442950"/>
              <a:gd name="connsiteY69" fmla="*/ 109182 h 1828800"/>
              <a:gd name="connsiteX70" fmla="*/ 81887 w 2442950"/>
              <a:gd name="connsiteY70" fmla="*/ 136478 h 1828800"/>
              <a:gd name="connsiteX71" fmla="*/ 40944 w 2442950"/>
              <a:gd name="connsiteY71" fmla="*/ 218364 h 1828800"/>
              <a:gd name="connsiteX72" fmla="*/ 13648 w 2442950"/>
              <a:gd name="connsiteY72" fmla="*/ 259308 h 1828800"/>
              <a:gd name="connsiteX73" fmla="*/ 27296 w 2442950"/>
              <a:gd name="connsiteY73" fmla="*/ 354842 h 1828800"/>
              <a:gd name="connsiteX74" fmla="*/ 40944 w 2442950"/>
              <a:gd name="connsiteY74" fmla="*/ 409433 h 18288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Lst>
            <a:rect l="l" t="t" r="r" b="b"/>
            <a:pathLst>
              <a:path w="2442950" h="1828800">
                <a:moveTo>
                  <a:pt x="0" y="95535"/>
                </a:moveTo>
                <a:cubicBezTo>
                  <a:pt x="4549" y="118281"/>
                  <a:pt x="10121" y="140846"/>
                  <a:pt x="13648" y="163773"/>
                </a:cubicBezTo>
                <a:cubicBezTo>
                  <a:pt x="19225" y="200024"/>
                  <a:pt x="17646" y="237570"/>
                  <a:pt x="27296" y="272955"/>
                </a:cubicBezTo>
                <a:cubicBezTo>
                  <a:pt x="31612" y="288780"/>
                  <a:pt x="47256" y="299228"/>
                  <a:pt x="54591" y="313899"/>
                </a:cubicBezTo>
                <a:cubicBezTo>
                  <a:pt x="61025" y="326766"/>
                  <a:pt x="58067" y="344670"/>
                  <a:pt x="68239" y="354842"/>
                </a:cubicBezTo>
                <a:cubicBezTo>
                  <a:pt x="91436" y="378039"/>
                  <a:pt x="122830" y="391236"/>
                  <a:pt x="150126" y="409433"/>
                </a:cubicBezTo>
                <a:lnTo>
                  <a:pt x="191069" y="436729"/>
                </a:lnTo>
                <a:cubicBezTo>
                  <a:pt x="227462" y="460991"/>
                  <a:pt x="244665" y="468592"/>
                  <a:pt x="272956" y="504967"/>
                </a:cubicBezTo>
                <a:cubicBezTo>
                  <a:pt x="293097" y="530862"/>
                  <a:pt x="327547" y="586854"/>
                  <a:pt x="327547" y="586854"/>
                </a:cubicBezTo>
                <a:cubicBezTo>
                  <a:pt x="336645" y="614149"/>
                  <a:pt x="341975" y="643006"/>
                  <a:pt x="354842" y="668740"/>
                </a:cubicBezTo>
                <a:cubicBezTo>
                  <a:pt x="363941" y="686937"/>
                  <a:pt x="374582" y="704442"/>
                  <a:pt x="382138" y="723332"/>
                </a:cubicBezTo>
                <a:cubicBezTo>
                  <a:pt x="392824" y="750046"/>
                  <a:pt x="403790" y="777005"/>
                  <a:pt x="409433" y="805218"/>
                </a:cubicBezTo>
                <a:cubicBezTo>
                  <a:pt x="414624" y="831175"/>
                  <a:pt x="422740" y="886421"/>
                  <a:pt x="436729" y="914400"/>
                </a:cubicBezTo>
                <a:cubicBezTo>
                  <a:pt x="444064" y="929071"/>
                  <a:pt x="456689" y="940672"/>
                  <a:pt x="464024" y="955343"/>
                </a:cubicBezTo>
                <a:cubicBezTo>
                  <a:pt x="495679" y="1018654"/>
                  <a:pt x="451936" y="1024361"/>
                  <a:pt x="559559" y="1078173"/>
                </a:cubicBezTo>
                <a:cubicBezTo>
                  <a:pt x="639886" y="1118337"/>
                  <a:pt x="594847" y="1099034"/>
                  <a:pt x="696036" y="1132764"/>
                </a:cubicBezTo>
                <a:cubicBezTo>
                  <a:pt x="709684" y="1137313"/>
                  <a:pt x="722738" y="1144378"/>
                  <a:pt x="736979" y="1146412"/>
                </a:cubicBezTo>
                <a:lnTo>
                  <a:pt x="832514" y="1160060"/>
                </a:lnTo>
                <a:cubicBezTo>
                  <a:pt x="846162" y="1164609"/>
                  <a:pt x="859414" y="1170587"/>
                  <a:pt x="873457" y="1173708"/>
                </a:cubicBezTo>
                <a:cubicBezTo>
                  <a:pt x="900470" y="1179711"/>
                  <a:pt x="928118" y="1182405"/>
                  <a:pt x="955344" y="1187355"/>
                </a:cubicBezTo>
                <a:cubicBezTo>
                  <a:pt x="978166" y="1191504"/>
                  <a:pt x="1000836" y="1196454"/>
                  <a:pt x="1023582" y="1201003"/>
                </a:cubicBezTo>
                <a:cubicBezTo>
                  <a:pt x="1037230" y="1210102"/>
                  <a:pt x="1054279" y="1215491"/>
                  <a:pt x="1064526" y="1228299"/>
                </a:cubicBezTo>
                <a:cubicBezTo>
                  <a:pt x="1073513" y="1239532"/>
                  <a:pt x="1071037" y="1256752"/>
                  <a:pt x="1078174" y="1269242"/>
                </a:cubicBezTo>
                <a:cubicBezTo>
                  <a:pt x="1089459" y="1288991"/>
                  <a:pt x="1105469" y="1305636"/>
                  <a:pt x="1119117" y="1323833"/>
                </a:cubicBezTo>
                <a:cubicBezTo>
                  <a:pt x="1122070" y="1335646"/>
                  <a:pt x="1137712" y="1404142"/>
                  <a:pt x="1146412" y="1419367"/>
                </a:cubicBezTo>
                <a:cubicBezTo>
                  <a:pt x="1157697" y="1439116"/>
                  <a:pt x="1174135" y="1455448"/>
                  <a:pt x="1187356" y="1473958"/>
                </a:cubicBezTo>
                <a:cubicBezTo>
                  <a:pt x="1196890" y="1487305"/>
                  <a:pt x="1204150" y="1502301"/>
                  <a:pt x="1214651" y="1514902"/>
                </a:cubicBezTo>
                <a:cubicBezTo>
                  <a:pt x="1224803" y="1527085"/>
                  <a:pt x="1275559" y="1579438"/>
                  <a:pt x="1296538" y="1583140"/>
                </a:cubicBezTo>
                <a:cubicBezTo>
                  <a:pt x="1359418" y="1594236"/>
                  <a:pt x="1423917" y="1592239"/>
                  <a:pt x="1487606" y="1596788"/>
                </a:cubicBezTo>
                <a:cubicBezTo>
                  <a:pt x="1545791" y="1611335"/>
                  <a:pt x="1542564" y="1597522"/>
                  <a:pt x="1569493" y="1651379"/>
                </a:cubicBezTo>
                <a:cubicBezTo>
                  <a:pt x="1591409" y="1695210"/>
                  <a:pt x="1576911" y="1713626"/>
                  <a:pt x="1610436" y="1760561"/>
                </a:cubicBezTo>
                <a:cubicBezTo>
                  <a:pt x="1619970" y="1773908"/>
                  <a:pt x="1635141" y="1785537"/>
                  <a:pt x="1651379" y="1787857"/>
                </a:cubicBezTo>
                <a:cubicBezTo>
                  <a:pt x="1732568" y="1799456"/>
                  <a:pt x="1815152" y="1796956"/>
                  <a:pt x="1897039" y="1801505"/>
                </a:cubicBezTo>
                <a:cubicBezTo>
                  <a:pt x="1919785" y="1806054"/>
                  <a:pt x="1942081" y="1815152"/>
                  <a:pt x="1965278" y="1815152"/>
                </a:cubicBezTo>
                <a:cubicBezTo>
                  <a:pt x="2195742" y="1815152"/>
                  <a:pt x="2149653" y="1826482"/>
                  <a:pt x="2265529" y="1787857"/>
                </a:cubicBezTo>
                <a:cubicBezTo>
                  <a:pt x="2283726" y="1792406"/>
                  <a:pt x="2302154" y="1796115"/>
                  <a:pt x="2320120" y="1801505"/>
                </a:cubicBezTo>
                <a:cubicBezTo>
                  <a:pt x="2347678" y="1809772"/>
                  <a:pt x="2402006" y="1828800"/>
                  <a:pt x="2402006" y="1828800"/>
                </a:cubicBezTo>
                <a:cubicBezTo>
                  <a:pt x="2407336" y="1818141"/>
                  <a:pt x="2442950" y="1753347"/>
                  <a:pt x="2442950" y="1733266"/>
                </a:cubicBezTo>
                <a:cubicBezTo>
                  <a:pt x="2442950" y="1599685"/>
                  <a:pt x="2442727" y="1609768"/>
                  <a:pt x="2415654" y="1528549"/>
                </a:cubicBezTo>
                <a:cubicBezTo>
                  <a:pt x="2388087" y="1252883"/>
                  <a:pt x="2423421" y="1505022"/>
                  <a:pt x="2374711" y="1310185"/>
                </a:cubicBezTo>
                <a:cubicBezTo>
                  <a:pt x="2370162" y="1291988"/>
                  <a:pt x="2366453" y="1273560"/>
                  <a:pt x="2361063" y="1255594"/>
                </a:cubicBezTo>
                <a:cubicBezTo>
                  <a:pt x="2352796" y="1228036"/>
                  <a:pt x="2342866" y="1201003"/>
                  <a:pt x="2333768" y="1173708"/>
                </a:cubicBezTo>
                <a:cubicBezTo>
                  <a:pt x="2319546" y="1131042"/>
                  <a:pt x="2305753" y="1077694"/>
                  <a:pt x="2265529" y="1050878"/>
                </a:cubicBezTo>
                <a:lnTo>
                  <a:pt x="2224585" y="1023582"/>
                </a:lnTo>
                <a:cubicBezTo>
                  <a:pt x="2151801" y="914405"/>
                  <a:pt x="2247328" y="1046324"/>
                  <a:pt x="2156347" y="955343"/>
                </a:cubicBezTo>
                <a:cubicBezTo>
                  <a:pt x="2144749" y="943745"/>
                  <a:pt x="2139552" y="927001"/>
                  <a:pt x="2129051" y="914400"/>
                </a:cubicBezTo>
                <a:cubicBezTo>
                  <a:pt x="2041481" y="809317"/>
                  <a:pt x="2128583" y="934168"/>
                  <a:pt x="2060812" y="832514"/>
                </a:cubicBezTo>
                <a:cubicBezTo>
                  <a:pt x="2016891" y="700740"/>
                  <a:pt x="2087315" y="905593"/>
                  <a:pt x="2019869" y="736979"/>
                </a:cubicBezTo>
                <a:cubicBezTo>
                  <a:pt x="2009183" y="710265"/>
                  <a:pt x="2001672" y="682388"/>
                  <a:pt x="1992574" y="655093"/>
                </a:cubicBezTo>
                <a:lnTo>
                  <a:pt x="1978926" y="614149"/>
                </a:lnTo>
                <a:lnTo>
                  <a:pt x="1965278" y="573206"/>
                </a:lnTo>
                <a:cubicBezTo>
                  <a:pt x="1969827" y="518615"/>
                  <a:pt x="1959261" y="460562"/>
                  <a:pt x="1978926" y="409433"/>
                </a:cubicBezTo>
                <a:cubicBezTo>
                  <a:pt x="1985659" y="391926"/>
                  <a:pt x="2015207" y="399854"/>
                  <a:pt x="2033517" y="395785"/>
                </a:cubicBezTo>
                <a:cubicBezTo>
                  <a:pt x="2056161" y="390753"/>
                  <a:pt x="2079252" y="387764"/>
                  <a:pt x="2101756" y="382138"/>
                </a:cubicBezTo>
                <a:cubicBezTo>
                  <a:pt x="2115712" y="378649"/>
                  <a:pt x="2128867" y="372442"/>
                  <a:pt x="2142699" y="368490"/>
                </a:cubicBezTo>
                <a:cubicBezTo>
                  <a:pt x="2160734" y="363337"/>
                  <a:pt x="2179093" y="359391"/>
                  <a:pt x="2197290" y="354842"/>
                </a:cubicBezTo>
                <a:cubicBezTo>
                  <a:pt x="2209811" y="336060"/>
                  <a:pt x="2249572" y="280085"/>
                  <a:pt x="2251881" y="259308"/>
                </a:cubicBezTo>
                <a:cubicBezTo>
                  <a:pt x="2257319" y="210364"/>
                  <a:pt x="2235606" y="175670"/>
                  <a:pt x="2197290" y="150126"/>
                </a:cubicBezTo>
                <a:cubicBezTo>
                  <a:pt x="2185320" y="142146"/>
                  <a:pt x="2169995" y="141027"/>
                  <a:pt x="2156347" y="136478"/>
                </a:cubicBezTo>
                <a:cubicBezTo>
                  <a:pt x="2142699" y="122830"/>
                  <a:pt x="2131462" y="106241"/>
                  <a:pt x="2115403" y="95535"/>
                </a:cubicBezTo>
                <a:cubicBezTo>
                  <a:pt x="2103433" y="87555"/>
                  <a:pt x="2088837" y="82400"/>
                  <a:pt x="2074460" y="81887"/>
                </a:cubicBezTo>
                <a:cubicBezTo>
                  <a:pt x="1833460" y="73280"/>
                  <a:pt x="1592239" y="72788"/>
                  <a:pt x="1351129" y="68239"/>
                </a:cubicBezTo>
                <a:cubicBezTo>
                  <a:pt x="1258962" y="37517"/>
                  <a:pt x="1372407" y="72967"/>
                  <a:pt x="1228299" y="40943"/>
                </a:cubicBezTo>
                <a:cubicBezTo>
                  <a:pt x="1214256" y="37822"/>
                  <a:pt x="1201135" y="31430"/>
                  <a:pt x="1187356" y="27296"/>
                </a:cubicBezTo>
                <a:cubicBezTo>
                  <a:pt x="1155633" y="17779"/>
                  <a:pt x="1123666" y="9099"/>
                  <a:pt x="1091821" y="0"/>
                </a:cubicBezTo>
                <a:cubicBezTo>
                  <a:pt x="1017449" y="1957"/>
                  <a:pt x="601750" y="1772"/>
                  <a:pt x="423081" y="27296"/>
                </a:cubicBezTo>
                <a:cubicBezTo>
                  <a:pt x="408840" y="29330"/>
                  <a:pt x="395970" y="36991"/>
                  <a:pt x="382138" y="40943"/>
                </a:cubicBezTo>
                <a:cubicBezTo>
                  <a:pt x="325127" y="57232"/>
                  <a:pt x="310013" y="57513"/>
                  <a:pt x="245660" y="68239"/>
                </a:cubicBezTo>
                <a:lnTo>
                  <a:pt x="163774" y="95535"/>
                </a:lnTo>
                <a:lnTo>
                  <a:pt x="122830" y="109182"/>
                </a:lnTo>
                <a:cubicBezTo>
                  <a:pt x="109182" y="118281"/>
                  <a:pt x="93485" y="124880"/>
                  <a:pt x="81887" y="136478"/>
                </a:cubicBezTo>
                <a:cubicBezTo>
                  <a:pt x="42771" y="175594"/>
                  <a:pt x="63145" y="173961"/>
                  <a:pt x="40944" y="218364"/>
                </a:cubicBezTo>
                <a:cubicBezTo>
                  <a:pt x="33608" y="233035"/>
                  <a:pt x="22747" y="245660"/>
                  <a:pt x="13648" y="259308"/>
                </a:cubicBezTo>
                <a:cubicBezTo>
                  <a:pt x="18197" y="291153"/>
                  <a:pt x="20987" y="323299"/>
                  <a:pt x="27296" y="354842"/>
                </a:cubicBezTo>
                <a:cubicBezTo>
                  <a:pt x="42383" y="430274"/>
                  <a:pt x="40944" y="371857"/>
                  <a:pt x="40944" y="409433"/>
                </a:cubicBezTo>
              </a:path>
            </a:pathLst>
          </a:custGeom>
          <a:noFill/>
          <a:ln w="381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Freeform: Shape 49">
            <a:extLst>
              <a:ext uri="{FF2B5EF4-FFF2-40B4-BE49-F238E27FC236}">
                <a16:creationId xmlns:a16="http://schemas.microsoft.com/office/drawing/2014/main" id="{94B9D718-79D6-4E20-BBAA-D397D0AFD734}"/>
              </a:ext>
            </a:extLst>
          </p:cNvPr>
          <p:cNvSpPr/>
          <p:nvPr/>
        </p:nvSpPr>
        <p:spPr>
          <a:xfrm>
            <a:off x="764275" y="4558352"/>
            <a:ext cx="2415653" cy="1719618"/>
          </a:xfrm>
          <a:custGeom>
            <a:avLst/>
            <a:gdLst>
              <a:gd name="connsiteX0" fmla="*/ 0 w 2415653"/>
              <a:gd name="connsiteY0" fmla="*/ 13648 h 1719618"/>
              <a:gd name="connsiteX1" fmla="*/ 13647 w 2415653"/>
              <a:gd name="connsiteY1" fmla="*/ 805218 h 1719618"/>
              <a:gd name="connsiteX2" fmla="*/ 54591 w 2415653"/>
              <a:gd name="connsiteY2" fmla="*/ 982639 h 1719618"/>
              <a:gd name="connsiteX3" fmla="*/ 68238 w 2415653"/>
              <a:gd name="connsiteY3" fmla="*/ 1037230 h 1719618"/>
              <a:gd name="connsiteX4" fmla="*/ 81886 w 2415653"/>
              <a:gd name="connsiteY4" fmla="*/ 1078173 h 1719618"/>
              <a:gd name="connsiteX5" fmla="*/ 122829 w 2415653"/>
              <a:gd name="connsiteY5" fmla="*/ 1119117 h 1719618"/>
              <a:gd name="connsiteX6" fmla="*/ 136477 w 2415653"/>
              <a:gd name="connsiteY6" fmla="*/ 1173708 h 1719618"/>
              <a:gd name="connsiteX7" fmla="*/ 163773 w 2415653"/>
              <a:gd name="connsiteY7" fmla="*/ 1255594 h 1719618"/>
              <a:gd name="connsiteX8" fmla="*/ 177421 w 2415653"/>
              <a:gd name="connsiteY8" fmla="*/ 1323833 h 1719618"/>
              <a:gd name="connsiteX9" fmla="*/ 191068 w 2415653"/>
              <a:gd name="connsiteY9" fmla="*/ 1378424 h 1719618"/>
              <a:gd name="connsiteX10" fmla="*/ 218364 w 2415653"/>
              <a:gd name="connsiteY10" fmla="*/ 1514902 h 1719618"/>
              <a:gd name="connsiteX11" fmla="*/ 245659 w 2415653"/>
              <a:gd name="connsiteY11" fmla="*/ 1555845 h 1719618"/>
              <a:gd name="connsiteX12" fmla="*/ 300250 w 2415653"/>
              <a:gd name="connsiteY12" fmla="*/ 1678675 h 1719618"/>
              <a:gd name="connsiteX13" fmla="*/ 341194 w 2415653"/>
              <a:gd name="connsiteY13" fmla="*/ 1692323 h 1719618"/>
              <a:gd name="connsiteX14" fmla="*/ 382137 w 2415653"/>
              <a:gd name="connsiteY14" fmla="*/ 1719618 h 1719618"/>
              <a:gd name="connsiteX15" fmla="*/ 900752 w 2415653"/>
              <a:gd name="connsiteY15" fmla="*/ 1719618 h 1719618"/>
              <a:gd name="connsiteX16" fmla="*/ 1296537 w 2415653"/>
              <a:gd name="connsiteY16" fmla="*/ 1705970 h 1719618"/>
              <a:gd name="connsiteX17" fmla="*/ 1392071 w 2415653"/>
              <a:gd name="connsiteY17" fmla="*/ 1665027 h 1719618"/>
              <a:gd name="connsiteX18" fmla="*/ 1419367 w 2415653"/>
              <a:gd name="connsiteY18" fmla="*/ 1624084 h 1719618"/>
              <a:gd name="connsiteX19" fmla="*/ 1460310 w 2415653"/>
              <a:gd name="connsiteY19" fmla="*/ 1596788 h 1719618"/>
              <a:gd name="connsiteX20" fmla="*/ 1514901 w 2415653"/>
              <a:gd name="connsiteY20" fmla="*/ 1514902 h 1719618"/>
              <a:gd name="connsiteX21" fmla="*/ 1583140 w 2415653"/>
              <a:gd name="connsiteY21" fmla="*/ 1446663 h 1719618"/>
              <a:gd name="connsiteX22" fmla="*/ 1665026 w 2415653"/>
              <a:gd name="connsiteY22" fmla="*/ 1419367 h 1719618"/>
              <a:gd name="connsiteX23" fmla="*/ 1705970 w 2415653"/>
              <a:gd name="connsiteY23" fmla="*/ 1392072 h 1719618"/>
              <a:gd name="connsiteX24" fmla="*/ 1897038 w 2415653"/>
              <a:gd name="connsiteY24" fmla="*/ 1337481 h 1719618"/>
              <a:gd name="connsiteX25" fmla="*/ 2033516 w 2415653"/>
              <a:gd name="connsiteY25" fmla="*/ 1255594 h 1719618"/>
              <a:gd name="connsiteX26" fmla="*/ 2074459 w 2415653"/>
              <a:gd name="connsiteY26" fmla="*/ 1241947 h 1719618"/>
              <a:gd name="connsiteX27" fmla="*/ 2197289 w 2415653"/>
              <a:gd name="connsiteY27" fmla="*/ 1160060 h 1719618"/>
              <a:gd name="connsiteX28" fmla="*/ 2238232 w 2415653"/>
              <a:gd name="connsiteY28" fmla="*/ 1132764 h 1719618"/>
              <a:gd name="connsiteX29" fmla="*/ 2279176 w 2415653"/>
              <a:gd name="connsiteY29" fmla="*/ 1119117 h 1719618"/>
              <a:gd name="connsiteX30" fmla="*/ 2320119 w 2415653"/>
              <a:gd name="connsiteY30" fmla="*/ 1091821 h 1719618"/>
              <a:gd name="connsiteX31" fmla="*/ 2361062 w 2415653"/>
              <a:gd name="connsiteY31" fmla="*/ 1009935 h 1719618"/>
              <a:gd name="connsiteX32" fmla="*/ 2374710 w 2415653"/>
              <a:gd name="connsiteY32" fmla="*/ 805218 h 1719618"/>
              <a:gd name="connsiteX33" fmla="*/ 2402006 w 2415653"/>
              <a:gd name="connsiteY33" fmla="*/ 627797 h 1719618"/>
              <a:gd name="connsiteX34" fmla="*/ 2415653 w 2415653"/>
              <a:gd name="connsiteY34" fmla="*/ 545911 h 1719618"/>
              <a:gd name="connsiteX35" fmla="*/ 2402006 w 2415653"/>
              <a:gd name="connsiteY35" fmla="*/ 245660 h 1719618"/>
              <a:gd name="connsiteX36" fmla="*/ 2388358 w 2415653"/>
              <a:gd name="connsiteY36" fmla="*/ 191069 h 1719618"/>
              <a:gd name="connsiteX37" fmla="*/ 2306471 w 2415653"/>
              <a:gd name="connsiteY37" fmla="*/ 136478 h 1719618"/>
              <a:gd name="connsiteX38" fmla="*/ 2224585 w 2415653"/>
              <a:gd name="connsiteY38" fmla="*/ 95535 h 1719618"/>
              <a:gd name="connsiteX39" fmla="*/ 2088107 w 2415653"/>
              <a:gd name="connsiteY39" fmla="*/ 54591 h 1719618"/>
              <a:gd name="connsiteX40" fmla="*/ 818865 w 2415653"/>
              <a:gd name="connsiteY40" fmla="*/ 40944 h 1719618"/>
              <a:gd name="connsiteX41" fmla="*/ 614149 w 2415653"/>
              <a:gd name="connsiteY41" fmla="*/ 27296 h 1719618"/>
              <a:gd name="connsiteX42" fmla="*/ 545910 w 2415653"/>
              <a:gd name="connsiteY42" fmla="*/ 13648 h 1719618"/>
              <a:gd name="connsiteX43" fmla="*/ 436728 w 2415653"/>
              <a:gd name="connsiteY43" fmla="*/ 0 h 1719618"/>
              <a:gd name="connsiteX44" fmla="*/ 81886 w 2415653"/>
              <a:gd name="connsiteY44" fmla="*/ 13648 h 1719618"/>
              <a:gd name="connsiteX45" fmla="*/ 27295 w 2415653"/>
              <a:gd name="connsiteY45" fmla="*/ 95535 h 1719618"/>
              <a:gd name="connsiteX46" fmla="*/ 13647 w 2415653"/>
              <a:gd name="connsiteY46" fmla="*/ 150126 h 17196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2415653" h="1719618">
                <a:moveTo>
                  <a:pt x="0" y="13648"/>
                </a:moveTo>
                <a:cubicBezTo>
                  <a:pt x="4549" y="277505"/>
                  <a:pt x="2016" y="541579"/>
                  <a:pt x="13647" y="805218"/>
                </a:cubicBezTo>
                <a:cubicBezTo>
                  <a:pt x="18387" y="912655"/>
                  <a:pt x="34141" y="911062"/>
                  <a:pt x="54591" y="982639"/>
                </a:cubicBezTo>
                <a:cubicBezTo>
                  <a:pt x="59744" y="1000674"/>
                  <a:pt x="63085" y="1019195"/>
                  <a:pt x="68238" y="1037230"/>
                </a:cubicBezTo>
                <a:cubicBezTo>
                  <a:pt x="72190" y="1051062"/>
                  <a:pt x="73906" y="1066203"/>
                  <a:pt x="81886" y="1078173"/>
                </a:cubicBezTo>
                <a:cubicBezTo>
                  <a:pt x="92592" y="1094232"/>
                  <a:pt x="109181" y="1105469"/>
                  <a:pt x="122829" y="1119117"/>
                </a:cubicBezTo>
                <a:cubicBezTo>
                  <a:pt x="127378" y="1137314"/>
                  <a:pt x="131087" y="1155742"/>
                  <a:pt x="136477" y="1173708"/>
                </a:cubicBezTo>
                <a:cubicBezTo>
                  <a:pt x="144745" y="1201266"/>
                  <a:pt x="158130" y="1227381"/>
                  <a:pt x="163773" y="1255594"/>
                </a:cubicBezTo>
                <a:cubicBezTo>
                  <a:pt x="168322" y="1278340"/>
                  <a:pt x="172389" y="1301189"/>
                  <a:pt x="177421" y="1323833"/>
                </a:cubicBezTo>
                <a:cubicBezTo>
                  <a:pt x="181490" y="1342143"/>
                  <a:pt x="187390" y="1360031"/>
                  <a:pt x="191068" y="1378424"/>
                </a:cubicBezTo>
                <a:cubicBezTo>
                  <a:pt x="195302" y="1399592"/>
                  <a:pt x="206476" y="1487163"/>
                  <a:pt x="218364" y="1514902"/>
                </a:cubicBezTo>
                <a:cubicBezTo>
                  <a:pt x="224825" y="1529978"/>
                  <a:pt x="238997" y="1540856"/>
                  <a:pt x="245659" y="1555845"/>
                </a:cubicBezTo>
                <a:cubicBezTo>
                  <a:pt x="258312" y="1584315"/>
                  <a:pt x="268300" y="1653115"/>
                  <a:pt x="300250" y="1678675"/>
                </a:cubicBezTo>
                <a:cubicBezTo>
                  <a:pt x="311484" y="1687662"/>
                  <a:pt x="328327" y="1685889"/>
                  <a:pt x="341194" y="1692323"/>
                </a:cubicBezTo>
                <a:cubicBezTo>
                  <a:pt x="355865" y="1699658"/>
                  <a:pt x="368489" y="1710520"/>
                  <a:pt x="382137" y="1719618"/>
                </a:cubicBezTo>
                <a:cubicBezTo>
                  <a:pt x="815594" y="1688656"/>
                  <a:pt x="281126" y="1719618"/>
                  <a:pt x="900752" y="1719618"/>
                </a:cubicBezTo>
                <a:cubicBezTo>
                  <a:pt x="1032759" y="1719618"/>
                  <a:pt x="1164609" y="1710519"/>
                  <a:pt x="1296537" y="1705970"/>
                </a:cubicBezTo>
                <a:cubicBezTo>
                  <a:pt x="1324983" y="1696488"/>
                  <a:pt x="1369582" y="1683768"/>
                  <a:pt x="1392071" y="1665027"/>
                </a:cubicBezTo>
                <a:cubicBezTo>
                  <a:pt x="1404672" y="1654526"/>
                  <a:pt x="1407769" y="1635682"/>
                  <a:pt x="1419367" y="1624084"/>
                </a:cubicBezTo>
                <a:cubicBezTo>
                  <a:pt x="1430965" y="1612486"/>
                  <a:pt x="1446662" y="1605887"/>
                  <a:pt x="1460310" y="1596788"/>
                </a:cubicBezTo>
                <a:lnTo>
                  <a:pt x="1514901" y="1514902"/>
                </a:lnTo>
                <a:cubicBezTo>
                  <a:pt x="1539803" y="1477549"/>
                  <a:pt x="1540041" y="1465818"/>
                  <a:pt x="1583140" y="1446663"/>
                </a:cubicBezTo>
                <a:cubicBezTo>
                  <a:pt x="1609432" y="1434978"/>
                  <a:pt x="1641086" y="1435326"/>
                  <a:pt x="1665026" y="1419367"/>
                </a:cubicBezTo>
                <a:cubicBezTo>
                  <a:pt x="1678674" y="1410269"/>
                  <a:pt x="1690555" y="1397677"/>
                  <a:pt x="1705970" y="1392072"/>
                </a:cubicBezTo>
                <a:cubicBezTo>
                  <a:pt x="1725984" y="1384794"/>
                  <a:pt x="1869359" y="1355934"/>
                  <a:pt x="1897038" y="1337481"/>
                </a:cubicBezTo>
                <a:cubicBezTo>
                  <a:pt x="1955245" y="1298676"/>
                  <a:pt x="1974767" y="1280772"/>
                  <a:pt x="2033516" y="1255594"/>
                </a:cubicBezTo>
                <a:cubicBezTo>
                  <a:pt x="2046739" y="1249927"/>
                  <a:pt x="2060811" y="1246496"/>
                  <a:pt x="2074459" y="1241947"/>
                </a:cubicBezTo>
                <a:lnTo>
                  <a:pt x="2197289" y="1160060"/>
                </a:lnTo>
                <a:cubicBezTo>
                  <a:pt x="2210937" y="1150961"/>
                  <a:pt x="2222671" y="1137951"/>
                  <a:pt x="2238232" y="1132764"/>
                </a:cubicBezTo>
                <a:lnTo>
                  <a:pt x="2279176" y="1119117"/>
                </a:lnTo>
                <a:cubicBezTo>
                  <a:pt x="2292824" y="1110018"/>
                  <a:pt x="2308521" y="1103419"/>
                  <a:pt x="2320119" y="1091821"/>
                </a:cubicBezTo>
                <a:cubicBezTo>
                  <a:pt x="2346577" y="1065363"/>
                  <a:pt x="2349962" y="1043237"/>
                  <a:pt x="2361062" y="1009935"/>
                </a:cubicBezTo>
                <a:cubicBezTo>
                  <a:pt x="2365611" y="941696"/>
                  <a:pt x="2368785" y="873351"/>
                  <a:pt x="2374710" y="805218"/>
                </a:cubicBezTo>
                <a:cubicBezTo>
                  <a:pt x="2384342" y="694449"/>
                  <a:pt x="2385524" y="718447"/>
                  <a:pt x="2402006" y="627797"/>
                </a:cubicBezTo>
                <a:cubicBezTo>
                  <a:pt x="2406956" y="600572"/>
                  <a:pt x="2411104" y="573206"/>
                  <a:pt x="2415653" y="545911"/>
                </a:cubicBezTo>
                <a:cubicBezTo>
                  <a:pt x="2411104" y="445827"/>
                  <a:pt x="2409690" y="345552"/>
                  <a:pt x="2402006" y="245660"/>
                </a:cubicBezTo>
                <a:cubicBezTo>
                  <a:pt x="2400567" y="226958"/>
                  <a:pt x="2400710" y="205185"/>
                  <a:pt x="2388358" y="191069"/>
                </a:cubicBezTo>
                <a:cubicBezTo>
                  <a:pt x="2366755" y="166381"/>
                  <a:pt x="2333767" y="154675"/>
                  <a:pt x="2306471" y="136478"/>
                </a:cubicBezTo>
                <a:cubicBezTo>
                  <a:pt x="2253556" y="101201"/>
                  <a:pt x="2281091" y="114369"/>
                  <a:pt x="2224585" y="95535"/>
                </a:cubicBezTo>
                <a:cubicBezTo>
                  <a:pt x="2167704" y="57614"/>
                  <a:pt x="2178643" y="56402"/>
                  <a:pt x="2088107" y="54591"/>
                </a:cubicBezTo>
                <a:lnTo>
                  <a:pt x="818865" y="40944"/>
                </a:lnTo>
                <a:cubicBezTo>
                  <a:pt x="750626" y="36395"/>
                  <a:pt x="682200" y="34101"/>
                  <a:pt x="614149" y="27296"/>
                </a:cubicBezTo>
                <a:cubicBezTo>
                  <a:pt x="591067" y="24988"/>
                  <a:pt x="568837" y="17175"/>
                  <a:pt x="545910" y="13648"/>
                </a:cubicBezTo>
                <a:cubicBezTo>
                  <a:pt x="509659" y="8071"/>
                  <a:pt x="473122" y="4549"/>
                  <a:pt x="436728" y="0"/>
                </a:cubicBezTo>
                <a:cubicBezTo>
                  <a:pt x="318447" y="4549"/>
                  <a:pt x="199144" y="-2526"/>
                  <a:pt x="81886" y="13648"/>
                </a:cubicBezTo>
                <a:cubicBezTo>
                  <a:pt x="47818" y="18347"/>
                  <a:pt x="34340" y="70878"/>
                  <a:pt x="27295" y="95535"/>
                </a:cubicBezTo>
                <a:cubicBezTo>
                  <a:pt x="22142" y="113570"/>
                  <a:pt x="13647" y="150126"/>
                  <a:pt x="13647" y="150126"/>
                </a:cubicBezTo>
              </a:path>
            </a:pathLst>
          </a:custGeom>
          <a:noFill/>
          <a:ln w="381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Freeform: Shape 50">
            <a:extLst>
              <a:ext uri="{FF2B5EF4-FFF2-40B4-BE49-F238E27FC236}">
                <a16:creationId xmlns:a16="http://schemas.microsoft.com/office/drawing/2014/main" id="{11CD67E1-1FE4-4EC7-9456-C996C04C5EF2}"/>
              </a:ext>
            </a:extLst>
          </p:cNvPr>
          <p:cNvSpPr/>
          <p:nvPr/>
        </p:nvSpPr>
        <p:spPr>
          <a:xfrm>
            <a:off x="736979" y="6328758"/>
            <a:ext cx="2415653" cy="1751212"/>
          </a:xfrm>
          <a:custGeom>
            <a:avLst/>
            <a:gdLst>
              <a:gd name="connsiteX0" fmla="*/ 81887 w 2524482"/>
              <a:gd name="connsiteY0" fmla="*/ 959147 h 1778013"/>
              <a:gd name="connsiteX1" fmla="*/ 68239 w 2524482"/>
              <a:gd name="connsiteY1" fmla="*/ 1532353 h 1778013"/>
              <a:gd name="connsiteX2" fmla="*/ 81887 w 2524482"/>
              <a:gd name="connsiteY2" fmla="*/ 1696127 h 1778013"/>
              <a:gd name="connsiteX3" fmla="*/ 95534 w 2524482"/>
              <a:gd name="connsiteY3" fmla="*/ 1737070 h 1778013"/>
              <a:gd name="connsiteX4" fmla="*/ 150125 w 2524482"/>
              <a:gd name="connsiteY4" fmla="*/ 1764365 h 1778013"/>
              <a:gd name="connsiteX5" fmla="*/ 191069 w 2524482"/>
              <a:gd name="connsiteY5" fmla="*/ 1737070 h 1778013"/>
              <a:gd name="connsiteX6" fmla="*/ 204717 w 2524482"/>
              <a:gd name="connsiteY6" fmla="*/ 1696127 h 1778013"/>
              <a:gd name="connsiteX7" fmla="*/ 232012 w 2524482"/>
              <a:gd name="connsiteY7" fmla="*/ 1655183 h 1778013"/>
              <a:gd name="connsiteX8" fmla="*/ 259308 w 2524482"/>
              <a:gd name="connsiteY8" fmla="*/ 1546001 h 1778013"/>
              <a:gd name="connsiteX9" fmla="*/ 272955 w 2524482"/>
              <a:gd name="connsiteY9" fmla="*/ 1505058 h 1778013"/>
              <a:gd name="connsiteX10" fmla="*/ 313899 w 2524482"/>
              <a:gd name="connsiteY10" fmla="*/ 1464115 h 1778013"/>
              <a:gd name="connsiteX11" fmla="*/ 341194 w 2524482"/>
              <a:gd name="connsiteY11" fmla="*/ 1423171 h 1778013"/>
              <a:gd name="connsiteX12" fmla="*/ 436728 w 2524482"/>
              <a:gd name="connsiteY12" fmla="*/ 1409524 h 1778013"/>
              <a:gd name="connsiteX13" fmla="*/ 518615 w 2524482"/>
              <a:gd name="connsiteY13" fmla="*/ 1423171 h 1778013"/>
              <a:gd name="connsiteX14" fmla="*/ 600502 w 2524482"/>
              <a:gd name="connsiteY14" fmla="*/ 1491410 h 1778013"/>
              <a:gd name="connsiteX15" fmla="*/ 668740 w 2524482"/>
              <a:gd name="connsiteY15" fmla="*/ 1573297 h 1778013"/>
              <a:gd name="connsiteX16" fmla="*/ 696036 w 2524482"/>
              <a:gd name="connsiteY16" fmla="*/ 1614240 h 1778013"/>
              <a:gd name="connsiteX17" fmla="*/ 777922 w 2524482"/>
              <a:gd name="connsiteY17" fmla="*/ 1682479 h 1778013"/>
              <a:gd name="connsiteX18" fmla="*/ 818866 w 2524482"/>
              <a:gd name="connsiteY18" fmla="*/ 1696127 h 1778013"/>
              <a:gd name="connsiteX19" fmla="*/ 832514 w 2524482"/>
              <a:gd name="connsiteY19" fmla="*/ 1737070 h 1778013"/>
              <a:gd name="connsiteX20" fmla="*/ 1009934 w 2524482"/>
              <a:gd name="connsiteY20" fmla="*/ 1778013 h 1778013"/>
              <a:gd name="connsiteX21" fmla="*/ 1173708 w 2524482"/>
              <a:gd name="connsiteY21" fmla="*/ 1764365 h 1778013"/>
              <a:gd name="connsiteX22" fmla="*/ 1214651 w 2524482"/>
              <a:gd name="connsiteY22" fmla="*/ 1750718 h 1778013"/>
              <a:gd name="connsiteX23" fmla="*/ 1282890 w 2524482"/>
              <a:gd name="connsiteY23" fmla="*/ 1737070 h 1778013"/>
              <a:gd name="connsiteX24" fmla="*/ 1323833 w 2524482"/>
              <a:gd name="connsiteY24" fmla="*/ 1723422 h 1778013"/>
              <a:gd name="connsiteX25" fmla="*/ 1501254 w 2524482"/>
              <a:gd name="connsiteY25" fmla="*/ 1709774 h 1778013"/>
              <a:gd name="connsiteX26" fmla="*/ 2388358 w 2524482"/>
              <a:gd name="connsiteY26" fmla="*/ 1682479 h 1778013"/>
              <a:gd name="connsiteX27" fmla="*/ 2429302 w 2524482"/>
              <a:gd name="connsiteY27" fmla="*/ 1668831 h 1778013"/>
              <a:gd name="connsiteX28" fmla="*/ 2470245 w 2524482"/>
              <a:gd name="connsiteY28" fmla="*/ 1627888 h 1778013"/>
              <a:gd name="connsiteX29" fmla="*/ 2497540 w 2524482"/>
              <a:gd name="connsiteY29" fmla="*/ 1546001 h 1778013"/>
              <a:gd name="connsiteX30" fmla="*/ 2483893 w 2524482"/>
              <a:gd name="connsiteY30" fmla="*/ 863613 h 1778013"/>
              <a:gd name="connsiteX31" fmla="*/ 2210937 w 2524482"/>
              <a:gd name="connsiteY31" fmla="*/ 836318 h 1778013"/>
              <a:gd name="connsiteX32" fmla="*/ 2129051 w 2524482"/>
              <a:gd name="connsiteY32" fmla="*/ 768079 h 1778013"/>
              <a:gd name="connsiteX33" fmla="*/ 2115403 w 2524482"/>
              <a:gd name="connsiteY33" fmla="*/ 713488 h 1778013"/>
              <a:gd name="connsiteX34" fmla="*/ 2210937 w 2524482"/>
              <a:gd name="connsiteY34" fmla="*/ 658897 h 1778013"/>
              <a:gd name="connsiteX35" fmla="*/ 2251881 w 2524482"/>
              <a:gd name="connsiteY35" fmla="*/ 645249 h 1778013"/>
              <a:gd name="connsiteX36" fmla="*/ 2333767 w 2524482"/>
              <a:gd name="connsiteY36" fmla="*/ 577010 h 1778013"/>
              <a:gd name="connsiteX37" fmla="*/ 2361063 w 2524482"/>
              <a:gd name="connsiteY37" fmla="*/ 495124 h 1778013"/>
              <a:gd name="connsiteX38" fmla="*/ 2374711 w 2524482"/>
              <a:gd name="connsiteY38" fmla="*/ 413237 h 1778013"/>
              <a:gd name="connsiteX39" fmla="*/ 2361063 w 2524482"/>
              <a:gd name="connsiteY39" fmla="*/ 194873 h 1778013"/>
              <a:gd name="connsiteX40" fmla="*/ 2347415 w 2524482"/>
              <a:gd name="connsiteY40" fmla="*/ 153930 h 1778013"/>
              <a:gd name="connsiteX41" fmla="*/ 2197290 w 2524482"/>
              <a:gd name="connsiteY41" fmla="*/ 99339 h 1778013"/>
              <a:gd name="connsiteX42" fmla="*/ 2129051 w 2524482"/>
              <a:gd name="connsiteY42" fmla="*/ 85691 h 1778013"/>
              <a:gd name="connsiteX43" fmla="*/ 2074460 w 2524482"/>
              <a:gd name="connsiteY43" fmla="*/ 72043 h 1778013"/>
              <a:gd name="connsiteX44" fmla="*/ 1897039 w 2524482"/>
              <a:gd name="connsiteY44" fmla="*/ 58395 h 1778013"/>
              <a:gd name="connsiteX45" fmla="*/ 1828800 w 2524482"/>
              <a:gd name="connsiteY45" fmla="*/ 44747 h 1778013"/>
              <a:gd name="connsiteX46" fmla="*/ 1214651 w 2524482"/>
              <a:gd name="connsiteY46" fmla="*/ 17452 h 1778013"/>
              <a:gd name="connsiteX47" fmla="*/ 818866 w 2524482"/>
              <a:gd name="connsiteY47" fmla="*/ 72043 h 1778013"/>
              <a:gd name="connsiteX48" fmla="*/ 805218 w 2524482"/>
              <a:gd name="connsiteY48" fmla="*/ 112986 h 1778013"/>
              <a:gd name="connsiteX49" fmla="*/ 832514 w 2524482"/>
              <a:gd name="connsiteY49" fmla="*/ 235816 h 1778013"/>
              <a:gd name="connsiteX50" fmla="*/ 873457 w 2524482"/>
              <a:gd name="connsiteY50" fmla="*/ 276759 h 1778013"/>
              <a:gd name="connsiteX51" fmla="*/ 955343 w 2524482"/>
              <a:gd name="connsiteY51" fmla="*/ 317703 h 1778013"/>
              <a:gd name="connsiteX52" fmla="*/ 1023582 w 2524482"/>
              <a:gd name="connsiteY52" fmla="*/ 331350 h 1778013"/>
              <a:gd name="connsiteX53" fmla="*/ 1555845 w 2524482"/>
              <a:gd name="connsiteY53" fmla="*/ 358646 h 1778013"/>
              <a:gd name="connsiteX54" fmla="*/ 1610436 w 2524482"/>
              <a:gd name="connsiteY54" fmla="*/ 372294 h 1778013"/>
              <a:gd name="connsiteX55" fmla="*/ 1692322 w 2524482"/>
              <a:gd name="connsiteY55" fmla="*/ 399589 h 1778013"/>
              <a:gd name="connsiteX56" fmla="*/ 1774209 w 2524482"/>
              <a:gd name="connsiteY56" fmla="*/ 454180 h 1778013"/>
              <a:gd name="connsiteX57" fmla="*/ 1869743 w 2524482"/>
              <a:gd name="connsiteY57" fmla="*/ 522419 h 1778013"/>
              <a:gd name="connsiteX58" fmla="*/ 1951630 w 2524482"/>
              <a:gd name="connsiteY58" fmla="*/ 604306 h 1778013"/>
              <a:gd name="connsiteX59" fmla="*/ 1978925 w 2524482"/>
              <a:gd name="connsiteY59" fmla="*/ 658897 h 1778013"/>
              <a:gd name="connsiteX60" fmla="*/ 2006221 w 2524482"/>
              <a:gd name="connsiteY60" fmla="*/ 699840 h 1778013"/>
              <a:gd name="connsiteX61" fmla="*/ 2033517 w 2524482"/>
              <a:gd name="connsiteY61" fmla="*/ 781727 h 1778013"/>
              <a:gd name="connsiteX62" fmla="*/ 2060812 w 2524482"/>
              <a:gd name="connsiteY62" fmla="*/ 836318 h 1778013"/>
              <a:gd name="connsiteX63" fmla="*/ 2060812 w 2524482"/>
              <a:gd name="connsiteY63" fmla="*/ 1041034 h 1778013"/>
              <a:gd name="connsiteX64" fmla="*/ 2019869 w 2524482"/>
              <a:gd name="connsiteY64" fmla="*/ 1081977 h 1778013"/>
              <a:gd name="connsiteX65" fmla="*/ 1910687 w 2524482"/>
              <a:gd name="connsiteY65" fmla="*/ 1191159 h 1778013"/>
              <a:gd name="connsiteX66" fmla="*/ 1828800 w 2524482"/>
              <a:gd name="connsiteY66" fmla="*/ 1259398 h 1778013"/>
              <a:gd name="connsiteX67" fmla="*/ 1774209 w 2524482"/>
              <a:gd name="connsiteY67" fmla="*/ 1273046 h 1778013"/>
              <a:gd name="connsiteX68" fmla="*/ 1733266 w 2524482"/>
              <a:gd name="connsiteY68" fmla="*/ 1313989 h 1778013"/>
              <a:gd name="connsiteX69" fmla="*/ 1378424 w 2524482"/>
              <a:gd name="connsiteY69" fmla="*/ 1300342 h 1778013"/>
              <a:gd name="connsiteX70" fmla="*/ 1296537 w 2524482"/>
              <a:gd name="connsiteY70" fmla="*/ 1273046 h 1778013"/>
              <a:gd name="connsiteX71" fmla="*/ 1187355 w 2524482"/>
              <a:gd name="connsiteY71" fmla="*/ 1245750 h 1778013"/>
              <a:gd name="connsiteX72" fmla="*/ 1132764 w 2524482"/>
              <a:gd name="connsiteY72" fmla="*/ 1218455 h 1778013"/>
              <a:gd name="connsiteX73" fmla="*/ 1078173 w 2524482"/>
              <a:gd name="connsiteY73" fmla="*/ 1204807 h 1778013"/>
              <a:gd name="connsiteX74" fmla="*/ 955343 w 2524482"/>
              <a:gd name="connsiteY74" fmla="*/ 1136568 h 1778013"/>
              <a:gd name="connsiteX75" fmla="*/ 914400 w 2524482"/>
              <a:gd name="connsiteY75" fmla="*/ 1095625 h 1778013"/>
              <a:gd name="connsiteX76" fmla="*/ 832514 w 2524482"/>
              <a:gd name="connsiteY76" fmla="*/ 1068330 h 1778013"/>
              <a:gd name="connsiteX77" fmla="*/ 709684 w 2524482"/>
              <a:gd name="connsiteY77" fmla="*/ 1013739 h 1778013"/>
              <a:gd name="connsiteX78" fmla="*/ 668740 w 2524482"/>
              <a:gd name="connsiteY78" fmla="*/ 1000091 h 1778013"/>
              <a:gd name="connsiteX79" fmla="*/ 627797 w 2524482"/>
              <a:gd name="connsiteY79" fmla="*/ 986443 h 1778013"/>
              <a:gd name="connsiteX80" fmla="*/ 532263 w 2524482"/>
              <a:gd name="connsiteY80" fmla="*/ 890909 h 1778013"/>
              <a:gd name="connsiteX81" fmla="*/ 450376 w 2524482"/>
              <a:gd name="connsiteY81" fmla="*/ 849965 h 1778013"/>
              <a:gd name="connsiteX82" fmla="*/ 423081 w 2524482"/>
              <a:gd name="connsiteY82" fmla="*/ 809022 h 1778013"/>
              <a:gd name="connsiteX83" fmla="*/ 382137 w 2524482"/>
              <a:gd name="connsiteY83" fmla="*/ 795374 h 1778013"/>
              <a:gd name="connsiteX84" fmla="*/ 300251 w 2524482"/>
              <a:gd name="connsiteY84" fmla="*/ 754431 h 1778013"/>
              <a:gd name="connsiteX85" fmla="*/ 150125 w 2524482"/>
              <a:gd name="connsiteY85" fmla="*/ 781727 h 1778013"/>
              <a:gd name="connsiteX86" fmla="*/ 109182 w 2524482"/>
              <a:gd name="connsiteY86" fmla="*/ 822670 h 1778013"/>
              <a:gd name="connsiteX87" fmla="*/ 54591 w 2524482"/>
              <a:gd name="connsiteY87" fmla="*/ 863613 h 1778013"/>
              <a:gd name="connsiteX88" fmla="*/ 27296 w 2524482"/>
              <a:gd name="connsiteY88" fmla="*/ 904556 h 1778013"/>
              <a:gd name="connsiteX89" fmla="*/ 0 w 2524482"/>
              <a:gd name="connsiteY89" fmla="*/ 986443 h 1778013"/>
              <a:gd name="connsiteX90" fmla="*/ 13648 w 2524482"/>
              <a:gd name="connsiteY90" fmla="*/ 1300342 h 1778013"/>
              <a:gd name="connsiteX91" fmla="*/ 40943 w 2524482"/>
              <a:gd name="connsiteY91" fmla="*/ 1382228 h 1778013"/>
              <a:gd name="connsiteX92" fmla="*/ 81887 w 2524482"/>
              <a:gd name="connsiteY92" fmla="*/ 1395876 h 177801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2524482" h="1778013">
                <a:moveTo>
                  <a:pt x="81887" y="959147"/>
                </a:moveTo>
                <a:cubicBezTo>
                  <a:pt x="77338" y="1150216"/>
                  <a:pt x="68239" y="1341230"/>
                  <a:pt x="68239" y="1532353"/>
                </a:cubicBezTo>
                <a:cubicBezTo>
                  <a:pt x="68239" y="1587134"/>
                  <a:pt x="74647" y="1641827"/>
                  <a:pt x="81887" y="1696127"/>
                </a:cubicBezTo>
                <a:cubicBezTo>
                  <a:pt x="83788" y="1710387"/>
                  <a:pt x="85362" y="1726898"/>
                  <a:pt x="95534" y="1737070"/>
                </a:cubicBezTo>
                <a:cubicBezTo>
                  <a:pt x="109920" y="1751456"/>
                  <a:pt x="131928" y="1755267"/>
                  <a:pt x="150125" y="1764365"/>
                </a:cubicBezTo>
                <a:cubicBezTo>
                  <a:pt x="163773" y="1755267"/>
                  <a:pt x="180822" y="1749878"/>
                  <a:pt x="191069" y="1737070"/>
                </a:cubicBezTo>
                <a:cubicBezTo>
                  <a:pt x="200056" y="1725837"/>
                  <a:pt x="198283" y="1708994"/>
                  <a:pt x="204717" y="1696127"/>
                </a:cubicBezTo>
                <a:cubicBezTo>
                  <a:pt x="212052" y="1681456"/>
                  <a:pt x="222914" y="1668831"/>
                  <a:pt x="232012" y="1655183"/>
                </a:cubicBezTo>
                <a:cubicBezTo>
                  <a:pt x="241111" y="1618789"/>
                  <a:pt x="247446" y="1581590"/>
                  <a:pt x="259308" y="1546001"/>
                </a:cubicBezTo>
                <a:cubicBezTo>
                  <a:pt x="263857" y="1532353"/>
                  <a:pt x="264975" y="1517028"/>
                  <a:pt x="272955" y="1505058"/>
                </a:cubicBezTo>
                <a:cubicBezTo>
                  <a:pt x="283661" y="1488999"/>
                  <a:pt x="301543" y="1478942"/>
                  <a:pt x="313899" y="1464115"/>
                </a:cubicBezTo>
                <a:cubicBezTo>
                  <a:pt x="324400" y="1451514"/>
                  <a:pt x="326205" y="1429833"/>
                  <a:pt x="341194" y="1423171"/>
                </a:cubicBezTo>
                <a:cubicBezTo>
                  <a:pt x="370589" y="1410106"/>
                  <a:pt x="404883" y="1414073"/>
                  <a:pt x="436728" y="1409524"/>
                </a:cubicBezTo>
                <a:cubicBezTo>
                  <a:pt x="464024" y="1414073"/>
                  <a:pt x="492363" y="1414420"/>
                  <a:pt x="518615" y="1423171"/>
                </a:cubicBezTo>
                <a:cubicBezTo>
                  <a:pt x="547114" y="1432670"/>
                  <a:pt x="581500" y="1472408"/>
                  <a:pt x="600502" y="1491410"/>
                </a:cubicBezTo>
                <a:cubicBezTo>
                  <a:pt x="659057" y="1608522"/>
                  <a:pt x="591581" y="1496138"/>
                  <a:pt x="668740" y="1573297"/>
                </a:cubicBezTo>
                <a:cubicBezTo>
                  <a:pt x="680338" y="1584895"/>
                  <a:pt x="685535" y="1601639"/>
                  <a:pt x="696036" y="1614240"/>
                </a:cubicBezTo>
                <a:cubicBezTo>
                  <a:pt x="717595" y="1640110"/>
                  <a:pt x="747250" y="1667143"/>
                  <a:pt x="777922" y="1682479"/>
                </a:cubicBezTo>
                <a:cubicBezTo>
                  <a:pt x="790789" y="1688913"/>
                  <a:pt x="805218" y="1691578"/>
                  <a:pt x="818866" y="1696127"/>
                </a:cubicBezTo>
                <a:cubicBezTo>
                  <a:pt x="823415" y="1709775"/>
                  <a:pt x="820808" y="1728708"/>
                  <a:pt x="832514" y="1737070"/>
                </a:cubicBezTo>
                <a:cubicBezTo>
                  <a:pt x="869981" y="1763832"/>
                  <a:pt x="969699" y="1772265"/>
                  <a:pt x="1009934" y="1778013"/>
                </a:cubicBezTo>
                <a:cubicBezTo>
                  <a:pt x="1064525" y="1773464"/>
                  <a:pt x="1119408" y="1771605"/>
                  <a:pt x="1173708" y="1764365"/>
                </a:cubicBezTo>
                <a:cubicBezTo>
                  <a:pt x="1187968" y="1762464"/>
                  <a:pt x="1200695" y="1754207"/>
                  <a:pt x="1214651" y="1750718"/>
                </a:cubicBezTo>
                <a:cubicBezTo>
                  <a:pt x="1237155" y="1745092"/>
                  <a:pt x="1260386" y="1742696"/>
                  <a:pt x="1282890" y="1737070"/>
                </a:cubicBezTo>
                <a:cubicBezTo>
                  <a:pt x="1296846" y="1733581"/>
                  <a:pt x="1309558" y="1725206"/>
                  <a:pt x="1323833" y="1723422"/>
                </a:cubicBezTo>
                <a:cubicBezTo>
                  <a:pt x="1382690" y="1716065"/>
                  <a:pt x="1442114" y="1714323"/>
                  <a:pt x="1501254" y="1709774"/>
                </a:cubicBezTo>
                <a:cubicBezTo>
                  <a:pt x="1811936" y="1606218"/>
                  <a:pt x="1486171" y="1710239"/>
                  <a:pt x="2388358" y="1682479"/>
                </a:cubicBezTo>
                <a:cubicBezTo>
                  <a:pt x="2402737" y="1682037"/>
                  <a:pt x="2415654" y="1673380"/>
                  <a:pt x="2429302" y="1668831"/>
                </a:cubicBezTo>
                <a:cubicBezTo>
                  <a:pt x="2442950" y="1655183"/>
                  <a:pt x="2460872" y="1644760"/>
                  <a:pt x="2470245" y="1627888"/>
                </a:cubicBezTo>
                <a:cubicBezTo>
                  <a:pt x="2484218" y="1602737"/>
                  <a:pt x="2497540" y="1546001"/>
                  <a:pt x="2497540" y="1546001"/>
                </a:cubicBezTo>
                <a:cubicBezTo>
                  <a:pt x="2492991" y="1318538"/>
                  <a:pt x="2569086" y="1074568"/>
                  <a:pt x="2483893" y="863613"/>
                </a:cubicBezTo>
                <a:cubicBezTo>
                  <a:pt x="2449652" y="778827"/>
                  <a:pt x="2301024" y="851985"/>
                  <a:pt x="2210937" y="836318"/>
                </a:cubicBezTo>
                <a:cubicBezTo>
                  <a:pt x="2187937" y="832318"/>
                  <a:pt x="2141582" y="780610"/>
                  <a:pt x="2129051" y="768079"/>
                </a:cubicBezTo>
                <a:cubicBezTo>
                  <a:pt x="2124502" y="749882"/>
                  <a:pt x="2112750" y="732057"/>
                  <a:pt x="2115403" y="713488"/>
                </a:cubicBezTo>
                <a:cubicBezTo>
                  <a:pt x="2123282" y="658333"/>
                  <a:pt x="2172269" y="668564"/>
                  <a:pt x="2210937" y="658897"/>
                </a:cubicBezTo>
                <a:cubicBezTo>
                  <a:pt x="2224894" y="655408"/>
                  <a:pt x="2238233" y="649798"/>
                  <a:pt x="2251881" y="645249"/>
                </a:cubicBezTo>
                <a:cubicBezTo>
                  <a:pt x="2277364" y="628260"/>
                  <a:pt x="2318314" y="604825"/>
                  <a:pt x="2333767" y="577010"/>
                </a:cubicBezTo>
                <a:cubicBezTo>
                  <a:pt x="2347740" y="551859"/>
                  <a:pt x="2361063" y="495124"/>
                  <a:pt x="2361063" y="495124"/>
                </a:cubicBezTo>
                <a:cubicBezTo>
                  <a:pt x="2365612" y="467828"/>
                  <a:pt x="2374711" y="440909"/>
                  <a:pt x="2374711" y="413237"/>
                </a:cubicBezTo>
                <a:cubicBezTo>
                  <a:pt x="2374711" y="340307"/>
                  <a:pt x="2368698" y="267402"/>
                  <a:pt x="2361063" y="194873"/>
                </a:cubicBezTo>
                <a:cubicBezTo>
                  <a:pt x="2359557" y="180566"/>
                  <a:pt x="2355395" y="165900"/>
                  <a:pt x="2347415" y="153930"/>
                </a:cubicBezTo>
                <a:cubicBezTo>
                  <a:pt x="2303929" y="88701"/>
                  <a:pt x="2281173" y="112244"/>
                  <a:pt x="2197290" y="99339"/>
                </a:cubicBezTo>
                <a:cubicBezTo>
                  <a:pt x="2174363" y="95812"/>
                  <a:pt x="2151695" y="90723"/>
                  <a:pt x="2129051" y="85691"/>
                </a:cubicBezTo>
                <a:cubicBezTo>
                  <a:pt x="2110741" y="81622"/>
                  <a:pt x="2093089" y="74235"/>
                  <a:pt x="2074460" y="72043"/>
                </a:cubicBezTo>
                <a:cubicBezTo>
                  <a:pt x="2015551" y="65112"/>
                  <a:pt x="1956179" y="62944"/>
                  <a:pt x="1897039" y="58395"/>
                </a:cubicBezTo>
                <a:cubicBezTo>
                  <a:pt x="1874293" y="53846"/>
                  <a:pt x="1851727" y="48274"/>
                  <a:pt x="1828800" y="44747"/>
                </a:cubicBezTo>
                <a:cubicBezTo>
                  <a:pt x="1615384" y="11914"/>
                  <a:pt x="1467743" y="24292"/>
                  <a:pt x="1214651" y="17452"/>
                </a:cubicBezTo>
                <a:cubicBezTo>
                  <a:pt x="1102028" y="21784"/>
                  <a:pt x="900868" y="-50959"/>
                  <a:pt x="818866" y="72043"/>
                </a:cubicBezTo>
                <a:cubicBezTo>
                  <a:pt x="810886" y="84013"/>
                  <a:pt x="809767" y="99338"/>
                  <a:pt x="805218" y="112986"/>
                </a:cubicBezTo>
                <a:cubicBezTo>
                  <a:pt x="814317" y="153929"/>
                  <a:pt x="816382" y="197100"/>
                  <a:pt x="832514" y="235816"/>
                </a:cubicBezTo>
                <a:cubicBezTo>
                  <a:pt x="839937" y="253632"/>
                  <a:pt x="858630" y="264403"/>
                  <a:pt x="873457" y="276759"/>
                </a:cubicBezTo>
                <a:cubicBezTo>
                  <a:pt x="902048" y="300585"/>
                  <a:pt x="920171" y="308910"/>
                  <a:pt x="955343" y="317703"/>
                </a:cubicBezTo>
                <a:cubicBezTo>
                  <a:pt x="977847" y="323329"/>
                  <a:pt x="1000439" y="329772"/>
                  <a:pt x="1023582" y="331350"/>
                </a:cubicBezTo>
                <a:cubicBezTo>
                  <a:pt x="1200825" y="343435"/>
                  <a:pt x="1378424" y="349547"/>
                  <a:pt x="1555845" y="358646"/>
                </a:cubicBezTo>
                <a:cubicBezTo>
                  <a:pt x="1574042" y="363195"/>
                  <a:pt x="1592470" y="366904"/>
                  <a:pt x="1610436" y="372294"/>
                </a:cubicBezTo>
                <a:cubicBezTo>
                  <a:pt x="1637994" y="380561"/>
                  <a:pt x="1692322" y="399589"/>
                  <a:pt x="1692322" y="399589"/>
                </a:cubicBezTo>
                <a:lnTo>
                  <a:pt x="1774209" y="454180"/>
                </a:lnTo>
                <a:cubicBezTo>
                  <a:pt x="1802683" y="473163"/>
                  <a:pt x="1845566" y="500660"/>
                  <a:pt x="1869743" y="522419"/>
                </a:cubicBezTo>
                <a:cubicBezTo>
                  <a:pt x="1898436" y="548242"/>
                  <a:pt x="1934367" y="569779"/>
                  <a:pt x="1951630" y="604306"/>
                </a:cubicBezTo>
                <a:cubicBezTo>
                  <a:pt x="1960728" y="622503"/>
                  <a:pt x="1968831" y="641233"/>
                  <a:pt x="1978925" y="658897"/>
                </a:cubicBezTo>
                <a:cubicBezTo>
                  <a:pt x="1987063" y="673138"/>
                  <a:pt x="1999559" y="684851"/>
                  <a:pt x="2006221" y="699840"/>
                </a:cubicBezTo>
                <a:cubicBezTo>
                  <a:pt x="2017907" y="726132"/>
                  <a:pt x="2020650" y="755992"/>
                  <a:pt x="2033517" y="781727"/>
                </a:cubicBezTo>
                <a:lnTo>
                  <a:pt x="2060812" y="836318"/>
                </a:lnTo>
                <a:cubicBezTo>
                  <a:pt x="2073752" y="913959"/>
                  <a:pt x="2088652" y="957515"/>
                  <a:pt x="2060812" y="1041034"/>
                </a:cubicBezTo>
                <a:cubicBezTo>
                  <a:pt x="2054709" y="1059344"/>
                  <a:pt x="2031718" y="1066742"/>
                  <a:pt x="2019869" y="1081977"/>
                </a:cubicBezTo>
                <a:cubicBezTo>
                  <a:pt x="1936027" y="1189775"/>
                  <a:pt x="2005762" y="1143622"/>
                  <a:pt x="1910687" y="1191159"/>
                </a:cubicBezTo>
                <a:cubicBezTo>
                  <a:pt x="1886093" y="1215753"/>
                  <a:pt x="1862052" y="1245147"/>
                  <a:pt x="1828800" y="1259398"/>
                </a:cubicBezTo>
                <a:cubicBezTo>
                  <a:pt x="1811560" y="1266787"/>
                  <a:pt x="1792406" y="1268497"/>
                  <a:pt x="1774209" y="1273046"/>
                </a:cubicBezTo>
                <a:cubicBezTo>
                  <a:pt x="1760561" y="1286694"/>
                  <a:pt x="1752521" y="1312661"/>
                  <a:pt x="1733266" y="1313989"/>
                </a:cubicBezTo>
                <a:cubicBezTo>
                  <a:pt x="1615178" y="1322133"/>
                  <a:pt x="1496275" y="1311390"/>
                  <a:pt x="1378424" y="1300342"/>
                </a:cubicBezTo>
                <a:cubicBezTo>
                  <a:pt x="1349777" y="1297656"/>
                  <a:pt x="1323833" y="1282145"/>
                  <a:pt x="1296537" y="1273046"/>
                </a:cubicBezTo>
                <a:cubicBezTo>
                  <a:pt x="1233586" y="1252062"/>
                  <a:pt x="1269703" y="1262220"/>
                  <a:pt x="1187355" y="1245750"/>
                </a:cubicBezTo>
                <a:cubicBezTo>
                  <a:pt x="1169158" y="1236652"/>
                  <a:pt x="1151813" y="1225598"/>
                  <a:pt x="1132764" y="1218455"/>
                </a:cubicBezTo>
                <a:cubicBezTo>
                  <a:pt x="1115201" y="1211869"/>
                  <a:pt x="1094950" y="1213195"/>
                  <a:pt x="1078173" y="1204807"/>
                </a:cubicBezTo>
                <a:cubicBezTo>
                  <a:pt x="890463" y="1110951"/>
                  <a:pt x="1068567" y="1174309"/>
                  <a:pt x="955343" y="1136568"/>
                </a:cubicBezTo>
                <a:cubicBezTo>
                  <a:pt x="941695" y="1122920"/>
                  <a:pt x="931272" y="1104998"/>
                  <a:pt x="914400" y="1095625"/>
                </a:cubicBezTo>
                <a:cubicBezTo>
                  <a:pt x="889249" y="1081652"/>
                  <a:pt x="832514" y="1068330"/>
                  <a:pt x="832514" y="1068330"/>
                </a:cubicBezTo>
                <a:cubicBezTo>
                  <a:pt x="767630" y="1025074"/>
                  <a:pt x="807132" y="1046221"/>
                  <a:pt x="709684" y="1013739"/>
                </a:cubicBezTo>
                <a:lnTo>
                  <a:pt x="668740" y="1000091"/>
                </a:lnTo>
                <a:lnTo>
                  <a:pt x="627797" y="986443"/>
                </a:lnTo>
                <a:cubicBezTo>
                  <a:pt x="595952" y="954598"/>
                  <a:pt x="574987" y="905151"/>
                  <a:pt x="532263" y="890909"/>
                </a:cubicBezTo>
                <a:cubicBezTo>
                  <a:pt x="475759" y="872074"/>
                  <a:pt x="503290" y="885241"/>
                  <a:pt x="450376" y="849965"/>
                </a:cubicBezTo>
                <a:cubicBezTo>
                  <a:pt x="441278" y="836317"/>
                  <a:pt x="435889" y="819268"/>
                  <a:pt x="423081" y="809022"/>
                </a:cubicBezTo>
                <a:cubicBezTo>
                  <a:pt x="411847" y="800035"/>
                  <a:pt x="395004" y="801808"/>
                  <a:pt x="382137" y="795374"/>
                </a:cubicBezTo>
                <a:cubicBezTo>
                  <a:pt x="276307" y="742460"/>
                  <a:pt x="403166" y="788737"/>
                  <a:pt x="300251" y="754431"/>
                </a:cubicBezTo>
                <a:cubicBezTo>
                  <a:pt x="295621" y="755010"/>
                  <a:pt x="179255" y="762307"/>
                  <a:pt x="150125" y="781727"/>
                </a:cubicBezTo>
                <a:cubicBezTo>
                  <a:pt x="134066" y="792433"/>
                  <a:pt x="123836" y="810109"/>
                  <a:pt x="109182" y="822670"/>
                </a:cubicBezTo>
                <a:cubicBezTo>
                  <a:pt x="91912" y="837473"/>
                  <a:pt x="72788" y="849965"/>
                  <a:pt x="54591" y="863613"/>
                </a:cubicBezTo>
                <a:cubicBezTo>
                  <a:pt x="45493" y="877261"/>
                  <a:pt x="33958" y="889567"/>
                  <a:pt x="27296" y="904556"/>
                </a:cubicBezTo>
                <a:cubicBezTo>
                  <a:pt x="15611" y="930848"/>
                  <a:pt x="0" y="986443"/>
                  <a:pt x="0" y="986443"/>
                </a:cubicBezTo>
                <a:cubicBezTo>
                  <a:pt x="4549" y="1091076"/>
                  <a:pt x="2871" y="1196166"/>
                  <a:pt x="13648" y="1300342"/>
                </a:cubicBezTo>
                <a:cubicBezTo>
                  <a:pt x="16609" y="1328961"/>
                  <a:pt x="17003" y="1366268"/>
                  <a:pt x="40943" y="1382228"/>
                </a:cubicBezTo>
                <a:cubicBezTo>
                  <a:pt x="85672" y="1412048"/>
                  <a:pt x="81887" y="1425927"/>
                  <a:pt x="81887" y="1395876"/>
                </a:cubicBezTo>
              </a:path>
            </a:pathLst>
          </a:custGeom>
          <a:noFill/>
          <a:ln w="381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457459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3084452239"/>
              </p:ext>
            </p:extLst>
          </p:nvPr>
        </p:nvGraphicFramePr>
        <p:xfrm>
          <a:off x="198441" y="10536238"/>
          <a:ext cx="3146425" cy="2843212"/>
        </p:xfrm>
        <a:graphic>
          <a:graphicData uri="http://schemas.openxmlformats.org/presentationml/2006/ole">
            <mc:AlternateContent xmlns:mc="http://schemas.openxmlformats.org/markup-compatibility/2006">
              <mc:Choice xmlns:v="urn:schemas-microsoft-com:vml" Requires="v">
                <p:oleObj spid="_x0000_s5354" name="Prism 7" r:id="rId3" imgW="3480712" imgH="3147026" progId="Prism7.Document">
                  <p:embed/>
                </p:oleObj>
              </mc:Choice>
              <mc:Fallback>
                <p:oleObj name="Prism 7" r:id="rId3" imgW="3480712" imgH="3147026" progId="Prism7.Document">
                  <p:embed/>
                  <p:pic>
                    <p:nvPicPr>
                      <p:cNvPr id="21" name="Object 20"/>
                      <p:cNvPicPr/>
                      <p:nvPr/>
                    </p:nvPicPr>
                    <p:blipFill>
                      <a:blip r:embed="rId4"/>
                      <a:stretch>
                        <a:fillRect/>
                      </a:stretch>
                    </p:blipFill>
                    <p:spPr>
                      <a:xfrm>
                        <a:off x="198441" y="10536238"/>
                        <a:ext cx="3146425" cy="2843212"/>
                      </a:xfrm>
                      <a:prstGeom prst="rect">
                        <a:avLst/>
                      </a:prstGeom>
                    </p:spPr>
                  </p:pic>
                </p:oleObj>
              </mc:Fallback>
            </mc:AlternateContent>
          </a:graphicData>
        </a:graphic>
      </p:graphicFrame>
      <p:pic>
        <p:nvPicPr>
          <p:cNvPr id="3" name="Picture 2"/>
          <p:cNvPicPr>
            <a:picLocks noChangeAspect="1"/>
          </p:cNvPicPr>
          <p:nvPr/>
        </p:nvPicPr>
        <p:blipFill rotWithShape="1">
          <a:blip r:embed="rId5" cstate="print">
            <a:extLst>
              <a:ext uri="{28A0092B-C50C-407E-A947-70E740481C1C}">
                <a14:useLocalDpi xmlns:a14="http://schemas.microsoft.com/office/drawing/2010/main" val="0"/>
              </a:ext>
            </a:extLst>
          </a:blip>
          <a:srcRect l="17292" t="29454" r="32029" b="52771"/>
          <a:stretch/>
        </p:blipFill>
        <p:spPr>
          <a:xfrm>
            <a:off x="7568602" y="9484340"/>
            <a:ext cx="2085374" cy="975204"/>
          </a:xfrm>
          <a:prstGeom prst="rect">
            <a:avLst/>
          </a:prstGeom>
        </p:spPr>
      </p:pic>
      <p:pic>
        <p:nvPicPr>
          <p:cNvPr id="4" name="Picture 3"/>
          <p:cNvPicPr>
            <a:picLocks noChangeAspect="1"/>
          </p:cNvPicPr>
          <p:nvPr/>
        </p:nvPicPr>
        <p:blipFill rotWithShape="1">
          <a:blip r:embed="rId6" cstate="print">
            <a:extLst>
              <a:ext uri="{28A0092B-C50C-407E-A947-70E740481C1C}">
                <a14:useLocalDpi xmlns:a14="http://schemas.microsoft.com/office/drawing/2010/main" val="0"/>
              </a:ext>
            </a:extLst>
          </a:blip>
          <a:srcRect l="11482" t="23717" r="26348" b="55086"/>
          <a:stretch/>
        </p:blipFill>
        <p:spPr>
          <a:xfrm>
            <a:off x="416895" y="9496202"/>
            <a:ext cx="2183819" cy="992778"/>
          </a:xfrm>
          <a:prstGeom prst="rect">
            <a:avLst/>
          </a:prstGeom>
        </p:spPr>
      </p:pic>
      <p:pic>
        <p:nvPicPr>
          <p:cNvPr id="5" name="Picture 4"/>
          <p:cNvPicPr>
            <a:picLocks noChangeAspect="1"/>
          </p:cNvPicPr>
          <p:nvPr/>
        </p:nvPicPr>
        <p:blipFill rotWithShape="1">
          <a:blip r:embed="rId7" cstate="print">
            <a:extLst>
              <a:ext uri="{28A0092B-C50C-407E-A947-70E740481C1C}">
                <a14:useLocalDpi xmlns:a14="http://schemas.microsoft.com/office/drawing/2010/main" val="0"/>
              </a:ext>
            </a:extLst>
          </a:blip>
          <a:srcRect l="21613" t="32655" r="60677" b="14910"/>
          <a:stretch/>
        </p:blipFill>
        <p:spPr>
          <a:xfrm rot="5400000">
            <a:off x="5758943" y="8896881"/>
            <a:ext cx="971550" cy="2157590"/>
          </a:xfrm>
          <a:prstGeom prst="rect">
            <a:avLst/>
          </a:prstGeom>
        </p:spPr>
      </p:pic>
      <p:pic>
        <p:nvPicPr>
          <p:cNvPr id="6" name="Picture 5"/>
          <p:cNvPicPr>
            <a:picLocks noChangeAspect="1"/>
          </p:cNvPicPr>
          <p:nvPr/>
        </p:nvPicPr>
        <p:blipFill rotWithShape="1">
          <a:blip r:embed="rId8" cstate="print">
            <a:extLst>
              <a:ext uri="{28A0092B-C50C-407E-A947-70E740481C1C}">
                <a14:useLocalDpi xmlns:a14="http://schemas.microsoft.com/office/drawing/2010/main" val="0"/>
              </a:ext>
            </a:extLst>
          </a:blip>
          <a:srcRect l="11143" t="17469" r="32985" b="62410"/>
          <a:stretch/>
        </p:blipFill>
        <p:spPr>
          <a:xfrm>
            <a:off x="2862177" y="9492861"/>
            <a:ext cx="2029173" cy="974302"/>
          </a:xfrm>
          <a:prstGeom prst="rect">
            <a:avLst/>
          </a:prstGeom>
        </p:spPr>
      </p:pic>
      <p:sp>
        <p:nvSpPr>
          <p:cNvPr id="7" name="TextBox 6">
            <a:extLst>
              <a:ext uri="{FF2B5EF4-FFF2-40B4-BE49-F238E27FC236}">
                <a16:creationId xmlns:a16="http://schemas.microsoft.com/office/drawing/2014/main" id="{11853775-673C-48E6-882E-404FEB83CDAF}"/>
              </a:ext>
            </a:extLst>
          </p:cNvPr>
          <p:cNvSpPr txBox="1"/>
          <p:nvPr/>
        </p:nvSpPr>
        <p:spPr>
          <a:xfrm>
            <a:off x="-61300" y="9355096"/>
            <a:ext cx="480131" cy="1158439"/>
          </a:xfrm>
          <a:prstGeom prst="rect">
            <a:avLst/>
          </a:prstGeom>
          <a:noFill/>
        </p:spPr>
        <p:txBody>
          <a:bodyPr vert="vert270" wrap="square" rtlCol="0">
            <a:spAutoFit/>
          </a:bodyPr>
          <a:lstStyle/>
          <a:p>
            <a:pPr algn="ctr"/>
            <a:r>
              <a:rPr lang="en-US" sz="1920" dirty="0"/>
              <a:t>Spleen</a:t>
            </a:r>
          </a:p>
        </p:txBody>
      </p:sp>
      <p:graphicFrame>
        <p:nvGraphicFramePr>
          <p:cNvPr id="8" name="Object 7"/>
          <p:cNvGraphicFramePr>
            <a:graphicFrameLocks noChangeAspect="1"/>
          </p:cNvGraphicFramePr>
          <p:nvPr>
            <p:extLst>
              <p:ext uri="{D42A27DB-BD31-4B8C-83A1-F6EECF244321}">
                <p14:modId xmlns:p14="http://schemas.microsoft.com/office/powerpoint/2010/main" val="2710835553"/>
              </p:ext>
            </p:extLst>
          </p:nvPr>
        </p:nvGraphicFramePr>
        <p:xfrm>
          <a:off x="3221038" y="10590579"/>
          <a:ext cx="2906712" cy="2740025"/>
        </p:xfrm>
        <a:graphic>
          <a:graphicData uri="http://schemas.openxmlformats.org/presentationml/2006/ole">
            <mc:AlternateContent xmlns:mc="http://schemas.openxmlformats.org/markup-compatibility/2006">
              <mc:Choice xmlns:v="urn:schemas-microsoft-com:vml" Requires="v">
                <p:oleObj spid="_x0000_s5355" name="Prism 7" r:id="rId9" imgW="3485033" imgH="3284245" progId="Prism7.Document">
                  <p:embed/>
                </p:oleObj>
              </mc:Choice>
              <mc:Fallback>
                <p:oleObj name="Prism 7" r:id="rId9" imgW="3485033" imgH="3284245" progId="Prism7.Document">
                  <p:embed/>
                  <p:pic>
                    <p:nvPicPr>
                      <p:cNvPr id="27" name="Object 26"/>
                      <p:cNvPicPr/>
                      <p:nvPr/>
                    </p:nvPicPr>
                    <p:blipFill>
                      <a:blip r:embed="rId10"/>
                      <a:stretch>
                        <a:fillRect/>
                      </a:stretch>
                    </p:blipFill>
                    <p:spPr>
                      <a:xfrm>
                        <a:off x="3221038" y="10590579"/>
                        <a:ext cx="2906712" cy="2740025"/>
                      </a:xfrm>
                      <a:prstGeom prst="rect">
                        <a:avLst/>
                      </a:prstGeom>
                    </p:spPr>
                  </p:pic>
                </p:oleObj>
              </mc:Fallback>
            </mc:AlternateContent>
          </a:graphicData>
        </a:graphic>
      </p:graphicFrame>
      <p:sp>
        <p:nvSpPr>
          <p:cNvPr id="9" name="TextBox 8"/>
          <p:cNvSpPr txBox="1"/>
          <p:nvPr/>
        </p:nvSpPr>
        <p:spPr>
          <a:xfrm>
            <a:off x="76912" y="9172820"/>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D</a:t>
            </a:r>
          </a:p>
        </p:txBody>
      </p:sp>
      <p:sp>
        <p:nvSpPr>
          <p:cNvPr id="10" name="TextBox 9"/>
          <p:cNvSpPr txBox="1"/>
          <p:nvPr/>
        </p:nvSpPr>
        <p:spPr>
          <a:xfrm>
            <a:off x="251840" y="10526897"/>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E</a:t>
            </a:r>
          </a:p>
        </p:txBody>
      </p:sp>
      <p:sp>
        <p:nvSpPr>
          <p:cNvPr id="11" name="TextBox 10"/>
          <p:cNvSpPr txBox="1"/>
          <p:nvPr/>
        </p:nvSpPr>
        <p:spPr>
          <a:xfrm>
            <a:off x="3344482" y="10542451"/>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F</a:t>
            </a:r>
          </a:p>
        </p:txBody>
      </p:sp>
      <p:graphicFrame>
        <p:nvGraphicFramePr>
          <p:cNvPr id="12" name="Object 11"/>
          <p:cNvGraphicFramePr>
            <a:graphicFrameLocks noChangeAspect="1"/>
          </p:cNvGraphicFramePr>
          <p:nvPr>
            <p:extLst>
              <p:ext uri="{D42A27DB-BD31-4B8C-83A1-F6EECF244321}">
                <p14:modId xmlns:p14="http://schemas.microsoft.com/office/powerpoint/2010/main" val="830295586"/>
              </p:ext>
            </p:extLst>
          </p:nvPr>
        </p:nvGraphicFramePr>
        <p:xfrm>
          <a:off x="269635" y="1354396"/>
          <a:ext cx="5346561" cy="2526858"/>
        </p:xfrm>
        <a:graphic>
          <a:graphicData uri="http://schemas.openxmlformats.org/presentationml/2006/ole">
            <mc:AlternateContent xmlns:mc="http://schemas.openxmlformats.org/markup-compatibility/2006">
              <mc:Choice xmlns:v="urn:schemas-microsoft-com:vml" Requires="v">
                <p:oleObj spid="_x0000_s5356" name="Prism 7" r:id="rId11" imgW="6869589" imgH="3246068" progId="Prism7.Document">
                  <p:embed/>
                </p:oleObj>
              </mc:Choice>
              <mc:Fallback>
                <p:oleObj name="Prism 7" r:id="rId11" imgW="6869589" imgH="3246068" progId="Prism7.Document">
                  <p:embed/>
                  <p:pic>
                    <p:nvPicPr>
                      <p:cNvPr id="42" name="Object 41"/>
                      <p:cNvPicPr/>
                      <p:nvPr/>
                    </p:nvPicPr>
                    <p:blipFill>
                      <a:blip r:embed="rId12"/>
                      <a:stretch>
                        <a:fillRect/>
                      </a:stretch>
                    </p:blipFill>
                    <p:spPr>
                      <a:xfrm>
                        <a:off x="269635" y="1354396"/>
                        <a:ext cx="5346561" cy="2526858"/>
                      </a:xfrm>
                      <a:prstGeom prst="rect">
                        <a:avLst/>
                      </a:prstGeom>
                    </p:spPr>
                  </p:pic>
                </p:oleObj>
              </mc:Fallback>
            </mc:AlternateContent>
          </a:graphicData>
        </a:graphic>
      </p:graphicFrame>
      <p:sp>
        <p:nvSpPr>
          <p:cNvPr id="13" name="TextBox 12"/>
          <p:cNvSpPr txBox="1"/>
          <p:nvPr/>
        </p:nvSpPr>
        <p:spPr>
          <a:xfrm>
            <a:off x="269635" y="1097205"/>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A</a:t>
            </a:r>
          </a:p>
        </p:txBody>
      </p:sp>
      <p:graphicFrame>
        <p:nvGraphicFramePr>
          <p:cNvPr id="14" name="Object 13"/>
          <p:cNvGraphicFramePr>
            <a:graphicFrameLocks noChangeAspect="1"/>
          </p:cNvGraphicFramePr>
          <p:nvPr>
            <p:extLst>
              <p:ext uri="{D42A27DB-BD31-4B8C-83A1-F6EECF244321}">
                <p14:modId xmlns:p14="http://schemas.microsoft.com/office/powerpoint/2010/main" val="3471479517"/>
              </p:ext>
            </p:extLst>
          </p:nvPr>
        </p:nvGraphicFramePr>
        <p:xfrm>
          <a:off x="5713551" y="1388034"/>
          <a:ext cx="3126905" cy="2152094"/>
        </p:xfrm>
        <a:graphic>
          <a:graphicData uri="http://schemas.openxmlformats.org/presentationml/2006/ole">
            <mc:AlternateContent xmlns:mc="http://schemas.openxmlformats.org/markup-compatibility/2006">
              <mc:Choice xmlns:v="urn:schemas-microsoft-com:vml" Requires="v">
                <p:oleObj spid="_x0000_s5357" name="Prism 7" r:id="rId13" imgW="7404750" imgH="5095459" progId="Prism7.Document">
                  <p:embed/>
                </p:oleObj>
              </mc:Choice>
              <mc:Fallback>
                <p:oleObj name="Prism 7" r:id="rId13" imgW="7404750" imgH="5095459" progId="Prism7.Document">
                  <p:embed/>
                  <p:pic>
                    <p:nvPicPr>
                      <p:cNvPr id="45" name="Object 44"/>
                      <p:cNvPicPr/>
                      <p:nvPr/>
                    </p:nvPicPr>
                    <p:blipFill>
                      <a:blip r:embed="rId14"/>
                      <a:stretch>
                        <a:fillRect/>
                      </a:stretch>
                    </p:blipFill>
                    <p:spPr>
                      <a:xfrm>
                        <a:off x="5713551" y="1388034"/>
                        <a:ext cx="3126905" cy="2152094"/>
                      </a:xfrm>
                      <a:prstGeom prst="rect">
                        <a:avLst/>
                      </a:prstGeom>
                    </p:spPr>
                  </p:pic>
                </p:oleObj>
              </mc:Fallback>
            </mc:AlternateContent>
          </a:graphicData>
        </a:graphic>
      </p:graphicFrame>
      <p:sp>
        <p:nvSpPr>
          <p:cNvPr id="15" name="TextBox 14"/>
          <p:cNvSpPr txBox="1"/>
          <p:nvPr/>
        </p:nvSpPr>
        <p:spPr>
          <a:xfrm>
            <a:off x="5500120" y="1138300"/>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B</a:t>
            </a:r>
          </a:p>
        </p:txBody>
      </p:sp>
      <p:sp>
        <p:nvSpPr>
          <p:cNvPr id="16" name="TextBox 15"/>
          <p:cNvSpPr txBox="1"/>
          <p:nvPr/>
        </p:nvSpPr>
        <p:spPr>
          <a:xfrm>
            <a:off x="9787" y="4251440"/>
            <a:ext cx="480131" cy="1158439"/>
          </a:xfrm>
          <a:prstGeom prst="rect">
            <a:avLst/>
          </a:prstGeom>
          <a:noFill/>
        </p:spPr>
        <p:txBody>
          <a:bodyPr vert="vert270" wrap="square" rtlCol="0">
            <a:spAutoFit/>
          </a:bodyPr>
          <a:lstStyle/>
          <a:p>
            <a:pPr algn="ctr"/>
            <a:r>
              <a:rPr lang="en-US" sz="1920" dirty="0"/>
              <a:t>Liver 200x</a:t>
            </a:r>
          </a:p>
        </p:txBody>
      </p:sp>
      <p:sp>
        <p:nvSpPr>
          <p:cNvPr id="17" name="TextBox 16"/>
          <p:cNvSpPr txBox="1"/>
          <p:nvPr/>
        </p:nvSpPr>
        <p:spPr>
          <a:xfrm>
            <a:off x="664786" y="3685692"/>
            <a:ext cx="1869440" cy="387798"/>
          </a:xfrm>
          <a:prstGeom prst="rect">
            <a:avLst/>
          </a:prstGeom>
          <a:noFill/>
        </p:spPr>
        <p:txBody>
          <a:bodyPr wrap="square" rtlCol="0">
            <a:spAutoFit/>
          </a:bodyPr>
          <a:lstStyle/>
          <a:p>
            <a:pPr algn="ctr"/>
            <a:r>
              <a:rPr lang="en-US" sz="1920" dirty="0"/>
              <a:t>Vehicle</a:t>
            </a:r>
          </a:p>
        </p:txBody>
      </p:sp>
      <p:sp>
        <p:nvSpPr>
          <p:cNvPr id="18" name="TextBox 17"/>
          <p:cNvSpPr txBox="1"/>
          <p:nvPr/>
        </p:nvSpPr>
        <p:spPr>
          <a:xfrm>
            <a:off x="3021907" y="3685693"/>
            <a:ext cx="1869440" cy="387798"/>
          </a:xfrm>
          <a:prstGeom prst="rect">
            <a:avLst/>
          </a:prstGeom>
          <a:noFill/>
        </p:spPr>
        <p:txBody>
          <a:bodyPr wrap="square" rtlCol="0">
            <a:spAutoFit/>
          </a:bodyPr>
          <a:lstStyle/>
          <a:p>
            <a:pPr algn="ctr"/>
            <a:r>
              <a:rPr lang="en-US" sz="1920" dirty="0"/>
              <a:t>Venetoclax</a:t>
            </a:r>
          </a:p>
        </p:txBody>
      </p:sp>
      <p:sp>
        <p:nvSpPr>
          <p:cNvPr id="19" name="TextBox 18"/>
          <p:cNvSpPr txBox="1"/>
          <p:nvPr/>
        </p:nvSpPr>
        <p:spPr>
          <a:xfrm>
            <a:off x="5379027" y="3685693"/>
            <a:ext cx="1869440" cy="387798"/>
          </a:xfrm>
          <a:prstGeom prst="rect">
            <a:avLst/>
          </a:prstGeom>
          <a:noFill/>
        </p:spPr>
        <p:txBody>
          <a:bodyPr wrap="square" rtlCol="0">
            <a:spAutoFit/>
          </a:bodyPr>
          <a:lstStyle/>
          <a:p>
            <a:pPr algn="ctr"/>
            <a:r>
              <a:rPr lang="en-US" sz="1920" dirty="0" err="1"/>
              <a:t>Midostaurin</a:t>
            </a:r>
            <a:endParaRPr lang="en-US" sz="1920" dirty="0"/>
          </a:p>
        </p:txBody>
      </p:sp>
      <p:sp>
        <p:nvSpPr>
          <p:cNvPr id="20" name="TextBox 19"/>
          <p:cNvSpPr txBox="1"/>
          <p:nvPr/>
        </p:nvSpPr>
        <p:spPr>
          <a:xfrm>
            <a:off x="7728019" y="3685693"/>
            <a:ext cx="1869440" cy="387798"/>
          </a:xfrm>
          <a:prstGeom prst="rect">
            <a:avLst/>
          </a:prstGeom>
          <a:noFill/>
        </p:spPr>
        <p:txBody>
          <a:bodyPr wrap="square" rtlCol="0">
            <a:spAutoFit/>
          </a:bodyPr>
          <a:lstStyle/>
          <a:p>
            <a:pPr algn="ctr"/>
            <a:r>
              <a:rPr lang="en-US" sz="1920" dirty="0"/>
              <a:t>Combination</a:t>
            </a:r>
          </a:p>
        </p:txBody>
      </p:sp>
      <p:sp>
        <p:nvSpPr>
          <p:cNvPr id="21" name="TextBox 20">
            <a:extLst>
              <a:ext uri="{FF2B5EF4-FFF2-40B4-BE49-F238E27FC236}">
                <a16:creationId xmlns:a16="http://schemas.microsoft.com/office/drawing/2014/main" id="{0540875C-140A-4051-BFE5-B188C5F32CC3}"/>
              </a:ext>
            </a:extLst>
          </p:cNvPr>
          <p:cNvSpPr txBox="1"/>
          <p:nvPr/>
        </p:nvSpPr>
        <p:spPr>
          <a:xfrm>
            <a:off x="9788" y="5731091"/>
            <a:ext cx="480131" cy="1554287"/>
          </a:xfrm>
          <a:prstGeom prst="rect">
            <a:avLst/>
          </a:prstGeom>
          <a:noFill/>
        </p:spPr>
        <p:txBody>
          <a:bodyPr vert="vert270" wrap="square" rtlCol="0">
            <a:spAutoFit/>
          </a:bodyPr>
          <a:lstStyle/>
          <a:p>
            <a:pPr algn="ctr"/>
            <a:r>
              <a:rPr lang="en-US" sz="1920" dirty="0"/>
              <a:t>Kidney 100x</a:t>
            </a:r>
          </a:p>
        </p:txBody>
      </p:sp>
      <p:sp>
        <p:nvSpPr>
          <p:cNvPr id="22" name="TextBox 21">
            <a:extLst>
              <a:ext uri="{FF2B5EF4-FFF2-40B4-BE49-F238E27FC236}">
                <a16:creationId xmlns:a16="http://schemas.microsoft.com/office/drawing/2014/main" id="{11853775-673C-48E6-882E-404FEB83CDAF}"/>
              </a:ext>
            </a:extLst>
          </p:cNvPr>
          <p:cNvSpPr txBox="1"/>
          <p:nvPr/>
        </p:nvSpPr>
        <p:spPr>
          <a:xfrm>
            <a:off x="-28146" y="7472138"/>
            <a:ext cx="480131" cy="1620670"/>
          </a:xfrm>
          <a:prstGeom prst="rect">
            <a:avLst/>
          </a:prstGeom>
          <a:noFill/>
        </p:spPr>
        <p:txBody>
          <a:bodyPr vert="vert270" wrap="square" rtlCol="0">
            <a:spAutoFit/>
          </a:bodyPr>
          <a:lstStyle/>
          <a:p>
            <a:pPr algn="ctr"/>
            <a:r>
              <a:rPr lang="en-US" sz="1920" dirty="0"/>
              <a:t>Intestine 200x</a:t>
            </a:r>
          </a:p>
        </p:txBody>
      </p:sp>
      <p:pic>
        <p:nvPicPr>
          <p:cNvPr id="23" name="Picture 22">
            <a:extLst>
              <a:ext uri="{FF2B5EF4-FFF2-40B4-BE49-F238E27FC236}">
                <a16:creationId xmlns:a16="http://schemas.microsoft.com/office/drawing/2014/main" id="{6BB17B98-E1DC-4B38-8851-E4242BF082DC}"/>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7490020" y="4048767"/>
            <a:ext cx="2340864" cy="1664614"/>
          </a:xfrm>
          <a:prstGeom prst="rect">
            <a:avLst/>
          </a:prstGeom>
        </p:spPr>
      </p:pic>
      <p:pic>
        <p:nvPicPr>
          <p:cNvPr id="24" name="Picture 23">
            <a:extLst>
              <a:ext uri="{FF2B5EF4-FFF2-40B4-BE49-F238E27FC236}">
                <a16:creationId xmlns:a16="http://schemas.microsoft.com/office/drawing/2014/main" id="{7FF6632C-DEE4-4A2C-B842-5AA9055D1765}"/>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7490020" y="5741667"/>
            <a:ext cx="2340864" cy="1664614"/>
          </a:xfrm>
          <a:prstGeom prst="rect">
            <a:avLst/>
          </a:prstGeom>
        </p:spPr>
      </p:pic>
      <p:pic>
        <p:nvPicPr>
          <p:cNvPr id="25" name="Picture 24">
            <a:extLst>
              <a:ext uri="{FF2B5EF4-FFF2-40B4-BE49-F238E27FC236}">
                <a16:creationId xmlns:a16="http://schemas.microsoft.com/office/drawing/2014/main" id="{7883B03F-3399-434F-95CD-390F32A83888}"/>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7487737" y="7417368"/>
            <a:ext cx="2345436" cy="1667866"/>
          </a:xfrm>
          <a:prstGeom prst="rect">
            <a:avLst/>
          </a:prstGeom>
        </p:spPr>
      </p:pic>
      <p:pic>
        <p:nvPicPr>
          <p:cNvPr id="26" name="Picture 25">
            <a:extLst>
              <a:ext uri="{FF2B5EF4-FFF2-40B4-BE49-F238E27FC236}">
                <a16:creationId xmlns:a16="http://schemas.microsoft.com/office/drawing/2014/main" id="{F213590A-6BE0-4B6D-B7FC-288A137C3F90}"/>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5123446" y="5731091"/>
            <a:ext cx="2340864" cy="1664614"/>
          </a:xfrm>
          <a:prstGeom prst="rect">
            <a:avLst/>
          </a:prstGeom>
        </p:spPr>
      </p:pic>
      <p:pic>
        <p:nvPicPr>
          <p:cNvPr id="27" name="Picture 26">
            <a:extLst>
              <a:ext uri="{FF2B5EF4-FFF2-40B4-BE49-F238E27FC236}">
                <a16:creationId xmlns:a16="http://schemas.microsoft.com/office/drawing/2014/main" id="{4D2BCAD1-3E77-40E8-B1D2-52B0AEB81064}"/>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5123446" y="7417368"/>
            <a:ext cx="2340864" cy="1664614"/>
          </a:xfrm>
          <a:prstGeom prst="rect">
            <a:avLst/>
          </a:prstGeom>
        </p:spPr>
      </p:pic>
      <p:pic>
        <p:nvPicPr>
          <p:cNvPr id="28" name="Picture 27">
            <a:extLst>
              <a:ext uri="{FF2B5EF4-FFF2-40B4-BE49-F238E27FC236}">
                <a16:creationId xmlns:a16="http://schemas.microsoft.com/office/drawing/2014/main" id="{53D1B9D3-4D39-41FA-AD2E-B453F0BB1F7D}"/>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5123446" y="4048767"/>
            <a:ext cx="2340864" cy="1664614"/>
          </a:xfrm>
          <a:prstGeom prst="rect">
            <a:avLst/>
          </a:prstGeom>
        </p:spPr>
      </p:pic>
      <p:pic>
        <p:nvPicPr>
          <p:cNvPr id="29" name="Picture 28">
            <a:extLst>
              <a:ext uri="{FF2B5EF4-FFF2-40B4-BE49-F238E27FC236}">
                <a16:creationId xmlns:a16="http://schemas.microsoft.com/office/drawing/2014/main" id="{7F7B5C99-352A-448A-A55D-20CCD1C29FDA}"/>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2755489" y="7417368"/>
            <a:ext cx="2340864" cy="1664614"/>
          </a:xfrm>
          <a:prstGeom prst="rect">
            <a:avLst/>
          </a:prstGeom>
        </p:spPr>
      </p:pic>
      <p:pic>
        <p:nvPicPr>
          <p:cNvPr id="30" name="Picture 29">
            <a:extLst>
              <a:ext uri="{FF2B5EF4-FFF2-40B4-BE49-F238E27FC236}">
                <a16:creationId xmlns:a16="http://schemas.microsoft.com/office/drawing/2014/main" id="{C6AA896A-4374-422B-899C-9C0E8532B6DC}"/>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2755489" y="5731091"/>
            <a:ext cx="2340864" cy="1664614"/>
          </a:xfrm>
          <a:prstGeom prst="rect">
            <a:avLst/>
          </a:prstGeom>
        </p:spPr>
      </p:pic>
      <p:pic>
        <p:nvPicPr>
          <p:cNvPr id="31" name="Picture 30">
            <a:extLst>
              <a:ext uri="{FF2B5EF4-FFF2-40B4-BE49-F238E27FC236}">
                <a16:creationId xmlns:a16="http://schemas.microsoft.com/office/drawing/2014/main" id="{78FA9976-DFD2-4B1D-ABFA-B0C75CCC308B}"/>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2755489" y="4048767"/>
            <a:ext cx="2340864" cy="1664614"/>
          </a:xfrm>
          <a:prstGeom prst="rect">
            <a:avLst/>
          </a:prstGeom>
        </p:spPr>
      </p:pic>
      <p:pic>
        <p:nvPicPr>
          <p:cNvPr id="32" name="Picture 31">
            <a:extLst>
              <a:ext uri="{FF2B5EF4-FFF2-40B4-BE49-F238E27FC236}">
                <a16:creationId xmlns:a16="http://schemas.microsoft.com/office/drawing/2014/main" id="{71E51940-2BBF-4E2C-8D0C-1704CA5EA19F}"/>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387531" y="7417368"/>
            <a:ext cx="2340864" cy="1664614"/>
          </a:xfrm>
          <a:prstGeom prst="rect">
            <a:avLst/>
          </a:prstGeom>
        </p:spPr>
      </p:pic>
      <p:pic>
        <p:nvPicPr>
          <p:cNvPr id="33" name="Picture 32">
            <a:extLst>
              <a:ext uri="{FF2B5EF4-FFF2-40B4-BE49-F238E27FC236}">
                <a16:creationId xmlns:a16="http://schemas.microsoft.com/office/drawing/2014/main" id="{D68FCA95-7F1E-42A4-B2F6-85900FD323E7}"/>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387531" y="5742018"/>
            <a:ext cx="2340864" cy="1664614"/>
          </a:xfrm>
          <a:prstGeom prst="rect">
            <a:avLst/>
          </a:prstGeom>
        </p:spPr>
      </p:pic>
      <p:pic>
        <p:nvPicPr>
          <p:cNvPr id="34" name="Picture 33">
            <a:extLst>
              <a:ext uri="{FF2B5EF4-FFF2-40B4-BE49-F238E27FC236}">
                <a16:creationId xmlns:a16="http://schemas.microsoft.com/office/drawing/2014/main" id="{B17A7E5D-B2D6-463C-A2B3-84A59F0BFF69}"/>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387531" y="4048767"/>
            <a:ext cx="2340864" cy="1664614"/>
          </a:xfrm>
          <a:prstGeom prst="rect">
            <a:avLst/>
          </a:prstGeom>
        </p:spPr>
      </p:pic>
      <p:sp>
        <p:nvSpPr>
          <p:cNvPr id="35" name="TextBox 34"/>
          <p:cNvSpPr txBox="1"/>
          <p:nvPr/>
        </p:nvSpPr>
        <p:spPr>
          <a:xfrm>
            <a:off x="86588" y="3679183"/>
            <a:ext cx="430895" cy="313932"/>
          </a:xfrm>
          <a:prstGeom prst="rect">
            <a:avLst/>
          </a:prstGeom>
          <a:noFill/>
        </p:spPr>
        <p:txBody>
          <a:bodyPr wrap="square" rtlCol="0">
            <a:spAutoFit/>
          </a:bodyPr>
          <a:lstStyle/>
          <a:p>
            <a:r>
              <a:rPr lang="en-US" sz="1440" b="1" dirty="0">
                <a:latin typeface="Arial" panose="020B0604020202020204" pitchFamily="34" charset="0"/>
                <a:cs typeface="Arial" panose="020B0604020202020204" pitchFamily="34" charset="0"/>
              </a:rPr>
              <a:t>C</a:t>
            </a:r>
          </a:p>
        </p:txBody>
      </p:sp>
      <p:sp>
        <p:nvSpPr>
          <p:cNvPr id="36" name="TextBox 35"/>
          <p:cNvSpPr txBox="1"/>
          <p:nvPr/>
        </p:nvSpPr>
        <p:spPr>
          <a:xfrm>
            <a:off x="20203" y="13269946"/>
            <a:ext cx="10214045" cy="2246769"/>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l Fig. 4: </a:t>
            </a:r>
            <a:r>
              <a:rPr lang="en-US" sz="1400" dirty="0">
                <a:latin typeface="Arial" panose="020B0604020202020204" pitchFamily="34" charset="0"/>
                <a:cs typeface="Arial" panose="020B0604020202020204" pitchFamily="34" charset="0"/>
              </a:rPr>
              <a:t>Additional studies of adoptive Transfer AML Murine Model from </a:t>
            </a:r>
            <a:r>
              <a:rPr lang="en-US" sz="1400" dirty="0" err="1">
                <a:latin typeface="Arial" panose="020B0604020202020204" pitchFamily="34" charset="0"/>
                <a:cs typeface="Arial" panose="020B0604020202020204" pitchFamily="34" charset="0"/>
              </a:rPr>
              <a:t>Vav-cre</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Tet2</a:t>
            </a:r>
            <a:r>
              <a:rPr lang="en-US" sz="1400" baseline="30000" dirty="0">
                <a:latin typeface="Arial" panose="020B0604020202020204" pitchFamily="34" charset="0"/>
                <a:cs typeface="Arial" panose="020B0604020202020204" pitchFamily="34" charset="0"/>
              </a:rPr>
              <a:t>-/-</a:t>
            </a:r>
            <a:r>
              <a:rPr lang="en-US" sz="1400" i="1" dirty="0">
                <a:latin typeface="Arial" panose="020B0604020202020204" pitchFamily="34" charset="0"/>
                <a:cs typeface="Arial" panose="020B0604020202020204" pitchFamily="34" charset="0"/>
              </a:rPr>
              <a:t>Flt3</a:t>
            </a:r>
            <a:r>
              <a:rPr lang="en-US" sz="1400" baseline="30000" dirty="0">
                <a:latin typeface="Arial" panose="020B0604020202020204" pitchFamily="34" charset="0"/>
                <a:cs typeface="Arial" panose="020B0604020202020204" pitchFamily="34" charset="0"/>
              </a:rPr>
              <a:t>ITD</a:t>
            </a:r>
            <a:r>
              <a:rPr lang="en-US" sz="1400" dirty="0">
                <a:latin typeface="Arial" panose="020B0604020202020204" pitchFamily="34" charset="0"/>
                <a:cs typeface="Arial" panose="020B0604020202020204" pitchFamily="34" charset="0"/>
              </a:rPr>
              <a:t> mice treated with venetoclax and FLT3i.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White blood cells (WBCs) were counted from blood smears.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Mice weights were tracked daily and mice with 20% weight loss met early removal criteria (ERC).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A subset of mice were sacrificed at eight weeks for histopathologic analysis.</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Representative images of liver, kidney and small intestine are shown. There was no evidence of drug-associated </a:t>
            </a:r>
            <a:r>
              <a:rPr lang="en-US" sz="1400" dirty="0" err="1">
                <a:latin typeface="Arial" panose="020B0604020202020204" pitchFamily="34" charset="0"/>
                <a:cs typeface="Arial" panose="020B0604020202020204" pitchFamily="34" charset="0"/>
              </a:rPr>
              <a:t>toxicologic</a:t>
            </a:r>
            <a:r>
              <a:rPr lang="en-US" sz="1400" dirty="0">
                <a:latin typeface="Arial" panose="020B0604020202020204" pitchFamily="34" charset="0"/>
                <a:cs typeface="Arial" panose="020B0604020202020204" pitchFamily="34" charset="0"/>
              </a:rPr>
              <a:t> lesions in any tissues examined.  In mice from all treatment groups, the liver demonstrated diffuse, mild glycogen-like hepatic </a:t>
            </a:r>
            <a:r>
              <a:rPr lang="en-US" sz="1400" dirty="0" err="1">
                <a:latin typeface="Arial" panose="020B0604020202020204" pitchFamily="34" charset="0"/>
                <a:cs typeface="Arial" panose="020B0604020202020204" pitchFamily="34" charset="0"/>
              </a:rPr>
              <a:t>vacuolation</a:t>
            </a:r>
            <a:r>
              <a:rPr lang="en-US" sz="1400" dirty="0">
                <a:latin typeface="Arial" panose="020B0604020202020204" pitchFamily="34" charset="0"/>
                <a:cs typeface="Arial" panose="020B0604020202020204" pitchFamily="34" charset="0"/>
              </a:rPr>
              <a:t>. This change often occurs due to stress, and given its presence in both control and treatment conditions, it is not likely related to drug administration. 10x Objective, Total Magnification= 200xLiver, 100XKidney, 200XIntestine.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Spleens from the mice sacrificed at eight weeks were excised and measured. </a:t>
            </a:r>
            <a:r>
              <a:rPr lang="en-US" sz="1400" b="1" dirty="0">
                <a:latin typeface="Arial" panose="020B0604020202020204" pitchFamily="34" charset="0"/>
                <a:cs typeface="Arial" panose="020B0604020202020204" pitchFamily="34" charset="0"/>
              </a:rPr>
              <a:t>e</a:t>
            </a:r>
            <a:r>
              <a:rPr lang="en-US" sz="1400" dirty="0">
                <a:latin typeface="Arial" panose="020B0604020202020204" pitchFamily="34" charset="0"/>
                <a:cs typeface="Arial" panose="020B0604020202020204" pitchFamily="34" charset="0"/>
              </a:rPr>
              <a:t> Spleens were weighed. </a:t>
            </a:r>
            <a:r>
              <a:rPr lang="en-US" sz="1400" b="1" dirty="0">
                <a:latin typeface="Arial" panose="020B0604020202020204" pitchFamily="34" charset="0"/>
                <a:cs typeface="Arial" panose="020B0604020202020204" pitchFamily="34" charset="0"/>
              </a:rPr>
              <a:t>f</a:t>
            </a:r>
            <a:r>
              <a:rPr lang="en-US" sz="1400" dirty="0">
                <a:latin typeface="Arial" panose="020B0604020202020204" pitchFamily="34" charset="0"/>
                <a:cs typeface="Arial" panose="020B0604020202020204" pitchFamily="34" charset="0"/>
              </a:rPr>
              <a:t> Colony-forming assays were performed on bone marrow recovered from mice sacrificed at eight weeks. Cells were cultivated in duplicate in </a:t>
            </a:r>
            <a:r>
              <a:rPr lang="en-US" sz="1400" dirty="0" err="1">
                <a:latin typeface="Arial" panose="020B0604020202020204" pitchFamily="34" charset="0"/>
                <a:cs typeface="Arial" panose="020B0604020202020204" pitchFamily="34" charset="0"/>
              </a:rPr>
              <a:t>Methocult</a:t>
            </a:r>
            <a:r>
              <a:rPr lang="en-US" sz="1400" dirty="0">
                <a:latin typeface="Arial" panose="020B0604020202020204" pitchFamily="34" charset="0"/>
                <a:cs typeface="Arial" panose="020B0604020202020204" pitchFamily="34" charset="0"/>
              </a:rPr>
              <a:t> media for 7-10 days and counted.</a:t>
            </a:r>
          </a:p>
        </p:txBody>
      </p:sp>
    </p:spTree>
    <p:extLst>
      <p:ext uri="{BB962C8B-B14F-4D97-AF65-F5344CB8AC3E}">
        <p14:creationId xmlns:p14="http://schemas.microsoft.com/office/powerpoint/2010/main" val="6202171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941</TotalTime>
  <Words>665</Words>
  <Application>Microsoft Macintosh PowerPoint</Application>
  <PresentationFormat>Custom</PresentationFormat>
  <Paragraphs>46</Paragraphs>
  <Slides>5</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5</vt:i4>
      </vt:variant>
    </vt:vector>
  </HeadingPairs>
  <TitlesOfParts>
    <vt:vector size="11" baseType="lpstr">
      <vt:lpstr>Arial</vt:lpstr>
      <vt:lpstr>Calibri</vt:lpstr>
      <vt:lpstr>Calibri Light</vt:lpstr>
      <vt:lpstr>Office Theme</vt:lpstr>
      <vt:lpstr>Prism 7</vt:lpstr>
      <vt:lpstr>Prism 8</vt:lpstr>
      <vt:lpstr>Supplemental Figures</vt:lpstr>
      <vt:lpstr>PowerPoint Presentation</vt:lpstr>
      <vt:lpstr>PowerPoint Presentation</vt:lpstr>
      <vt:lpstr>PowerPoint Presentation</vt:lpstr>
      <vt:lpstr>PowerPoint Presentation</vt:lpstr>
    </vt:vector>
  </TitlesOfParts>
  <Company>The James Comprehensive Cancer Center</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ynergistic effect of BCL2 and FLT3 inhibition in Acute Myeloid Leukemia</dc:title>
  <dc:creator>Brinton, Lindsey</dc:creator>
  <cp:lastModifiedBy>Lapalombella, Rosa</cp:lastModifiedBy>
  <cp:revision>79</cp:revision>
  <dcterms:created xsi:type="dcterms:W3CDTF">2020-01-17T15:27:07Z</dcterms:created>
  <dcterms:modified xsi:type="dcterms:W3CDTF">2020-09-23T12:38:42Z</dcterms:modified>
</cp:coreProperties>
</file>